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9"/>
  </p:notesMasterIdLst>
  <p:sldIdLst>
    <p:sldId id="286" r:id="rId2"/>
    <p:sldId id="294" r:id="rId3"/>
    <p:sldId id="295" r:id="rId4"/>
    <p:sldId id="284" r:id="rId5"/>
    <p:sldId id="287" r:id="rId6"/>
    <p:sldId id="296" r:id="rId7"/>
    <p:sldId id="298" r:id="rId8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7AC3CCA-C797-4891-BE02-D94E43425B78}" styleName="中度样式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7" d="100"/>
          <a:sy n="67" d="100"/>
        </p:scale>
        <p:origin x="1965" y="3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hnas1-users\USERS\dyamashita\Desktop\CD133,CD109\Array%20dat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hnas1-users\USERS\dyamashita\Desktop\CD133,CD109\Array%20data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000"/>
              <a:t>Microarray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A$14</c:f>
              <c:strCache>
                <c:ptCount val="1"/>
                <c:pt idx="0">
                  <c:v>267 NT</c:v>
                </c:pt>
              </c:strCache>
            </c:strRef>
          </c:tx>
          <c:spPr>
            <a:solidFill>
              <a:schemeClr val="accent1"/>
            </a:solidFill>
            <a:ln w="635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D$14:$D$15</c:f>
                <c:numCache>
                  <c:formatCode>General</c:formatCode>
                  <c:ptCount val="2"/>
                  <c:pt idx="0">
                    <c:v>0.24205832783077227</c:v>
                  </c:pt>
                  <c:pt idx="1">
                    <c:v>3.6343306576419994E-2</c:v>
                  </c:pt>
                </c:numCache>
              </c:numRef>
            </c:plus>
            <c:minus>
              <c:numRef>
                <c:f>Sheet1!$D$14:$D$15</c:f>
                <c:numCache>
                  <c:formatCode>General</c:formatCode>
                  <c:ptCount val="2"/>
                  <c:pt idx="0">
                    <c:v>0.24205832783077227</c:v>
                  </c:pt>
                  <c:pt idx="1">
                    <c:v>3.6343306576419994E-2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B$8:$C$8</c:f>
              <c:strCache>
                <c:ptCount val="2"/>
                <c:pt idx="0">
                  <c:v>CD109</c:v>
                </c:pt>
                <c:pt idx="1">
                  <c:v>PLAGL1</c:v>
                </c:pt>
              </c:strCache>
            </c:strRef>
          </c:cat>
          <c:val>
            <c:numRef>
              <c:f>Sheet1!$B$14:$C$14</c:f>
              <c:numCache>
                <c:formatCode>0.0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770-44DE-93C8-5F4DE7D5D4A7}"/>
            </c:ext>
          </c:extLst>
        </c:ser>
        <c:ser>
          <c:idx val="1"/>
          <c:order val="1"/>
          <c:tx>
            <c:strRef>
              <c:f>Sheet1!$A$15</c:f>
              <c:strCache>
                <c:ptCount val="1"/>
                <c:pt idx="0">
                  <c:v>267 shCD109</c:v>
                </c:pt>
              </c:strCache>
            </c:strRef>
          </c:tx>
          <c:spPr>
            <a:solidFill>
              <a:schemeClr val="accent2"/>
            </a:solidFill>
            <a:ln w="635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14:$E$15</c:f>
                <c:numCache>
                  <c:formatCode>General</c:formatCode>
                  <c:ptCount val="2"/>
                  <c:pt idx="0">
                    <c:v>0.15194609984298407</c:v>
                  </c:pt>
                  <c:pt idx="1">
                    <c:v>0.12074279774036144</c:v>
                  </c:pt>
                </c:numCache>
              </c:numRef>
            </c:plus>
            <c:minus>
              <c:numRef>
                <c:f>Sheet1!$E$14:$E$15</c:f>
                <c:numCache>
                  <c:formatCode>General</c:formatCode>
                  <c:ptCount val="2"/>
                  <c:pt idx="0">
                    <c:v>0.15194609984298407</c:v>
                  </c:pt>
                  <c:pt idx="1">
                    <c:v>0.12074279774036144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B$8:$C$8</c:f>
              <c:strCache>
                <c:ptCount val="2"/>
                <c:pt idx="0">
                  <c:v>CD109</c:v>
                </c:pt>
                <c:pt idx="1">
                  <c:v>PLAGL1</c:v>
                </c:pt>
              </c:strCache>
            </c:strRef>
          </c:cat>
          <c:val>
            <c:numRef>
              <c:f>Sheet1!$B$15:$C$15</c:f>
              <c:numCache>
                <c:formatCode>0.0</c:formatCode>
                <c:ptCount val="2"/>
                <c:pt idx="0">
                  <c:v>0.43631314940881399</c:v>
                </c:pt>
                <c:pt idx="1">
                  <c:v>0.590434896859808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770-44DE-93C8-5F4DE7D5D4A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88345832"/>
        <c:axId val="887852624"/>
      </c:barChart>
      <c:catAx>
        <c:axId val="8883458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887852624"/>
        <c:crosses val="autoZero"/>
        <c:auto val="1"/>
        <c:lblAlgn val="ctr"/>
        <c:lblOffset val="100"/>
        <c:noMultiLvlLbl val="0"/>
      </c:catAx>
      <c:valAx>
        <c:axId val="887852624"/>
        <c:scaling>
          <c:orientation val="minMax"/>
        </c:scaling>
        <c:delete val="0"/>
        <c:axPos val="l"/>
        <c:numFmt formatCode="0.0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88834583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000"/>
              <a:t>RNA-seq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2691908663316725"/>
          <c:y val="0.16428376906318082"/>
          <c:w val="0.73080913366832756"/>
          <c:h val="0.4849160312273057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M$6</c:f>
              <c:strCache>
                <c:ptCount val="1"/>
                <c:pt idx="0">
                  <c:v>1005 CD109 Pos</c:v>
                </c:pt>
              </c:strCache>
            </c:strRef>
          </c:tx>
          <c:spPr>
            <a:solidFill>
              <a:schemeClr val="accent1"/>
            </a:solidFill>
            <a:ln w="6350">
              <a:solidFill>
                <a:schemeClr val="tx1"/>
              </a:solidFill>
            </a:ln>
            <a:effectLst/>
          </c:spPr>
          <c:invertIfNegative val="0"/>
          <c:cat>
            <c:strRef>
              <c:f>Sheet1!$N$1:$O$1</c:f>
              <c:strCache>
                <c:ptCount val="2"/>
                <c:pt idx="0">
                  <c:v>CD109</c:v>
                </c:pt>
                <c:pt idx="1">
                  <c:v>PLAGL1</c:v>
                </c:pt>
              </c:strCache>
            </c:strRef>
          </c:cat>
          <c:val>
            <c:numRef>
              <c:f>Sheet1!$N$6:$O$6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02B-4E8F-B4D9-D747B414E9DC}"/>
            </c:ext>
          </c:extLst>
        </c:ser>
        <c:ser>
          <c:idx val="1"/>
          <c:order val="1"/>
          <c:tx>
            <c:strRef>
              <c:f>Sheet1!$M$7</c:f>
              <c:strCache>
                <c:ptCount val="1"/>
                <c:pt idx="0">
                  <c:v>1005 CD109 Neg</c:v>
                </c:pt>
              </c:strCache>
            </c:strRef>
          </c:tx>
          <c:spPr>
            <a:solidFill>
              <a:schemeClr val="accent2"/>
            </a:solidFill>
            <a:ln w="6350">
              <a:solidFill>
                <a:schemeClr val="tx1"/>
              </a:solidFill>
            </a:ln>
            <a:effectLst/>
          </c:spPr>
          <c:invertIfNegative val="0"/>
          <c:cat>
            <c:strRef>
              <c:f>Sheet1!$N$1:$O$1</c:f>
              <c:strCache>
                <c:ptCount val="2"/>
                <c:pt idx="0">
                  <c:v>CD109</c:v>
                </c:pt>
                <c:pt idx="1">
                  <c:v>PLAGL1</c:v>
                </c:pt>
              </c:strCache>
            </c:strRef>
          </c:cat>
          <c:val>
            <c:numRef>
              <c:f>Sheet1!$N$7:$O$7</c:f>
              <c:numCache>
                <c:formatCode>General</c:formatCode>
                <c:ptCount val="2"/>
                <c:pt idx="0">
                  <c:v>0.21201209851649142</c:v>
                </c:pt>
                <c:pt idx="1">
                  <c:v>0.207594936708860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02B-4E8F-B4D9-D747B414E9D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87648104"/>
        <c:axId val="887648760"/>
      </c:barChart>
      <c:catAx>
        <c:axId val="8876481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887648760"/>
        <c:crosses val="autoZero"/>
        <c:auto val="1"/>
        <c:lblAlgn val="ctr"/>
        <c:lblOffset val="100"/>
        <c:noMultiLvlLbl val="0"/>
      </c:catAx>
      <c:valAx>
        <c:axId val="887648760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887648104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811DEFC-0813-4178-8119-95473F82957B}" type="datetimeFigureOut">
              <a:rPr lang="zh-CN" altLang="en-US" smtClean="0"/>
              <a:t>2020/9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E2B2C53-6AA5-42D9-94E9-74993D88D6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26478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89A255D-E717-4DDB-981D-EAAF5413FE67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378220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89A255D-E717-4DDB-981D-EAAF5413FE67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57650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7CED1-C62E-4EF8-A9A4-2CCECED049A4}" type="datetimeFigureOut">
              <a:rPr lang="zh-CN" altLang="en-US" smtClean="0"/>
              <a:t>2020/9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58634-6A79-466D-878A-634F472C1D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16858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7CED1-C62E-4EF8-A9A4-2CCECED049A4}" type="datetimeFigureOut">
              <a:rPr lang="zh-CN" altLang="en-US" smtClean="0"/>
              <a:t>2020/9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58634-6A79-466D-878A-634F472C1D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89574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7CED1-C62E-4EF8-A9A4-2CCECED049A4}" type="datetimeFigureOut">
              <a:rPr lang="zh-CN" altLang="en-US" smtClean="0"/>
              <a:t>2020/9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58634-6A79-466D-878A-634F472C1D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4332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7CED1-C62E-4EF8-A9A4-2CCECED049A4}" type="datetimeFigureOut">
              <a:rPr lang="zh-CN" altLang="en-US" smtClean="0"/>
              <a:t>2020/9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58634-6A79-466D-878A-634F472C1D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87316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7CED1-C62E-4EF8-A9A4-2CCECED049A4}" type="datetimeFigureOut">
              <a:rPr lang="zh-CN" altLang="en-US" smtClean="0"/>
              <a:t>2020/9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58634-6A79-466D-878A-634F472C1D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24147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7CED1-C62E-4EF8-A9A4-2CCECED049A4}" type="datetimeFigureOut">
              <a:rPr lang="zh-CN" altLang="en-US" smtClean="0"/>
              <a:t>2020/9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58634-6A79-466D-878A-634F472C1D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87017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7CED1-C62E-4EF8-A9A4-2CCECED049A4}" type="datetimeFigureOut">
              <a:rPr lang="zh-CN" altLang="en-US" smtClean="0"/>
              <a:t>2020/9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58634-6A79-466D-878A-634F472C1D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7258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7CED1-C62E-4EF8-A9A4-2CCECED049A4}" type="datetimeFigureOut">
              <a:rPr lang="zh-CN" altLang="en-US" smtClean="0"/>
              <a:t>2020/9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58634-6A79-466D-878A-634F472C1D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22965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7CED1-C62E-4EF8-A9A4-2CCECED049A4}" type="datetimeFigureOut">
              <a:rPr lang="zh-CN" altLang="en-US" smtClean="0"/>
              <a:t>2020/9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58634-6A79-466D-878A-634F472C1D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47477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7CED1-C62E-4EF8-A9A4-2CCECED049A4}" type="datetimeFigureOut">
              <a:rPr lang="zh-CN" altLang="en-US" smtClean="0"/>
              <a:t>2020/9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58634-6A79-466D-878A-634F472C1D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31694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7CED1-C62E-4EF8-A9A4-2CCECED049A4}" type="datetimeFigureOut">
              <a:rPr lang="zh-CN" altLang="en-US" smtClean="0"/>
              <a:t>2020/9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58634-6A79-466D-878A-634F472C1D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58716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17CED1-C62E-4EF8-A9A4-2CCECED049A4}" type="datetimeFigureOut">
              <a:rPr lang="zh-CN" altLang="en-US" smtClean="0"/>
              <a:t>2020/9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958634-6A79-466D-878A-634F472C1D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7988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tiff"/><Relationship Id="rId4" Type="http://schemas.openxmlformats.org/officeDocument/2006/relationships/image" Target="../media/image4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2.xml"/><Relationship Id="rId5" Type="http://schemas.openxmlformats.org/officeDocument/2006/relationships/chart" Target="../charts/chart1.xml"/><Relationship Id="rId4" Type="http://schemas.openxmlformats.org/officeDocument/2006/relationships/image" Target="../media/image8.jp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tif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jpeg"/><Relationship Id="rId13" Type="http://schemas.openxmlformats.org/officeDocument/2006/relationships/image" Target="../media/image24.jpeg"/><Relationship Id="rId3" Type="http://schemas.openxmlformats.org/officeDocument/2006/relationships/image" Target="../media/image14.jpeg"/><Relationship Id="rId7" Type="http://schemas.openxmlformats.org/officeDocument/2006/relationships/image" Target="../media/image18.jpeg"/><Relationship Id="rId12" Type="http://schemas.openxmlformats.org/officeDocument/2006/relationships/image" Target="../media/image23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jpeg"/><Relationship Id="rId11" Type="http://schemas.openxmlformats.org/officeDocument/2006/relationships/image" Target="../media/image22.jpeg"/><Relationship Id="rId5" Type="http://schemas.openxmlformats.org/officeDocument/2006/relationships/image" Target="../media/image16.jpeg"/><Relationship Id="rId15" Type="http://schemas.openxmlformats.org/officeDocument/2006/relationships/image" Target="../media/image26.jpeg"/><Relationship Id="rId10" Type="http://schemas.openxmlformats.org/officeDocument/2006/relationships/image" Target="../media/image21.jpeg"/><Relationship Id="rId4" Type="http://schemas.openxmlformats.org/officeDocument/2006/relationships/image" Target="../media/image15.jpeg"/><Relationship Id="rId9" Type="http://schemas.openxmlformats.org/officeDocument/2006/relationships/image" Target="../media/image20.jpeg"/><Relationship Id="rId14" Type="http://schemas.openxmlformats.org/officeDocument/2006/relationships/image" Target="../media/image25.jpe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jpeg"/><Relationship Id="rId3" Type="http://schemas.openxmlformats.org/officeDocument/2006/relationships/image" Target="../media/image28.jpeg"/><Relationship Id="rId7" Type="http://schemas.openxmlformats.org/officeDocument/2006/relationships/image" Target="../media/image32.jpeg"/><Relationship Id="rId2" Type="http://schemas.openxmlformats.org/officeDocument/2006/relationships/image" Target="../media/image27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1.png"/><Relationship Id="rId5" Type="http://schemas.openxmlformats.org/officeDocument/2006/relationships/image" Target="../media/image30.png"/><Relationship Id="rId4" Type="http://schemas.openxmlformats.org/officeDocument/2006/relationships/image" Target="../media/image2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副标题 2">
            <a:extLst>
              <a:ext uri="{FF2B5EF4-FFF2-40B4-BE49-F238E27FC236}">
                <a16:creationId xmlns:a16="http://schemas.microsoft.com/office/drawing/2014/main" id="{EB2174D6-24C4-4803-9905-052F009EE6D2}"/>
              </a:ext>
            </a:extLst>
          </p:cNvPr>
          <p:cNvSpPr txBox="1">
            <a:spLocks/>
          </p:cNvSpPr>
          <p:nvPr/>
        </p:nvSpPr>
        <p:spPr>
          <a:xfrm>
            <a:off x="105054" y="169610"/>
            <a:ext cx="3014695" cy="72144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.1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1" name="组合 100">
            <a:extLst>
              <a:ext uri="{FF2B5EF4-FFF2-40B4-BE49-F238E27FC236}">
                <a16:creationId xmlns:a16="http://schemas.microsoft.com/office/drawing/2014/main" id="{3755C3EE-41CC-434B-ABA9-00F57BC3EE90}"/>
              </a:ext>
            </a:extLst>
          </p:cNvPr>
          <p:cNvGrpSpPr/>
          <p:nvPr/>
        </p:nvGrpSpPr>
        <p:grpSpPr>
          <a:xfrm>
            <a:off x="232570" y="912662"/>
            <a:ext cx="3071651" cy="1781251"/>
            <a:chOff x="78414" y="1010770"/>
            <a:chExt cx="3071651" cy="1781251"/>
          </a:xfrm>
        </p:grpSpPr>
        <p:grpSp>
          <p:nvGrpSpPr>
            <p:cNvPr id="105" name="组合 104">
              <a:extLst>
                <a:ext uri="{FF2B5EF4-FFF2-40B4-BE49-F238E27FC236}">
                  <a16:creationId xmlns:a16="http://schemas.microsoft.com/office/drawing/2014/main" id="{60FA5FA5-6EAE-4F52-889A-A380DA352EF0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75599" y="1270320"/>
              <a:ext cx="1099883" cy="1107114"/>
              <a:chOff x="7837625" y="3088437"/>
              <a:chExt cx="437369" cy="440244"/>
            </a:xfrm>
          </p:grpSpPr>
          <p:pic>
            <p:nvPicPr>
              <p:cNvPr id="116" name="그림 9">
                <a:extLst>
                  <a:ext uri="{FF2B5EF4-FFF2-40B4-BE49-F238E27FC236}">
                    <a16:creationId xmlns:a16="http://schemas.microsoft.com/office/drawing/2014/main" id="{86EEFDB1-D76F-4FE0-B28A-9CE0C08FFA4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196" t="31712" r="43306" b="27524"/>
              <a:stretch/>
            </p:blipFill>
            <p:spPr>
              <a:xfrm>
                <a:off x="7837625" y="3088437"/>
                <a:ext cx="437369" cy="440244"/>
              </a:xfrm>
              <a:prstGeom prst="rect">
                <a:avLst/>
              </a:prstGeom>
            </p:spPr>
          </p:pic>
          <p:sp>
            <p:nvSpPr>
              <p:cNvPr id="117" name="任意多边形: 形状 116">
                <a:extLst>
                  <a:ext uri="{FF2B5EF4-FFF2-40B4-BE49-F238E27FC236}">
                    <a16:creationId xmlns:a16="http://schemas.microsoft.com/office/drawing/2014/main" id="{860BE83D-85E9-4B56-9E51-FEED6B273706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7927102" y="3225141"/>
                <a:ext cx="183519" cy="207400"/>
              </a:xfrm>
              <a:custGeom>
                <a:avLst/>
                <a:gdLst>
                  <a:gd name="connsiteX0" fmla="*/ 45589 w 244692"/>
                  <a:gd name="connsiteY0" fmla="*/ 14749 h 276533"/>
                  <a:gd name="connsiteX1" fmla="*/ 66483 w 244692"/>
                  <a:gd name="connsiteY1" fmla="*/ 13520 h 276533"/>
                  <a:gd name="connsiteX2" fmla="*/ 68941 w 244692"/>
                  <a:gd name="connsiteY2" fmla="*/ 8604 h 276533"/>
                  <a:gd name="connsiteX3" fmla="*/ 72628 w 244692"/>
                  <a:gd name="connsiteY3" fmla="*/ 6146 h 276533"/>
                  <a:gd name="connsiteX4" fmla="*/ 81231 w 244692"/>
                  <a:gd name="connsiteY4" fmla="*/ 3688 h 276533"/>
                  <a:gd name="connsiteX5" fmla="*/ 92292 w 244692"/>
                  <a:gd name="connsiteY5" fmla="*/ 0 h 276533"/>
                  <a:gd name="connsiteX6" fmla="*/ 152515 w 244692"/>
                  <a:gd name="connsiteY6" fmla="*/ 1229 h 276533"/>
                  <a:gd name="connsiteX7" fmla="*/ 169721 w 244692"/>
                  <a:gd name="connsiteY7" fmla="*/ 2459 h 276533"/>
                  <a:gd name="connsiteX8" fmla="*/ 177095 w 244692"/>
                  <a:gd name="connsiteY8" fmla="*/ 8604 h 276533"/>
                  <a:gd name="connsiteX9" fmla="*/ 183241 w 244692"/>
                  <a:gd name="connsiteY9" fmla="*/ 12291 h 276533"/>
                  <a:gd name="connsiteX10" fmla="*/ 188157 w 244692"/>
                  <a:gd name="connsiteY10" fmla="*/ 15978 h 276533"/>
                  <a:gd name="connsiteX11" fmla="*/ 193073 w 244692"/>
                  <a:gd name="connsiteY11" fmla="*/ 22123 h 276533"/>
                  <a:gd name="connsiteX12" fmla="*/ 197989 w 244692"/>
                  <a:gd name="connsiteY12" fmla="*/ 27039 h 276533"/>
                  <a:gd name="connsiteX13" fmla="*/ 200447 w 244692"/>
                  <a:gd name="connsiteY13" fmla="*/ 30726 h 276533"/>
                  <a:gd name="connsiteX14" fmla="*/ 207821 w 244692"/>
                  <a:gd name="connsiteY14" fmla="*/ 34413 h 276533"/>
                  <a:gd name="connsiteX15" fmla="*/ 210279 w 244692"/>
                  <a:gd name="connsiteY15" fmla="*/ 39329 h 276533"/>
                  <a:gd name="connsiteX16" fmla="*/ 217654 w 244692"/>
                  <a:gd name="connsiteY16" fmla="*/ 45475 h 276533"/>
                  <a:gd name="connsiteX17" fmla="*/ 221341 w 244692"/>
                  <a:gd name="connsiteY17" fmla="*/ 50391 h 276533"/>
                  <a:gd name="connsiteX18" fmla="*/ 225028 w 244692"/>
                  <a:gd name="connsiteY18" fmla="*/ 52849 h 276533"/>
                  <a:gd name="connsiteX19" fmla="*/ 228715 w 244692"/>
                  <a:gd name="connsiteY19" fmla="*/ 56536 h 276533"/>
                  <a:gd name="connsiteX20" fmla="*/ 229944 w 244692"/>
                  <a:gd name="connsiteY20" fmla="*/ 60223 h 276533"/>
                  <a:gd name="connsiteX21" fmla="*/ 233631 w 244692"/>
                  <a:gd name="connsiteY21" fmla="*/ 62681 h 276533"/>
                  <a:gd name="connsiteX22" fmla="*/ 238547 w 244692"/>
                  <a:gd name="connsiteY22" fmla="*/ 66368 h 276533"/>
                  <a:gd name="connsiteX23" fmla="*/ 242234 w 244692"/>
                  <a:gd name="connsiteY23" fmla="*/ 73742 h 276533"/>
                  <a:gd name="connsiteX24" fmla="*/ 244692 w 244692"/>
                  <a:gd name="connsiteY24" fmla="*/ 77429 h 276533"/>
                  <a:gd name="connsiteX25" fmla="*/ 243463 w 244692"/>
                  <a:gd name="connsiteY25" fmla="*/ 181897 h 276533"/>
                  <a:gd name="connsiteX26" fmla="*/ 239776 w 244692"/>
                  <a:gd name="connsiteY26" fmla="*/ 183126 h 276533"/>
                  <a:gd name="connsiteX27" fmla="*/ 237318 w 244692"/>
                  <a:gd name="connsiteY27" fmla="*/ 196646 h 276533"/>
                  <a:gd name="connsiteX28" fmla="*/ 234860 w 244692"/>
                  <a:gd name="connsiteY28" fmla="*/ 204020 h 276533"/>
                  <a:gd name="connsiteX29" fmla="*/ 233631 w 244692"/>
                  <a:gd name="connsiteY29" fmla="*/ 207707 h 276533"/>
                  <a:gd name="connsiteX30" fmla="*/ 232402 w 244692"/>
                  <a:gd name="connsiteY30" fmla="*/ 211394 h 276533"/>
                  <a:gd name="connsiteX31" fmla="*/ 231173 w 244692"/>
                  <a:gd name="connsiteY31" fmla="*/ 232288 h 276533"/>
                  <a:gd name="connsiteX32" fmla="*/ 229944 w 244692"/>
                  <a:gd name="connsiteY32" fmla="*/ 238433 h 276533"/>
                  <a:gd name="connsiteX33" fmla="*/ 226257 w 244692"/>
                  <a:gd name="connsiteY33" fmla="*/ 243349 h 276533"/>
                  <a:gd name="connsiteX34" fmla="*/ 221341 w 244692"/>
                  <a:gd name="connsiteY34" fmla="*/ 251952 h 276533"/>
                  <a:gd name="connsiteX35" fmla="*/ 216425 w 244692"/>
                  <a:gd name="connsiteY35" fmla="*/ 258097 h 276533"/>
                  <a:gd name="connsiteX36" fmla="*/ 206592 w 244692"/>
                  <a:gd name="connsiteY36" fmla="*/ 267929 h 276533"/>
                  <a:gd name="connsiteX37" fmla="*/ 201676 w 244692"/>
                  <a:gd name="connsiteY37" fmla="*/ 272846 h 276533"/>
                  <a:gd name="connsiteX38" fmla="*/ 151286 w 244692"/>
                  <a:gd name="connsiteY38" fmla="*/ 274075 h 276533"/>
                  <a:gd name="connsiteX39" fmla="*/ 116873 w 244692"/>
                  <a:gd name="connsiteY39" fmla="*/ 276533 h 276533"/>
                  <a:gd name="connsiteX40" fmla="*/ 56650 w 244692"/>
                  <a:gd name="connsiteY40" fmla="*/ 275304 h 276533"/>
                  <a:gd name="connsiteX41" fmla="*/ 51734 w 244692"/>
                  <a:gd name="connsiteY41" fmla="*/ 269159 h 276533"/>
                  <a:gd name="connsiteX42" fmla="*/ 49276 w 244692"/>
                  <a:gd name="connsiteY42" fmla="*/ 265471 h 276533"/>
                  <a:gd name="connsiteX43" fmla="*/ 45589 w 244692"/>
                  <a:gd name="connsiteY43" fmla="*/ 263013 h 276533"/>
                  <a:gd name="connsiteX44" fmla="*/ 41902 w 244692"/>
                  <a:gd name="connsiteY44" fmla="*/ 259326 h 276533"/>
                  <a:gd name="connsiteX45" fmla="*/ 33299 w 244692"/>
                  <a:gd name="connsiteY45" fmla="*/ 256868 h 276533"/>
                  <a:gd name="connsiteX46" fmla="*/ 29612 w 244692"/>
                  <a:gd name="connsiteY46" fmla="*/ 254410 h 276533"/>
                  <a:gd name="connsiteX47" fmla="*/ 22237 w 244692"/>
                  <a:gd name="connsiteY47" fmla="*/ 248265 h 276533"/>
                  <a:gd name="connsiteX48" fmla="*/ 18550 w 244692"/>
                  <a:gd name="connsiteY48" fmla="*/ 247036 h 276533"/>
                  <a:gd name="connsiteX49" fmla="*/ 12405 w 244692"/>
                  <a:gd name="connsiteY49" fmla="*/ 244578 h 276533"/>
                  <a:gd name="connsiteX50" fmla="*/ 7489 w 244692"/>
                  <a:gd name="connsiteY50" fmla="*/ 239662 h 276533"/>
                  <a:gd name="connsiteX51" fmla="*/ 2573 w 244692"/>
                  <a:gd name="connsiteY51" fmla="*/ 235975 h 276533"/>
                  <a:gd name="connsiteX52" fmla="*/ 115 w 244692"/>
                  <a:gd name="connsiteY52" fmla="*/ 228600 h 276533"/>
                  <a:gd name="connsiteX53" fmla="*/ 1344 w 244692"/>
                  <a:gd name="connsiteY53" fmla="*/ 210165 h 276533"/>
                  <a:gd name="connsiteX54" fmla="*/ 8718 w 244692"/>
                  <a:gd name="connsiteY54" fmla="*/ 207707 h 276533"/>
                  <a:gd name="connsiteX55" fmla="*/ 11176 w 244692"/>
                  <a:gd name="connsiteY55" fmla="*/ 197875 h 276533"/>
                  <a:gd name="connsiteX56" fmla="*/ 13634 w 244692"/>
                  <a:gd name="connsiteY56" fmla="*/ 194188 h 276533"/>
                  <a:gd name="connsiteX57" fmla="*/ 12405 w 244692"/>
                  <a:gd name="connsiteY57" fmla="*/ 126591 h 276533"/>
                  <a:gd name="connsiteX58" fmla="*/ 11176 w 244692"/>
                  <a:gd name="connsiteY58" fmla="*/ 119217 h 276533"/>
                  <a:gd name="connsiteX59" fmla="*/ 9947 w 244692"/>
                  <a:gd name="connsiteY59" fmla="*/ 115529 h 276533"/>
                  <a:gd name="connsiteX60" fmla="*/ 11176 w 244692"/>
                  <a:gd name="connsiteY60" fmla="*/ 66368 h 276533"/>
                  <a:gd name="connsiteX61" fmla="*/ 13634 w 244692"/>
                  <a:gd name="connsiteY61" fmla="*/ 57765 h 276533"/>
                  <a:gd name="connsiteX62" fmla="*/ 19779 w 244692"/>
                  <a:gd name="connsiteY62" fmla="*/ 46704 h 276533"/>
                  <a:gd name="connsiteX63" fmla="*/ 25925 w 244692"/>
                  <a:gd name="connsiteY63" fmla="*/ 40559 h 276533"/>
                  <a:gd name="connsiteX64" fmla="*/ 28383 w 244692"/>
                  <a:gd name="connsiteY64" fmla="*/ 33184 h 276533"/>
                  <a:gd name="connsiteX65" fmla="*/ 36986 w 244692"/>
                  <a:gd name="connsiteY65" fmla="*/ 27039 h 276533"/>
                  <a:gd name="connsiteX66" fmla="*/ 40673 w 244692"/>
                  <a:gd name="connsiteY66" fmla="*/ 24581 h 276533"/>
                  <a:gd name="connsiteX67" fmla="*/ 44360 w 244692"/>
                  <a:gd name="connsiteY67" fmla="*/ 23352 h 276533"/>
                  <a:gd name="connsiteX68" fmla="*/ 45589 w 244692"/>
                  <a:gd name="connsiteY68" fmla="*/ 14749 h 27653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</a:cxnLst>
                <a:rect l="l" t="t" r="r" b="b"/>
                <a:pathLst>
                  <a:path w="244692" h="276533">
                    <a:moveTo>
                      <a:pt x="45589" y="14749"/>
                    </a:moveTo>
                    <a:cubicBezTo>
                      <a:pt x="52554" y="14339"/>
                      <a:pt x="59736" y="15295"/>
                      <a:pt x="66483" y="13520"/>
                    </a:cubicBezTo>
                    <a:cubicBezTo>
                      <a:pt x="68255" y="13054"/>
                      <a:pt x="67768" y="10011"/>
                      <a:pt x="68941" y="8604"/>
                    </a:cubicBezTo>
                    <a:cubicBezTo>
                      <a:pt x="69887" y="7469"/>
                      <a:pt x="71257" y="6695"/>
                      <a:pt x="72628" y="6146"/>
                    </a:cubicBezTo>
                    <a:cubicBezTo>
                      <a:pt x="75397" y="5038"/>
                      <a:pt x="78384" y="4578"/>
                      <a:pt x="81231" y="3688"/>
                    </a:cubicBezTo>
                    <a:cubicBezTo>
                      <a:pt x="84941" y="2529"/>
                      <a:pt x="92292" y="0"/>
                      <a:pt x="92292" y="0"/>
                    </a:cubicBezTo>
                    <a:lnTo>
                      <a:pt x="152515" y="1229"/>
                    </a:lnTo>
                    <a:cubicBezTo>
                      <a:pt x="158262" y="1412"/>
                      <a:pt x="164059" y="1459"/>
                      <a:pt x="169721" y="2459"/>
                    </a:cubicBezTo>
                    <a:cubicBezTo>
                      <a:pt x="172220" y="2900"/>
                      <a:pt x="175463" y="7380"/>
                      <a:pt x="177095" y="8604"/>
                    </a:cubicBezTo>
                    <a:cubicBezTo>
                      <a:pt x="179006" y="10037"/>
                      <a:pt x="181253" y="10966"/>
                      <a:pt x="183241" y="12291"/>
                    </a:cubicBezTo>
                    <a:cubicBezTo>
                      <a:pt x="184945" y="13427"/>
                      <a:pt x="186518" y="14749"/>
                      <a:pt x="188157" y="15978"/>
                    </a:cubicBezTo>
                    <a:cubicBezTo>
                      <a:pt x="190225" y="22181"/>
                      <a:pt x="187885" y="17676"/>
                      <a:pt x="193073" y="22123"/>
                    </a:cubicBezTo>
                    <a:cubicBezTo>
                      <a:pt x="194833" y="23631"/>
                      <a:pt x="196481" y="25279"/>
                      <a:pt x="197989" y="27039"/>
                    </a:cubicBezTo>
                    <a:cubicBezTo>
                      <a:pt x="198950" y="28160"/>
                      <a:pt x="199403" y="29682"/>
                      <a:pt x="200447" y="30726"/>
                    </a:cubicBezTo>
                    <a:cubicBezTo>
                      <a:pt x="202829" y="33108"/>
                      <a:pt x="204822" y="33413"/>
                      <a:pt x="207821" y="34413"/>
                    </a:cubicBezTo>
                    <a:cubicBezTo>
                      <a:pt x="208640" y="36052"/>
                      <a:pt x="209263" y="37805"/>
                      <a:pt x="210279" y="39329"/>
                    </a:cubicBezTo>
                    <a:cubicBezTo>
                      <a:pt x="211935" y="41814"/>
                      <a:pt x="215787" y="43608"/>
                      <a:pt x="217654" y="45475"/>
                    </a:cubicBezTo>
                    <a:cubicBezTo>
                      <a:pt x="219102" y="46923"/>
                      <a:pt x="219893" y="48943"/>
                      <a:pt x="221341" y="50391"/>
                    </a:cubicBezTo>
                    <a:cubicBezTo>
                      <a:pt x="222385" y="51435"/>
                      <a:pt x="223893" y="51903"/>
                      <a:pt x="225028" y="52849"/>
                    </a:cubicBezTo>
                    <a:cubicBezTo>
                      <a:pt x="226363" y="53962"/>
                      <a:pt x="227486" y="55307"/>
                      <a:pt x="228715" y="56536"/>
                    </a:cubicBezTo>
                    <a:cubicBezTo>
                      <a:pt x="229125" y="57765"/>
                      <a:pt x="229135" y="59211"/>
                      <a:pt x="229944" y="60223"/>
                    </a:cubicBezTo>
                    <a:cubicBezTo>
                      <a:pt x="230867" y="61376"/>
                      <a:pt x="232429" y="61822"/>
                      <a:pt x="233631" y="62681"/>
                    </a:cubicBezTo>
                    <a:cubicBezTo>
                      <a:pt x="235298" y="63872"/>
                      <a:pt x="237099" y="64920"/>
                      <a:pt x="238547" y="66368"/>
                    </a:cubicBezTo>
                    <a:cubicBezTo>
                      <a:pt x="242069" y="69890"/>
                      <a:pt x="240235" y="69744"/>
                      <a:pt x="242234" y="73742"/>
                    </a:cubicBezTo>
                    <a:cubicBezTo>
                      <a:pt x="242895" y="75063"/>
                      <a:pt x="243873" y="76200"/>
                      <a:pt x="244692" y="77429"/>
                    </a:cubicBezTo>
                    <a:cubicBezTo>
                      <a:pt x="244282" y="112252"/>
                      <a:pt x="245081" y="147110"/>
                      <a:pt x="243463" y="181897"/>
                    </a:cubicBezTo>
                    <a:cubicBezTo>
                      <a:pt x="243403" y="183191"/>
                      <a:pt x="240274" y="181930"/>
                      <a:pt x="239776" y="183126"/>
                    </a:cubicBezTo>
                    <a:cubicBezTo>
                      <a:pt x="238014" y="187354"/>
                      <a:pt x="238367" y="192187"/>
                      <a:pt x="237318" y="196646"/>
                    </a:cubicBezTo>
                    <a:cubicBezTo>
                      <a:pt x="236725" y="199168"/>
                      <a:pt x="235679" y="201562"/>
                      <a:pt x="234860" y="204020"/>
                    </a:cubicBezTo>
                    <a:lnTo>
                      <a:pt x="233631" y="207707"/>
                    </a:lnTo>
                    <a:lnTo>
                      <a:pt x="232402" y="211394"/>
                    </a:lnTo>
                    <a:cubicBezTo>
                      <a:pt x="231992" y="218359"/>
                      <a:pt x="231805" y="225340"/>
                      <a:pt x="231173" y="232288"/>
                    </a:cubicBezTo>
                    <a:cubicBezTo>
                      <a:pt x="230984" y="234368"/>
                      <a:pt x="230792" y="236524"/>
                      <a:pt x="229944" y="238433"/>
                    </a:cubicBezTo>
                    <a:cubicBezTo>
                      <a:pt x="229112" y="240305"/>
                      <a:pt x="227486" y="241710"/>
                      <a:pt x="226257" y="243349"/>
                    </a:cubicBezTo>
                    <a:cubicBezTo>
                      <a:pt x="223439" y="251803"/>
                      <a:pt x="227293" y="241535"/>
                      <a:pt x="221341" y="251952"/>
                    </a:cubicBezTo>
                    <a:cubicBezTo>
                      <a:pt x="217688" y="258345"/>
                      <a:pt x="223421" y="253433"/>
                      <a:pt x="216425" y="258097"/>
                    </a:cubicBezTo>
                    <a:cubicBezTo>
                      <a:pt x="210492" y="266995"/>
                      <a:pt x="214150" y="264150"/>
                      <a:pt x="206592" y="267929"/>
                    </a:cubicBezTo>
                    <a:cubicBezTo>
                      <a:pt x="205432" y="271409"/>
                      <a:pt x="206113" y="272644"/>
                      <a:pt x="201676" y="272846"/>
                    </a:cubicBezTo>
                    <a:cubicBezTo>
                      <a:pt x="184892" y="273609"/>
                      <a:pt x="168083" y="273665"/>
                      <a:pt x="151286" y="274075"/>
                    </a:cubicBezTo>
                    <a:cubicBezTo>
                      <a:pt x="141484" y="274966"/>
                      <a:pt x="125840" y="276533"/>
                      <a:pt x="116873" y="276533"/>
                    </a:cubicBezTo>
                    <a:cubicBezTo>
                      <a:pt x="96794" y="276533"/>
                      <a:pt x="76724" y="275714"/>
                      <a:pt x="56650" y="275304"/>
                    </a:cubicBezTo>
                    <a:cubicBezTo>
                      <a:pt x="54101" y="265107"/>
                      <a:pt x="57795" y="274009"/>
                      <a:pt x="51734" y="269159"/>
                    </a:cubicBezTo>
                    <a:cubicBezTo>
                      <a:pt x="50580" y="268236"/>
                      <a:pt x="50321" y="266516"/>
                      <a:pt x="49276" y="265471"/>
                    </a:cubicBezTo>
                    <a:cubicBezTo>
                      <a:pt x="48232" y="264426"/>
                      <a:pt x="46724" y="263959"/>
                      <a:pt x="45589" y="263013"/>
                    </a:cubicBezTo>
                    <a:cubicBezTo>
                      <a:pt x="44254" y="261900"/>
                      <a:pt x="43348" y="260290"/>
                      <a:pt x="41902" y="259326"/>
                    </a:cubicBezTo>
                    <a:cubicBezTo>
                      <a:pt x="40844" y="258621"/>
                      <a:pt x="33955" y="257032"/>
                      <a:pt x="33299" y="256868"/>
                    </a:cubicBezTo>
                    <a:cubicBezTo>
                      <a:pt x="32070" y="256049"/>
                      <a:pt x="30747" y="255356"/>
                      <a:pt x="29612" y="254410"/>
                    </a:cubicBezTo>
                    <a:cubicBezTo>
                      <a:pt x="25533" y="251010"/>
                      <a:pt x="26817" y="250555"/>
                      <a:pt x="22237" y="248265"/>
                    </a:cubicBezTo>
                    <a:cubicBezTo>
                      <a:pt x="21078" y="247686"/>
                      <a:pt x="19763" y="247491"/>
                      <a:pt x="18550" y="247036"/>
                    </a:cubicBezTo>
                    <a:cubicBezTo>
                      <a:pt x="16484" y="246261"/>
                      <a:pt x="14453" y="245397"/>
                      <a:pt x="12405" y="244578"/>
                    </a:cubicBezTo>
                    <a:cubicBezTo>
                      <a:pt x="10766" y="242939"/>
                      <a:pt x="9233" y="241188"/>
                      <a:pt x="7489" y="239662"/>
                    </a:cubicBezTo>
                    <a:cubicBezTo>
                      <a:pt x="5947" y="238313"/>
                      <a:pt x="3709" y="237679"/>
                      <a:pt x="2573" y="235975"/>
                    </a:cubicBezTo>
                    <a:cubicBezTo>
                      <a:pt x="1136" y="233819"/>
                      <a:pt x="115" y="228600"/>
                      <a:pt x="115" y="228600"/>
                    </a:cubicBezTo>
                    <a:cubicBezTo>
                      <a:pt x="525" y="222455"/>
                      <a:pt x="-1001" y="215860"/>
                      <a:pt x="1344" y="210165"/>
                    </a:cubicBezTo>
                    <a:cubicBezTo>
                      <a:pt x="2331" y="207769"/>
                      <a:pt x="8718" y="207707"/>
                      <a:pt x="8718" y="207707"/>
                    </a:cubicBezTo>
                    <a:cubicBezTo>
                      <a:pt x="9185" y="205370"/>
                      <a:pt x="9916" y="200394"/>
                      <a:pt x="11176" y="197875"/>
                    </a:cubicBezTo>
                    <a:cubicBezTo>
                      <a:pt x="11837" y="196554"/>
                      <a:pt x="12815" y="195417"/>
                      <a:pt x="13634" y="194188"/>
                    </a:cubicBezTo>
                    <a:cubicBezTo>
                      <a:pt x="13224" y="171656"/>
                      <a:pt x="13143" y="149115"/>
                      <a:pt x="12405" y="126591"/>
                    </a:cubicBezTo>
                    <a:cubicBezTo>
                      <a:pt x="12323" y="124100"/>
                      <a:pt x="11717" y="121650"/>
                      <a:pt x="11176" y="119217"/>
                    </a:cubicBezTo>
                    <a:cubicBezTo>
                      <a:pt x="10895" y="117952"/>
                      <a:pt x="10357" y="116758"/>
                      <a:pt x="9947" y="115529"/>
                    </a:cubicBezTo>
                    <a:cubicBezTo>
                      <a:pt x="10357" y="99142"/>
                      <a:pt x="10132" y="82727"/>
                      <a:pt x="11176" y="66368"/>
                    </a:cubicBezTo>
                    <a:cubicBezTo>
                      <a:pt x="11366" y="63392"/>
                      <a:pt x="12777" y="60622"/>
                      <a:pt x="13634" y="57765"/>
                    </a:cubicBezTo>
                    <a:cubicBezTo>
                      <a:pt x="14959" y="53350"/>
                      <a:pt x="16057" y="50426"/>
                      <a:pt x="19779" y="46704"/>
                    </a:cubicBezTo>
                    <a:lnTo>
                      <a:pt x="25925" y="40559"/>
                    </a:lnTo>
                    <a:cubicBezTo>
                      <a:pt x="26744" y="38101"/>
                      <a:pt x="26227" y="34621"/>
                      <a:pt x="28383" y="33184"/>
                    </a:cubicBezTo>
                    <a:cubicBezTo>
                      <a:pt x="37072" y="27391"/>
                      <a:pt x="26315" y="34661"/>
                      <a:pt x="36986" y="27039"/>
                    </a:cubicBezTo>
                    <a:cubicBezTo>
                      <a:pt x="38188" y="26180"/>
                      <a:pt x="39352" y="25242"/>
                      <a:pt x="40673" y="24581"/>
                    </a:cubicBezTo>
                    <a:cubicBezTo>
                      <a:pt x="41832" y="24002"/>
                      <a:pt x="43131" y="23762"/>
                      <a:pt x="44360" y="23352"/>
                    </a:cubicBezTo>
                    <a:lnTo>
                      <a:pt x="45589" y="14749"/>
                    </a:lnTo>
                    <a:close/>
                  </a:path>
                </a:pathLst>
              </a:custGeom>
              <a:noFill/>
              <a:ln w="9525">
                <a:solidFill>
                  <a:srgbClr val="FF0000"/>
                </a:solidFill>
                <a:prstDash val="soli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cxnSp>
          <p:nvCxnSpPr>
            <p:cNvPr id="106" name="直接箭头连接符 105">
              <a:extLst>
                <a:ext uri="{FF2B5EF4-FFF2-40B4-BE49-F238E27FC236}">
                  <a16:creationId xmlns:a16="http://schemas.microsoft.com/office/drawing/2014/main" id="{41EAF694-CC99-41A2-A2A3-4D116A6BC176}"/>
                </a:ext>
              </a:extLst>
            </p:cNvPr>
            <p:cNvCxnSpPr>
              <a:cxnSpLocks/>
            </p:cNvCxnSpPr>
            <p:nvPr/>
          </p:nvCxnSpPr>
          <p:spPr>
            <a:xfrm>
              <a:off x="608586" y="1904730"/>
              <a:ext cx="146533" cy="546466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grpSp>
          <p:nvGrpSpPr>
            <p:cNvPr id="107" name="组合 106">
              <a:extLst>
                <a:ext uri="{FF2B5EF4-FFF2-40B4-BE49-F238E27FC236}">
                  <a16:creationId xmlns:a16="http://schemas.microsoft.com/office/drawing/2014/main" id="{F5B89B72-F6C1-4EB9-A583-C99434FAAE5D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483063" y="1261365"/>
              <a:ext cx="1099884" cy="1107115"/>
              <a:chOff x="5229013" y="4368706"/>
              <a:chExt cx="583155" cy="586991"/>
            </a:xfrm>
          </p:grpSpPr>
          <p:pic>
            <p:nvPicPr>
              <p:cNvPr id="113" name="그림 7">
                <a:extLst>
                  <a:ext uri="{FF2B5EF4-FFF2-40B4-BE49-F238E27FC236}">
                    <a16:creationId xmlns:a16="http://schemas.microsoft.com/office/drawing/2014/main" id="{34119A6C-00DD-4A76-AC0D-9BBA657B866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920" t="31181" r="42583" b="28057"/>
              <a:stretch/>
            </p:blipFill>
            <p:spPr>
              <a:xfrm>
                <a:off x="5229013" y="4368706"/>
                <a:ext cx="583155" cy="586991"/>
              </a:xfrm>
              <a:prstGeom prst="rect">
                <a:avLst/>
              </a:prstGeom>
            </p:spPr>
          </p:pic>
          <p:sp>
            <p:nvSpPr>
              <p:cNvPr id="114" name="任意多边形: 形状 113">
                <a:extLst>
                  <a:ext uri="{FF2B5EF4-FFF2-40B4-BE49-F238E27FC236}">
                    <a16:creationId xmlns:a16="http://schemas.microsoft.com/office/drawing/2014/main" id="{582ED685-6BBF-4236-9E90-746B3B43CFCE}"/>
                  </a:ext>
                </a:extLst>
              </p:cNvPr>
              <p:cNvSpPr/>
              <p:nvPr/>
            </p:nvSpPr>
            <p:spPr>
              <a:xfrm>
                <a:off x="5298120" y="4439874"/>
                <a:ext cx="414580" cy="501445"/>
              </a:xfrm>
              <a:custGeom>
                <a:avLst/>
                <a:gdLst>
                  <a:gd name="connsiteX0" fmla="*/ 17207 w 414580"/>
                  <a:gd name="connsiteY0" fmla="*/ 145026 h 501445"/>
                  <a:gd name="connsiteX1" fmla="*/ 13520 w 414580"/>
                  <a:gd name="connsiteY1" fmla="*/ 156087 h 501445"/>
                  <a:gd name="connsiteX2" fmla="*/ 8603 w 414580"/>
                  <a:gd name="connsiteY2" fmla="*/ 167148 h 501445"/>
                  <a:gd name="connsiteX3" fmla="*/ 7374 w 414580"/>
                  <a:gd name="connsiteY3" fmla="*/ 172064 h 501445"/>
                  <a:gd name="connsiteX4" fmla="*/ 6145 w 414580"/>
                  <a:gd name="connsiteY4" fmla="*/ 175751 h 501445"/>
                  <a:gd name="connsiteX5" fmla="*/ 3687 w 414580"/>
                  <a:gd name="connsiteY5" fmla="*/ 185584 h 501445"/>
                  <a:gd name="connsiteX6" fmla="*/ 0 w 414580"/>
                  <a:gd name="connsiteY6" fmla="*/ 192958 h 501445"/>
                  <a:gd name="connsiteX7" fmla="*/ 2458 w 414580"/>
                  <a:gd name="connsiteY7" fmla="*/ 310945 h 501445"/>
                  <a:gd name="connsiteX8" fmla="*/ 4916 w 414580"/>
                  <a:gd name="connsiteY8" fmla="*/ 320777 h 501445"/>
                  <a:gd name="connsiteX9" fmla="*/ 8603 w 414580"/>
                  <a:gd name="connsiteY9" fmla="*/ 335526 h 501445"/>
                  <a:gd name="connsiteX10" fmla="*/ 12291 w 414580"/>
                  <a:gd name="connsiteY10" fmla="*/ 337984 h 501445"/>
                  <a:gd name="connsiteX11" fmla="*/ 13520 w 414580"/>
                  <a:gd name="connsiteY11" fmla="*/ 347816 h 501445"/>
                  <a:gd name="connsiteX12" fmla="*/ 14749 w 414580"/>
                  <a:gd name="connsiteY12" fmla="*/ 352732 h 501445"/>
                  <a:gd name="connsiteX13" fmla="*/ 15978 w 414580"/>
                  <a:gd name="connsiteY13" fmla="*/ 361335 h 501445"/>
                  <a:gd name="connsiteX14" fmla="*/ 18436 w 414580"/>
                  <a:gd name="connsiteY14" fmla="*/ 369938 h 501445"/>
                  <a:gd name="connsiteX15" fmla="*/ 22123 w 414580"/>
                  <a:gd name="connsiteY15" fmla="*/ 379771 h 501445"/>
                  <a:gd name="connsiteX16" fmla="*/ 23352 w 414580"/>
                  <a:gd name="connsiteY16" fmla="*/ 385916 h 501445"/>
                  <a:gd name="connsiteX17" fmla="*/ 24581 w 414580"/>
                  <a:gd name="connsiteY17" fmla="*/ 389603 h 501445"/>
                  <a:gd name="connsiteX18" fmla="*/ 28268 w 414580"/>
                  <a:gd name="connsiteY18" fmla="*/ 406809 h 501445"/>
                  <a:gd name="connsiteX19" fmla="*/ 29497 w 414580"/>
                  <a:gd name="connsiteY19" fmla="*/ 410496 h 501445"/>
                  <a:gd name="connsiteX20" fmla="*/ 33184 w 414580"/>
                  <a:gd name="connsiteY20" fmla="*/ 420329 h 501445"/>
                  <a:gd name="connsiteX21" fmla="*/ 35642 w 414580"/>
                  <a:gd name="connsiteY21" fmla="*/ 430161 h 501445"/>
                  <a:gd name="connsiteX22" fmla="*/ 40558 w 414580"/>
                  <a:gd name="connsiteY22" fmla="*/ 439993 h 501445"/>
                  <a:gd name="connsiteX23" fmla="*/ 45474 w 414580"/>
                  <a:gd name="connsiteY23" fmla="*/ 448596 h 501445"/>
                  <a:gd name="connsiteX24" fmla="*/ 49162 w 414580"/>
                  <a:gd name="connsiteY24" fmla="*/ 455971 h 501445"/>
                  <a:gd name="connsiteX25" fmla="*/ 54078 w 414580"/>
                  <a:gd name="connsiteY25" fmla="*/ 457200 h 501445"/>
                  <a:gd name="connsiteX26" fmla="*/ 57765 w 414580"/>
                  <a:gd name="connsiteY26" fmla="*/ 460887 h 501445"/>
                  <a:gd name="connsiteX27" fmla="*/ 62681 w 414580"/>
                  <a:gd name="connsiteY27" fmla="*/ 463345 h 501445"/>
                  <a:gd name="connsiteX28" fmla="*/ 70055 w 414580"/>
                  <a:gd name="connsiteY28" fmla="*/ 468261 h 501445"/>
                  <a:gd name="connsiteX29" fmla="*/ 73742 w 414580"/>
                  <a:gd name="connsiteY29" fmla="*/ 470719 h 501445"/>
                  <a:gd name="connsiteX30" fmla="*/ 77429 w 414580"/>
                  <a:gd name="connsiteY30" fmla="*/ 473177 h 501445"/>
                  <a:gd name="connsiteX31" fmla="*/ 79887 w 414580"/>
                  <a:gd name="connsiteY31" fmla="*/ 476864 h 501445"/>
                  <a:gd name="connsiteX32" fmla="*/ 89720 w 414580"/>
                  <a:gd name="connsiteY32" fmla="*/ 480551 h 501445"/>
                  <a:gd name="connsiteX33" fmla="*/ 108155 w 414580"/>
                  <a:gd name="connsiteY33" fmla="*/ 483009 h 501445"/>
                  <a:gd name="connsiteX34" fmla="*/ 146255 w 414580"/>
                  <a:gd name="connsiteY34" fmla="*/ 481780 h 501445"/>
                  <a:gd name="connsiteX35" fmla="*/ 149942 w 414580"/>
                  <a:gd name="connsiteY35" fmla="*/ 473177 h 501445"/>
                  <a:gd name="connsiteX36" fmla="*/ 153629 w 414580"/>
                  <a:gd name="connsiteY36" fmla="*/ 470719 h 501445"/>
                  <a:gd name="connsiteX37" fmla="*/ 158545 w 414580"/>
                  <a:gd name="connsiteY37" fmla="*/ 463345 h 501445"/>
                  <a:gd name="connsiteX38" fmla="*/ 161003 w 414580"/>
                  <a:gd name="connsiteY38" fmla="*/ 467032 h 501445"/>
                  <a:gd name="connsiteX39" fmla="*/ 167149 w 414580"/>
                  <a:gd name="connsiteY39" fmla="*/ 471948 h 501445"/>
                  <a:gd name="connsiteX40" fmla="*/ 168378 w 414580"/>
                  <a:gd name="connsiteY40" fmla="*/ 476864 h 501445"/>
                  <a:gd name="connsiteX41" fmla="*/ 169607 w 414580"/>
                  <a:gd name="connsiteY41" fmla="*/ 480551 h 501445"/>
                  <a:gd name="connsiteX42" fmla="*/ 170836 w 414580"/>
                  <a:gd name="connsiteY42" fmla="*/ 501445 h 501445"/>
                  <a:gd name="connsiteX43" fmla="*/ 178210 w 414580"/>
                  <a:gd name="connsiteY43" fmla="*/ 500216 h 501445"/>
                  <a:gd name="connsiteX44" fmla="*/ 186813 w 414580"/>
                  <a:gd name="connsiteY44" fmla="*/ 496529 h 501445"/>
                  <a:gd name="connsiteX45" fmla="*/ 190500 w 414580"/>
                  <a:gd name="connsiteY45" fmla="*/ 495300 h 501445"/>
                  <a:gd name="connsiteX46" fmla="*/ 195416 w 414580"/>
                  <a:gd name="connsiteY46" fmla="*/ 492842 h 501445"/>
                  <a:gd name="connsiteX47" fmla="*/ 199103 w 414580"/>
                  <a:gd name="connsiteY47" fmla="*/ 491613 h 501445"/>
                  <a:gd name="connsiteX48" fmla="*/ 205249 w 414580"/>
                  <a:gd name="connsiteY48" fmla="*/ 486696 h 501445"/>
                  <a:gd name="connsiteX49" fmla="*/ 208936 w 414580"/>
                  <a:gd name="connsiteY49" fmla="*/ 485467 h 501445"/>
                  <a:gd name="connsiteX50" fmla="*/ 212623 w 414580"/>
                  <a:gd name="connsiteY50" fmla="*/ 483009 h 501445"/>
                  <a:gd name="connsiteX51" fmla="*/ 215081 w 414580"/>
                  <a:gd name="connsiteY51" fmla="*/ 479322 h 501445"/>
                  <a:gd name="connsiteX52" fmla="*/ 216310 w 414580"/>
                  <a:gd name="connsiteY52" fmla="*/ 475635 h 501445"/>
                  <a:gd name="connsiteX53" fmla="*/ 219997 w 414580"/>
                  <a:gd name="connsiteY53" fmla="*/ 473177 h 501445"/>
                  <a:gd name="connsiteX54" fmla="*/ 221226 w 414580"/>
                  <a:gd name="connsiteY54" fmla="*/ 469490 h 501445"/>
                  <a:gd name="connsiteX55" fmla="*/ 228600 w 414580"/>
                  <a:gd name="connsiteY55" fmla="*/ 464574 h 501445"/>
                  <a:gd name="connsiteX56" fmla="*/ 239662 w 414580"/>
                  <a:gd name="connsiteY56" fmla="*/ 455971 h 501445"/>
                  <a:gd name="connsiteX57" fmla="*/ 249494 w 414580"/>
                  <a:gd name="connsiteY57" fmla="*/ 451055 h 501445"/>
                  <a:gd name="connsiteX58" fmla="*/ 254410 w 414580"/>
                  <a:gd name="connsiteY58" fmla="*/ 446138 h 501445"/>
                  <a:gd name="connsiteX59" fmla="*/ 260555 w 414580"/>
                  <a:gd name="connsiteY59" fmla="*/ 441222 h 501445"/>
                  <a:gd name="connsiteX60" fmla="*/ 261784 w 414580"/>
                  <a:gd name="connsiteY60" fmla="*/ 437535 h 501445"/>
                  <a:gd name="connsiteX61" fmla="*/ 269158 w 414580"/>
                  <a:gd name="connsiteY61" fmla="*/ 427703 h 501445"/>
                  <a:gd name="connsiteX62" fmla="*/ 270387 w 414580"/>
                  <a:gd name="connsiteY62" fmla="*/ 424016 h 501445"/>
                  <a:gd name="connsiteX63" fmla="*/ 277762 w 414580"/>
                  <a:gd name="connsiteY63" fmla="*/ 414184 h 501445"/>
                  <a:gd name="connsiteX64" fmla="*/ 280220 w 414580"/>
                  <a:gd name="connsiteY64" fmla="*/ 409267 h 501445"/>
                  <a:gd name="connsiteX65" fmla="*/ 282678 w 414580"/>
                  <a:gd name="connsiteY65" fmla="*/ 374855 h 501445"/>
                  <a:gd name="connsiteX66" fmla="*/ 288823 w 414580"/>
                  <a:gd name="connsiteY66" fmla="*/ 362564 h 501445"/>
                  <a:gd name="connsiteX67" fmla="*/ 294968 w 414580"/>
                  <a:gd name="connsiteY67" fmla="*/ 351503 h 501445"/>
                  <a:gd name="connsiteX68" fmla="*/ 297426 w 414580"/>
                  <a:gd name="connsiteY68" fmla="*/ 347816 h 501445"/>
                  <a:gd name="connsiteX69" fmla="*/ 298655 w 414580"/>
                  <a:gd name="connsiteY69" fmla="*/ 314632 h 501445"/>
                  <a:gd name="connsiteX70" fmla="*/ 299884 w 414580"/>
                  <a:gd name="connsiteY70" fmla="*/ 309716 h 501445"/>
                  <a:gd name="connsiteX71" fmla="*/ 303571 w 414580"/>
                  <a:gd name="connsiteY71" fmla="*/ 302342 h 501445"/>
                  <a:gd name="connsiteX72" fmla="*/ 315862 w 414580"/>
                  <a:gd name="connsiteY72" fmla="*/ 296196 h 501445"/>
                  <a:gd name="connsiteX73" fmla="*/ 320778 w 414580"/>
                  <a:gd name="connsiteY73" fmla="*/ 294967 h 501445"/>
                  <a:gd name="connsiteX74" fmla="*/ 331839 w 414580"/>
                  <a:gd name="connsiteY74" fmla="*/ 290051 h 501445"/>
                  <a:gd name="connsiteX75" fmla="*/ 339213 w 414580"/>
                  <a:gd name="connsiteY75" fmla="*/ 287593 h 501445"/>
                  <a:gd name="connsiteX76" fmla="*/ 351503 w 414580"/>
                  <a:gd name="connsiteY76" fmla="*/ 283906 h 501445"/>
                  <a:gd name="connsiteX77" fmla="*/ 360107 w 414580"/>
                  <a:gd name="connsiteY77" fmla="*/ 280219 h 501445"/>
                  <a:gd name="connsiteX78" fmla="*/ 368710 w 414580"/>
                  <a:gd name="connsiteY78" fmla="*/ 277761 h 501445"/>
                  <a:gd name="connsiteX79" fmla="*/ 372397 w 414580"/>
                  <a:gd name="connsiteY79" fmla="*/ 275303 h 501445"/>
                  <a:gd name="connsiteX80" fmla="*/ 376084 w 414580"/>
                  <a:gd name="connsiteY80" fmla="*/ 274074 h 501445"/>
                  <a:gd name="connsiteX81" fmla="*/ 381000 w 414580"/>
                  <a:gd name="connsiteY81" fmla="*/ 271616 h 501445"/>
                  <a:gd name="connsiteX82" fmla="*/ 384687 w 414580"/>
                  <a:gd name="connsiteY82" fmla="*/ 270387 h 501445"/>
                  <a:gd name="connsiteX83" fmla="*/ 393291 w 414580"/>
                  <a:gd name="connsiteY83" fmla="*/ 266700 h 501445"/>
                  <a:gd name="connsiteX84" fmla="*/ 396978 w 414580"/>
                  <a:gd name="connsiteY84" fmla="*/ 264242 h 501445"/>
                  <a:gd name="connsiteX85" fmla="*/ 399436 w 414580"/>
                  <a:gd name="connsiteY85" fmla="*/ 260555 h 501445"/>
                  <a:gd name="connsiteX86" fmla="*/ 403123 w 414580"/>
                  <a:gd name="connsiteY86" fmla="*/ 259326 h 501445"/>
                  <a:gd name="connsiteX87" fmla="*/ 408039 w 414580"/>
                  <a:gd name="connsiteY87" fmla="*/ 251951 h 501445"/>
                  <a:gd name="connsiteX88" fmla="*/ 410497 w 414580"/>
                  <a:gd name="connsiteY88" fmla="*/ 248264 h 501445"/>
                  <a:gd name="connsiteX89" fmla="*/ 414184 w 414580"/>
                  <a:gd name="connsiteY89" fmla="*/ 242119 h 501445"/>
                  <a:gd name="connsiteX90" fmla="*/ 412955 w 414580"/>
                  <a:gd name="connsiteY90" fmla="*/ 228600 h 501445"/>
                  <a:gd name="connsiteX91" fmla="*/ 403123 w 414580"/>
                  <a:gd name="connsiteY91" fmla="*/ 229829 h 501445"/>
                  <a:gd name="connsiteX92" fmla="*/ 393291 w 414580"/>
                  <a:gd name="connsiteY92" fmla="*/ 227371 h 501445"/>
                  <a:gd name="connsiteX93" fmla="*/ 393291 w 414580"/>
                  <a:gd name="connsiteY93" fmla="*/ 181896 h 501445"/>
                  <a:gd name="connsiteX94" fmla="*/ 398207 w 414580"/>
                  <a:gd name="connsiteY94" fmla="*/ 168377 h 501445"/>
                  <a:gd name="connsiteX95" fmla="*/ 399436 w 414580"/>
                  <a:gd name="connsiteY95" fmla="*/ 163461 h 501445"/>
                  <a:gd name="connsiteX96" fmla="*/ 384687 w 414580"/>
                  <a:gd name="connsiteY96" fmla="*/ 145026 h 501445"/>
                  <a:gd name="connsiteX97" fmla="*/ 381000 w 414580"/>
                  <a:gd name="connsiteY97" fmla="*/ 146255 h 501445"/>
                  <a:gd name="connsiteX98" fmla="*/ 376084 w 414580"/>
                  <a:gd name="connsiteY98" fmla="*/ 149942 h 501445"/>
                  <a:gd name="connsiteX99" fmla="*/ 371168 w 414580"/>
                  <a:gd name="connsiteY99" fmla="*/ 152400 h 501445"/>
                  <a:gd name="connsiteX100" fmla="*/ 369939 w 414580"/>
                  <a:gd name="connsiteY100" fmla="*/ 157316 h 501445"/>
                  <a:gd name="connsiteX101" fmla="*/ 366252 w 414580"/>
                  <a:gd name="connsiteY101" fmla="*/ 167148 h 501445"/>
                  <a:gd name="connsiteX102" fmla="*/ 363794 w 414580"/>
                  <a:gd name="connsiteY102" fmla="*/ 175751 h 501445"/>
                  <a:gd name="connsiteX103" fmla="*/ 360107 w 414580"/>
                  <a:gd name="connsiteY103" fmla="*/ 179438 h 501445"/>
                  <a:gd name="connsiteX104" fmla="*/ 357649 w 414580"/>
                  <a:gd name="connsiteY104" fmla="*/ 185584 h 501445"/>
                  <a:gd name="connsiteX105" fmla="*/ 356420 w 414580"/>
                  <a:gd name="connsiteY105" fmla="*/ 189271 h 501445"/>
                  <a:gd name="connsiteX106" fmla="*/ 345358 w 414580"/>
                  <a:gd name="connsiteY106" fmla="*/ 200332 h 501445"/>
                  <a:gd name="connsiteX107" fmla="*/ 344129 w 414580"/>
                  <a:gd name="connsiteY107" fmla="*/ 164690 h 501445"/>
                  <a:gd name="connsiteX108" fmla="*/ 346587 w 414580"/>
                  <a:gd name="connsiteY108" fmla="*/ 161003 h 501445"/>
                  <a:gd name="connsiteX109" fmla="*/ 349045 w 414580"/>
                  <a:gd name="connsiteY109" fmla="*/ 156087 h 501445"/>
                  <a:gd name="connsiteX110" fmla="*/ 350274 w 414580"/>
                  <a:gd name="connsiteY110" fmla="*/ 148713 h 501445"/>
                  <a:gd name="connsiteX111" fmla="*/ 350274 w 414580"/>
                  <a:gd name="connsiteY111" fmla="*/ 131506 h 501445"/>
                  <a:gd name="connsiteX112" fmla="*/ 344129 w 414580"/>
                  <a:gd name="connsiteY112" fmla="*/ 129048 h 501445"/>
                  <a:gd name="connsiteX113" fmla="*/ 337984 w 414580"/>
                  <a:gd name="connsiteY113" fmla="*/ 130277 h 501445"/>
                  <a:gd name="connsiteX114" fmla="*/ 331839 w 414580"/>
                  <a:gd name="connsiteY114" fmla="*/ 136422 h 501445"/>
                  <a:gd name="connsiteX115" fmla="*/ 328152 w 414580"/>
                  <a:gd name="connsiteY115" fmla="*/ 140109 h 501445"/>
                  <a:gd name="connsiteX116" fmla="*/ 323236 w 414580"/>
                  <a:gd name="connsiteY116" fmla="*/ 149942 h 501445"/>
                  <a:gd name="connsiteX117" fmla="*/ 319549 w 414580"/>
                  <a:gd name="connsiteY117" fmla="*/ 161003 h 501445"/>
                  <a:gd name="connsiteX118" fmla="*/ 318320 w 414580"/>
                  <a:gd name="connsiteY118" fmla="*/ 90948 h 501445"/>
                  <a:gd name="connsiteX119" fmla="*/ 317091 w 414580"/>
                  <a:gd name="connsiteY119" fmla="*/ 87261 h 501445"/>
                  <a:gd name="connsiteX120" fmla="*/ 314632 w 414580"/>
                  <a:gd name="connsiteY120" fmla="*/ 83574 h 501445"/>
                  <a:gd name="connsiteX121" fmla="*/ 308487 w 414580"/>
                  <a:gd name="connsiteY121" fmla="*/ 73742 h 501445"/>
                  <a:gd name="connsiteX122" fmla="*/ 307258 w 414580"/>
                  <a:gd name="connsiteY122" fmla="*/ 70055 h 501445"/>
                  <a:gd name="connsiteX123" fmla="*/ 294968 w 414580"/>
                  <a:gd name="connsiteY123" fmla="*/ 76200 h 501445"/>
                  <a:gd name="connsiteX124" fmla="*/ 292510 w 414580"/>
                  <a:gd name="connsiteY124" fmla="*/ 114300 h 501445"/>
                  <a:gd name="connsiteX125" fmla="*/ 291281 w 414580"/>
                  <a:gd name="connsiteY125" fmla="*/ 122903 h 501445"/>
                  <a:gd name="connsiteX126" fmla="*/ 288823 w 414580"/>
                  <a:gd name="connsiteY126" fmla="*/ 127819 h 501445"/>
                  <a:gd name="connsiteX127" fmla="*/ 287594 w 414580"/>
                  <a:gd name="connsiteY127" fmla="*/ 132735 h 501445"/>
                  <a:gd name="connsiteX128" fmla="*/ 281449 w 414580"/>
                  <a:gd name="connsiteY128" fmla="*/ 124132 h 501445"/>
                  <a:gd name="connsiteX129" fmla="*/ 280220 w 414580"/>
                  <a:gd name="connsiteY129" fmla="*/ 119216 h 501445"/>
                  <a:gd name="connsiteX130" fmla="*/ 276532 w 414580"/>
                  <a:gd name="connsiteY130" fmla="*/ 88490 h 501445"/>
                  <a:gd name="connsiteX131" fmla="*/ 272845 w 414580"/>
                  <a:gd name="connsiteY131" fmla="*/ 81116 h 501445"/>
                  <a:gd name="connsiteX132" fmla="*/ 270387 w 414580"/>
                  <a:gd name="connsiteY132" fmla="*/ 76200 h 501445"/>
                  <a:gd name="connsiteX133" fmla="*/ 261784 w 414580"/>
                  <a:gd name="connsiteY133" fmla="*/ 66367 h 501445"/>
                  <a:gd name="connsiteX134" fmla="*/ 256868 w 414580"/>
                  <a:gd name="connsiteY134" fmla="*/ 63909 h 501445"/>
                  <a:gd name="connsiteX135" fmla="*/ 253181 w 414580"/>
                  <a:gd name="connsiteY135" fmla="*/ 61451 h 501445"/>
                  <a:gd name="connsiteX136" fmla="*/ 245807 w 414580"/>
                  <a:gd name="connsiteY136" fmla="*/ 62680 h 501445"/>
                  <a:gd name="connsiteX137" fmla="*/ 243349 w 414580"/>
                  <a:gd name="connsiteY137" fmla="*/ 66367 h 501445"/>
                  <a:gd name="connsiteX138" fmla="*/ 240891 w 414580"/>
                  <a:gd name="connsiteY138" fmla="*/ 68826 h 501445"/>
                  <a:gd name="connsiteX139" fmla="*/ 239662 w 414580"/>
                  <a:gd name="connsiteY139" fmla="*/ 73742 h 501445"/>
                  <a:gd name="connsiteX140" fmla="*/ 234745 w 414580"/>
                  <a:gd name="connsiteY140" fmla="*/ 106926 h 501445"/>
                  <a:gd name="connsiteX141" fmla="*/ 231058 w 414580"/>
                  <a:gd name="connsiteY141" fmla="*/ 103238 h 501445"/>
                  <a:gd name="connsiteX142" fmla="*/ 226142 w 414580"/>
                  <a:gd name="connsiteY142" fmla="*/ 93406 h 501445"/>
                  <a:gd name="connsiteX143" fmla="*/ 222455 w 414580"/>
                  <a:gd name="connsiteY143" fmla="*/ 81116 h 501445"/>
                  <a:gd name="connsiteX144" fmla="*/ 221226 w 414580"/>
                  <a:gd name="connsiteY144" fmla="*/ 77429 h 501445"/>
                  <a:gd name="connsiteX145" fmla="*/ 219997 w 414580"/>
                  <a:gd name="connsiteY145" fmla="*/ 70055 h 501445"/>
                  <a:gd name="connsiteX146" fmla="*/ 217539 w 414580"/>
                  <a:gd name="connsiteY146" fmla="*/ 67596 h 501445"/>
                  <a:gd name="connsiteX147" fmla="*/ 213852 w 414580"/>
                  <a:gd name="connsiteY147" fmla="*/ 57764 h 501445"/>
                  <a:gd name="connsiteX148" fmla="*/ 211394 w 414580"/>
                  <a:gd name="connsiteY148" fmla="*/ 52848 h 501445"/>
                  <a:gd name="connsiteX149" fmla="*/ 207707 w 414580"/>
                  <a:gd name="connsiteY149" fmla="*/ 51619 h 501445"/>
                  <a:gd name="connsiteX150" fmla="*/ 205249 w 414580"/>
                  <a:gd name="connsiteY150" fmla="*/ 47932 h 501445"/>
                  <a:gd name="connsiteX151" fmla="*/ 201562 w 414580"/>
                  <a:gd name="connsiteY151" fmla="*/ 45474 h 501445"/>
                  <a:gd name="connsiteX152" fmla="*/ 191729 w 414580"/>
                  <a:gd name="connsiteY152" fmla="*/ 38100 h 501445"/>
                  <a:gd name="connsiteX153" fmla="*/ 186813 w 414580"/>
                  <a:gd name="connsiteY153" fmla="*/ 35642 h 501445"/>
                  <a:gd name="connsiteX154" fmla="*/ 181897 w 414580"/>
                  <a:gd name="connsiteY154" fmla="*/ 30726 h 501445"/>
                  <a:gd name="connsiteX155" fmla="*/ 178210 w 414580"/>
                  <a:gd name="connsiteY155" fmla="*/ 28267 h 501445"/>
                  <a:gd name="connsiteX156" fmla="*/ 175752 w 414580"/>
                  <a:gd name="connsiteY156" fmla="*/ 24580 h 501445"/>
                  <a:gd name="connsiteX157" fmla="*/ 168378 w 414580"/>
                  <a:gd name="connsiteY157" fmla="*/ 17206 h 501445"/>
                  <a:gd name="connsiteX158" fmla="*/ 162232 w 414580"/>
                  <a:gd name="connsiteY158" fmla="*/ 11061 h 501445"/>
                  <a:gd name="connsiteX159" fmla="*/ 156087 w 414580"/>
                  <a:gd name="connsiteY159" fmla="*/ 8603 h 501445"/>
                  <a:gd name="connsiteX160" fmla="*/ 148713 w 414580"/>
                  <a:gd name="connsiteY160" fmla="*/ 6145 h 501445"/>
                  <a:gd name="connsiteX161" fmla="*/ 146255 w 414580"/>
                  <a:gd name="connsiteY161" fmla="*/ 2458 h 501445"/>
                  <a:gd name="connsiteX162" fmla="*/ 138881 w 414580"/>
                  <a:gd name="connsiteY162" fmla="*/ 0 h 501445"/>
                  <a:gd name="connsiteX163" fmla="*/ 84803 w 414580"/>
                  <a:gd name="connsiteY163" fmla="*/ 1229 h 501445"/>
                  <a:gd name="connsiteX164" fmla="*/ 82345 w 414580"/>
                  <a:gd name="connsiteY164" fmla="*/ 6145 h 501445"/>
                  <a:gd name="connsiteX165" fmla="*/ 78658 w 414580"/>
                  <a:gd name="connsiteY165" fmla="*/ 15977 h 501445"/>
                  <a:gd name="connsiteX166" fmla="*/ 79887 w 414580"/>
                  <a:gd name="connsiteY166" fmla="*/ 25809 h 501445"/>
                  <a:gd name="connsiteX167" fmla="*/ 82345 w 414580"/>
                  <a:gd name="connsiteY167" fmla="*/ 33184 h 501445"/>
                  <a:gd name="connsiteX168" fmla="*/ 86032 w 414580"/>
                  <a:gd name="connsiteY168" fmla="*/ 45474 h 501445"/>
                  <a:gd name="connsiteX169" fmla="*/ 87262 w 414580"/>
                  <a:gd name="connsiteY169" fmla="*/ 49161 h 501445"/>
                  <a:gd name="connsiteX170" fmla="*/ 94636 w 414580"/>
                  <a:gd name="connsiteY170" fmla="*/ 54077 h 501445"/>
                  <a:gd name="connsiteX171" fmla="*/ 97094 w 414580"/>
                  <a:gd name="connsiteY171" fmla="*/ 57764 h 501445"/>
                  <a:gd name="connsiteX172" fmla="*/ 89720 w 414580"/>
                  <a:gd name="connsiteY172" fmla="*/ 63909 h 501445"/>
                  <a:gd name="connsiteX173" fmla="*/ 87262 w 414580"/>
                  <a:gd name="connsiteY173" fmla="*/ 67596 h 501445"/>
                  <a:gd name="connsiteX174" fmla="*/ 74971 w 414580"/>
                  <a:gd name="connsiteY174" fmla="*/ 73742 h 501445"/>
                  <a:gd name="connsiteX175" fmla="*/ 67597 w 414580"/>
                  <a:gd name="connsiteY175" fmla="*/ 77429 h 501445"/>
                  <a:gd name="connsiteX176" fmla="*/ 60223 w 414580"/>
                  <a:gd name="connsiteY176" fmla="*/ 88490 h 501445"/>
                  <a:gd name="connsiteX177" fmla="*/ 57765 w 414580"/>
                  <a:gd name="connsiteY177" fmla="*/ 94635 h 501445"/>
                  <a:gd name="connsiteX178" fmla="*/ 51620 w 414580"/>
                  <a:gd name="connsiteY178" fmla="*/ 102009 h 501445"/>
                  <a:gd name="connsiteX179" fmla="*/ 47932 w 414580"/>
                  <a:gd name="connsiteY179" fmla="*/ 109384 h 501445"/>
                  <a:gd name="connsiteX180" fmla="*/ 45474 w 414580"/>
                  <a:gd name="connsiteY180" fmla="*/ 115529 h 501445"/>
                  <a:gd name="connsiteX181" fmla="*/ 43016 w 414580"/>
                  <a:gd name="connsiteY181" fmla="*/ 119216 h 501445"/>
                  <a:gd name="connsiteX182" fmla="*/ 35642 w 414580"/>
                  <a:gd name="connsiteY182" fmla="*/ 127819 h 501445"/>
                  <a:gd name="connsiteX183" fmla="*/ 34413 w 414580"/>
                  <a:gd name="connsiteY183" fmla="*/ 131506 h 501445"/>
                  <a:gd name="connsiteX184" fmla="*/ 30726 w 414580"/>
                  <a:gd name="connsiteY184" fmla="*/ 132735 h 501445"/>
                  <a:gd name="connsiteX185" fmla="*/ 28268 w 414580"/>
                  <a:gd name="connsiteY185" fmla="*/ 140109 h 501445"/>
                  <a:gd name="connsiteX186" fmla="*/ 25810 w 414580"/>
                  <a:gd name="connsiteY186" fmla="*/ 145026 h 501445"/>
                  <a:gd name="connsiteX187" fmla="*/ 24581 w 414580"/>
                  <a:gd name="connsiteY187" fmla="*/ 148713 h 501445"/>
                  <a:gd name="connsiteX188" fmla="*/ 20894 w 414580"/>
                  <a:gd name="connsiteY188" fmla="*/ 149942 h 501445"/>
                  <a:gd name="connsiteX189" fmla="*/ 18436 w 414580"/>
                  <a:gd name="connsiteY189" fmla="*/ 154858 h 501445"/>
                  <a:gd name="connsiteX190" fmla="*/ 14749 w 414580"/>
                  <a:gd name="connsiteY190" fmla="*/ 157316 h 501445"/>
                  <a:gd name="connsiteX191" fmla="*/ 17207 w 414580"/>
                  <a:gd name="connsiteY191" fmla="*/ 145026 h 50144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  <a:cxn ang="0">
                    <a:pos x="connsiteX108" y="connsiteY108"/>
                  </a:cxn>
                  <a:cxn ang="0">
                    <a:pos x="connsiteX109" y="connsiteY109"/>
                  </a:cxn>
                  <a:cxn ang="0">
                    <a:pos x="connsiteX110" y="connsiteY110"/>
                  </a:cxn>
                  <a:cxn ang="0">
                    <a:pos x="connsiteX111" y="connsiteY111"/>
                  </a:cxn>
                  <a:cxn ang="0">
                    <a:pos x="connsiteX112" y="connsiteY112"/>
                  </a:cxn>
                  <a:cxn ang="0">
                    <a:pos x="connsiteX113" y="connsiteY113"/>
                  </a:cxn>
                  <a:cxn ang="0">
                    <a:pos x="connsiteX114" y="connsiteY114"/>
                  </a:cxn>
                  <a:cxn ang="0">
                    <a:pos x="connsiteX115" y="connsiteY115"/>
                  </a:cxn>
                  <a:cxn ang="0">
                    <a:pos x="connsiteX116" y="connsiteY116"/>
                  </a:cxn>
                  <a:cxn ang="0">
                    <a:pos x="connsiteX117" y="connsiteY117"/>
                  </a:cxn>
                  <a:cxn ang="0">
                    <a:pos x="connsiteX118" y="connsiteY118"/>
                  </a:cxn>
                  <a:cxn ang="0">
                    <a:pos x="connsiteX119" y="connsiteY119"/>
                  </a:cxn>
                  <a:cxn ang="0">
                    <a:pos x="connsiteX120" y="connsiteY120"/>
                  </a:cxn>
                  <a:cxn ang="0">
                    <a:pos x="connsiteX121" y="connsiteY121"/>
                  </a:cxn>
                  <a:cxn ang="0">
                    <a:pos x="connsiteX122" y="connsiteY122"/>
                  </a:cxn>
                  <a:cxn ang="0">
                    <a:pos x="connsiteX123" y="connsiteY123"/>
                  </a:cxn>
                  <a:cxn ang="0">
                    <a:pos x="connsiteX124" y="connsiteY124"/>
                  </a:cxn>
                  <a:cxn ang="0">
                    <a:pos x="connsiteX125" y="connsiteY125"/>
                  </a:cxn>
                  <a:cxn ang="0">
                    <a:pos x="connsiteX126" y="connsiteY126"/>
                  </a:cxn>
                  <a:cxn ang="0">
                    <a:pos x="connsiteX127" y="connsiteY127"/>
                  </a:cxn>
                  <a:cxn ang="0">
                    <a:pos x="connsiteX128" y="connsiteY128"/>
                  </a:cxn>
                  <a:cxn ang="0">
                    <a:pos x="connsiteX129" y="connsiteY129"/>
                  </a:cxn>
                  <a:cxn ang="0">
                    <a:pos x="connsiteX130" y="connsiteY130"/>
                  </a:cxn>
                  <a:cxn ang="0">
                    <a:pos x="connsiteX131" y="connsiteY131"/>
                  </a:cxn>
                  <a:cxn ang="0">
                    <a:pos x="connsiteX132" y="connsiteY132"/>
                  </a:cxn>
                  <a:cxn ang="0">
                    <a:pos x="connsiteX133" y="connsiteY133"/>
                  </a:cxn>
                  <a:cxn ang="0">
                    <a:pos x="connsiteX134" y="connsiteY134"/>
                  </a:cxn>
                  <a:cxn ang="0">
                    <a:pos x="connsiteX135" y="connsiteY135"/>
                  </a:cxn>
                  <a:cxn ang="0">
                    <a:pos x="connsiteX136" y="connsiteY136"/>
                  </a:cxn>
                  <a:cxn ang="0">
                    <a:pos x="connsiteX137" y="connsiteY137"/>
                  </a:cxn>
                  <a:cxn ang="0">
                    <a:pos x="connsiteX138" y="connsiteY138"/>
                  </a:cxn>
                  <a:cxn ang="0">
                    <a:pos x="connsiteX139" y="connsiteY139"/>
                  </a:cxn>
                  <a:cxn ang="0">
                    <a:pos x="connsiteX140" y="connsiteY140"/>
                  </a:cxn>
                  <a:cxn ang="0">
                    <a:pos x="connsiteX141" y="connsiteY141"/>
                  </a:cxn>
                  <a:cxn ang="0">
                    <a:pos x="connsiteX142" y="connsiteY142"/>
                  </a:cxn>
                  <a:cxn ang="0">
                    <a:pos x="connsiteX143" y="connsiteY143"/>
                  </a:cxn>
                  <a:cxn ang="0">
                    <a:pos x="connsiteX144" y="connsiteY144"/>
                  </a:cxn>
                  <a:cxn ang="0">
                    <a:pos x="connsiteX145" y="connsiteY145"/>
                  </a:cxn>
                  <a:cxn ang="0">
                    <a:pos x="connsiteX146" y="connsiteY146"/>
                  </a:cxn>
                  <a:cxn ang="0">
                    <a:pos x="connsiteX147" y="connsiteY147"/>
                  </a:cxn>
                  <a:cxn ang="0">
                    <a:pos x="connsiteX148" y="connsiteY148"/>
                  </a:cxn>
                  <a:cxn ang="0">
                    <a:pos x="connsiteX149" y="connsiteY149"/>
                  </a:cxn>
                  <a:cxn ang="0">
                    <a:pos x="connsiteX150" y="connsiteY150"/>
                  </a:cxn>
                  <a:cxn ang="0">
                    <a:pos x="connsiteX151" y="connsiteY151"/>
                  </a:cxn>
                  <a:cxn ang="0">
                    <a:pos x="connsiteX152" y="connsiteY152"/>
                  </a:cxn>
                  <a:cxn ang="0">
                    <a:pos x="connsiteX153" y="connsiteY153"/>
                  </a:cxn>
                  <a:cxn ang="0">
                    <a:pos x="connsiteX154" y="connsiteY154"/>
                  </a:cxn>
                  <a:cxn ang="0">
                    <a:pos x="connsiteX155" y="connsiteY155"/>
                  </a:cxn>
                  <a:cxn ang="0">
                    <a:pos x="connsiteX156" y="connsiteY156"/>
                  </a:cxn>
                  <a:cxn ang="0">
                    <a:pos x="connsiteX157" y="connsiteY157"/>
                  </a:cxn>
                  <a:cxn ang="0">
                    <a:pos x="connsiteX158" y="connsiteY158"/>
                  </a:cxn>
                  <a:cxn ang="0">
                    <a:pos x="connsiteX159" y="connsiteY159"/>
                  </a:cxn>
                  <a:cxn ang="0">
                    <a:pos x="connsiteX160" y="connsiteY160"/>
                  </a:cxn>
                  <a:cxn ang="0">
                    <a:pos x="connsiteX161" y="connsiteY161"/>
                  </a:cxn>
                  <a:cxn ang="0">
                    <a:pos x="connsiteX162" y="connsiteY162"/>
                  </a:cxn>
                  <a:cxn ang="0">
                    <a:pos x="connsiteX163" y="connsiteY163"/>
                  </a:cxn>
                  <a:cxn ang="0">
                    <a:pos x="connsiteX164" y="connsiteY164"/>
                  </a:cxn>
                  <a:cxn ang="0">
                    <a:pos x="connsiteX165" y="connsiteY165"/>
                  </a:cxn>
                  <a:cxn ang="0">
                    <a:pos x="connsiteX166" y="connsiteY166"/>
                  </a:cxn>
                  <a:cxn ang="0">
                    <a:pos x="connsiteX167" y="connsiteY167"/>
                  </a:cxn>
                  <a:cxn ang="0">
                    <a:pos x="connsiteX168" y="connsiteY168"/>
                  </a:cxn>
                  <a:cxn ang="0">
                    <a:pos x="connsiteX169" y="connsiteY169"/>
                  </a:cxn>
                  <a:cxn ang="0">
                    <a:pos x="connsiteX170" y="connsiteY170"/>
                  </a:cxn>
                  <a:cxn ang="0">
                    <a:pos x="connsiteX171" y="connsiteY171"/>
                  </a:cxn>
                  <a:cxn ang="0">
                    <a:pos x="connsiteX172" y="connsiteY172"/>
                  </a:cxn>
                  <a:cxn ang="0">
                    <a:pos x="connsiteX173" y="connsiteY173"/>
                  </a:cxn>
                  <a:cxn ang="0">
                    <a:pos x="connsiteX174" y="connsiteY174"/>
                  </a:cxn>
                  <a:cxn ang="0">
                    <a:pos x="connsiteX175" y="connsiteY175"/>
                  </a:cxn>
                  <a:cxn ang="0">
                    <a:pos x="connsiteX176" y="connsiteY176"/>
                  </a:cxn>
                  <a:cxn ang="0">
                    <a:pos x="connsiteX177" y="connsiteY177"/>
                  </a:cxn>
                  <a:cxn ang="0">
                    <a:pos x="connsiteX178" y="connsiteY178"/>
                  </a:cxn>
                  <a:cxn ang="0">
                    <a:pos x="connsiteX179" y="connsiteY179"/>
                  </a:cxn>
                  <a:cxn ang="0">
                    <a:pos x="connsiteX180" y="connsiteY180"/>
                  </a:cxn>
                  <a:cxn ang="0">
                    <a:pos x="connsiteX181" y="connsiteY181"/>
                  </a:cxn>
                  <a:cxn ang="0">
                    <a:pos x="connsiteX182" y="connsiteY182"/>
                  </a:cxn>
                  <a:cxn ang="0">
                    <a:pos x="connsiteX183" y="connsiteY183"/>
                  </a:cxn>
                  <a:cxn ang="0">
                    <a:pos x="connsiteX184" y="connsiteY184"/>
                  </a:cxn>
                  <a:cxn ang="0">
                    <a:pos x="connsiteX185" y="connsiteY185"/>
                  </a:cxn>
                  <a:cxn ang="0">
                    <a:pos x="connsiteX186" y="connsiteY186"/>
                  </a:cxn>
                  <a:cxn ang="0">
                    <a:pos x="connsiteX187" y="connsiteY187"/>
                  </a:cxn>
                  <a:cxn ang="0">
                    <a:pos x="connsiteX188" y="connsiteY188"/>
                  </a:cxn>
                  <a:cxn ang="0">
                    <a:pos x="connsiteX189" y="connsiteY189"/>
                  </a:cxn>
                  <a:cxn ang="0">
                    <a:pos x="connsiteX190" y="connsiteY190"/>
                  </a:cxn>
                  <a:cxn ang="0">
                    <a:pos x="connsiteX191" y="connsiteY191"/>
                  </a:cxn>
                </a:cxnLst>
                <a:rect l="l" t="t" r="r" b="b"/>
                <a:pathLst>
                  <a:path w="414580" h="501445">
                    <a:moveTo>
                      <a:pt x="17207" y="145026"/>
                    </a:moveTo>
                    <a:cubicBezTo>
                      <a:pt x="17002" y="144821"/>
                      <a:pt x="15676" y="152853"/>
                      <a:pt x="13520" y="156087"/>
                    </a:cubicBezTo>
                    <a:cubicBezTo>
                      <a:pt x="10293" y="160928"/>
                      <a:pt x="10357" y="160131"/>
                      <a:pt x="8603" y="167148"/>
                    </a:cubicBezTo>
                    <a:cubicBezTo>
                      <a:pt x="8193" y="168787"/>
                      <a:pt x="7838" y="170440"/>
                      <a:pt x="7374" y="172064"/>
                    </a:cubicBezTo>
                    <a:cubicBezTo>
                      <a:pt x="7018" y="173310"/>
                      <a:pt x="6459" y="174494"/>
                      <a:pt x="6145" y="175751"/>
                    </a:cubicBezTo>
                    <a:cubicBezTo>
                      <a:pt x="5444" y="178554"/>
                      <a:pt x="5091" y="182775"/>
                      <a:pt x="3687" y="185584"/>
                    </a:cubicBezTo>
                    <a:cubicBezTo>
                      <a:pt x="-1079" y="195118"/>
                      <a:pt x="3090" y="183687"/>
                      <a:pt x="0" y="192958"/>
                    </a:cubicBezTo>
                    <a:cubicBezTo>
                      <a:pt x="819" y="232287"/>
                      <a:pt x="946" y="271637"/>
                      <a:pt x="2458" y="310945"/>
                    </a:cubicBezTo>
                    <a:cubicBezTo>
                      <a:pt x="2588" y="314321"/>
                      <a:pt x="4361" y="317445"/>
                      <a:pt x="4916" y="320777"/>
                    </a:cubicBezTo>
                    <a:cubicBezTo>
                      <a:pt x="5205" y="322511"/>
                      <a:pt x="6777" y="334309"/>
                      <a:pt x="8603" y="335526"/>
                    </a:cubicBezTo>
                    <a:lnTo>
                      <a:pt x="12291" y="337984"/>
                    </a:lnTo>
                    <a:cubicBezTo>
                      <a:pt x="12701" y="341261"/>
                      <a:pt x="12977" y="344558"/>
                      <a:pt x="13520" y="347816"/>
                    </a:cubicBezTo>
                    <a:cubicBezTo>
                      <a:pt x="13798" y="349482"/>
                      <a:pt x="14447" y="351070"/>
                      <a:pt x="14749" y="352732"/>
                    </a:cubicBezTo>
                    <a:cubicBezTo>
                      <a:pt x="15267" y="355582"/>
                      <a:pt x="15460" y="358485"/>
                      <a:pt x="15978" y="361335"/>
                    </a:cubicBezTo>
                    <a:cubicBezTo>
                      <a:pt x="16939" y="366620"/>
                      <a:pt x="17119" y="365330"/>
                      <a:pt x="18436" y="369938"/>
                    </a:cubicBezTo>
                    <a:cubicBezTo>
                      <a:pt x="20667" y="377749"/>
                      <a:pt x="18304" y="372134"/>
                      <a:pt x="22123" y="379771"/>
                    </a:cubicBezTo>
                    <a:cubicBezTo>
                      <a:pt x="22533" y="381819"/>
                      <a:pt x="22845" y="383889"/>
                      <a:pt x="23352" y="385916"/>
                    </a:cubicBezTo>
                    <a:cubicBezTo>
                      <a:pt x="23666" y="387173"/>
                      <a:pt x="24300" y="388338"/>
                      <a:pt x="24581" y="389603"/>
                    </a:cubicBezTo>
                    <a:cubicBezTo>
                      <a:pt x="26644" y="398886"/>
                      <a:pt x="24828" y="396490"/>
                      <a:pt x="28268" y="406809"/>
                    </a:cubicBezTo>
                    <a:cubicBezTo>
                      <a:pt x="28678" y="408038"/>
                      <a:pt x="29042" y="409283"/>
                      <a:pt x="29497" y="410496"/>
                    </a:cubicBezTo>
                    <a:cubicBezTo>
                      <a:pt x="30737" y="413804"/>
                      <a:pt x="32255" y="416921"/>
                      <a:pt x="33184" y="420329"/>
                    </a:cubicBezTo>
                    <a:cubicBezTo>
                      <a:pt x="34073" y="423588"/>
                      <a:pt x="34387" y="427024"/>
                      <a:pt x="35642" y="430161"/>
                    </a:cubicBezTo>
                    <a:cubicBezTo>
                      <a:pt x="40482" y="442260"/>
                      <a:pt x="35649" y="431402"/>
                      <a:pt x="40558" y="439993"/>
                    </a:cubicBezTo>
                    <a:cubicBezTo>
                      <a:pt x="46795" y="450908"/>
                      <a:pt x="39485" y="439613"/>
                      <a:pt x="45474" y="448596"/>
                    </a:cubicBezTo>
                    <a:cubicBezTo>
                      <a:pt x="46175" y="450701"/>
                      <a:pt x="47118" y="454608"/>
                      <a:pt x="49162" y="455971"/>
                    </a:cubicBezTo>
                    <a:cubicBezTo>
                      <a:pt x="50567" y="456908"/>
                      <a:pt x="52439" y="456790"/>
                      <a:pt x="54078" y="457200"/>
                    </a:cubicBezTo>
                    <a:cubicBezTo>
                      <a:pt x="55307" y="458429"/>
                      <a:pt x="56351" y="459877"/>
                      <a:pt x="57765" y="460887"/>
                    </a:cubicBezTo>
                    <a:cubicBezTo>
                      <a:pt x="59256" y="461952"/>
                      <a:pt x="61110" y="462402"/>
                      <a:pt x="62681" y="463345"/>
                    </a:cubicBezTo>
                    <a:cubicBezTo>
                      <a:pt x="65214" y="464865"/>
                      <a:pt x="67597" y="466622"/>
                      <a:pt x="70055" y="468261"/>
                    </a:cubicBezTo>
                    <a:lnTo>
                      <a:pt x="73742" y="470719"/>
                    </a:lnTo>
                    <a:lnTo>
                      <a:pt x="77429" y="473177"/>
                    </a:lnTo>
                    <a:cubicBezTo>
                      <a:pt x="78248" y="474406"/>
                      <a:pt x="78843" y="475820"/>
                      <a:pt x="79887" y="476864"/>
                    </a:cubicBezTo>
                    <a:cubicBezTo>
                      <a:pt x="82928" y="479905"/>
                      <a:pt x="85499" y="479847"/>
                      <a:pt x="89720" y="480551"/>
                    </a:cubicBezTo>
                    <a:cubicBezTo>
                      <a:pt x="94810" y="481399"/>
                      <a:pt x="103182" y="482387"/>
                      <a:pt x="108155" y="483009"/>
                    </a:cubicBezTo>
                    <a:cubicBezTo>
                      <a:pt x="120855" y="482599"/>
                      <a:pt x="133641" y="483309"/>
                      <a:pt x="146255" y="481780"/>
                    </a:cubicBezTo>
                    <a:cubicBezTo>
                      <a:pt x="148772" y="481475"/>
                      <a:pt x="149359" y="474051"/>
                      <a:pt x="149942" y="473177"/>
                    </a:cubicBezTo>
                    <a:cubicBezTo>
                      <a:pt x="150761" y="471948"/>
                      <a:pt x="152400" y="471538"/>
                      <a:pt x="153629" y="470719"/>
                    </a:cubicBezTo>
                    <a:cubicBezTo>
                      <a:pt x="154015" y="469177"/>
                      <a:pt x="154503" y="462537"/>
                      <a:pt x="158545" y="463345"/>
                    </a:cubicBezTo>
                    <a:cubicBezTo>
                      <a:pt x="159993" y="463635"/>
                      <a:pt x="160080" y="465879"/>
                      <a:pt x="161003" y="467032"/>
                    </a:cubicBezTo>
                    <a:cubicBezTo>
                      <a:pt x="163004" y="469532"/>
                      <a:pt x="164413" y="470124"/>
                      <a:pt x="167149" y="471948"/>
                    </a:cubicBezTo>
                    <a:cubicBezTo>
                      <a:pt x="167559" y="473587"/>
                      <a:pt x="167914" y="475240"/>
                      <a:pt x="168378" y="476864"/>
                    </a:cubicBezTo>
                    <a:cubicBezTo>
                      <a:pt x="168734" y="478110"/>
                      <a:pt x="169478" y="479262"/>
                      <a:pt x="169607" y="480551"/>
                    </a:cubicBezTo>
                    <a:cubicBezTo>
                      <a:pt x="170301" y="487493"/>
                      <a:pt x="170426" y="494480"/>
                      <a:pt x="170836" y="501445"/>
                    </a:cubicBezTo>
                    <a:cubicBezTo>
                      <a:pt x="173294" y="501035"/>
                      <a:pt x="175828" y="500949"/>
                      <a:pt x="178210" y="500216"/>
                    </a:cubicBezTo>
                    <a:cubicBezTo>
                      <a:pt x="181192" y="499298"/>
                      <a:pt x="183916" y="497688"/>
                      <a:pt x="186813" y="496529"/>
                    </a:cubicBezTo>
                    <a:cubicBezTo>
                      <a:pt x="188016" y="496048"/>
                      <a:pt x="189309" y="495810"/>
                      <a:pt x="190500" y="495300"/>
                    </a:cubicBezTo>
                    <a:cubicBezTo>
                      <a:pt x="192184" y="494578"/>
                      <a:pt x="193732" y="493564"/>
                      <a:pt x="195416" y="492842"/>
                    </a:cubicBezTo>
                    <a:cubicBezTo>
                      <a:pt x="196607" y="492332"/>
                      <a:pt x="197944" y="492192"/>
                      <a:pt x="199103" y="491613"/>
                    </a:cubicBezTo>
                    <a:cubicBezTo>
                      <a:pt x="213853" y="484239"/>
                      <a:pt x="193825" y="493552"/>
                      <a:pt x="205249" y="486696"/>
                    </a:cubicBezTo>
                    <a:cubicBezTo>
                      <a:pt x="206360" y="486029"/>
                      <a:pt x="207777" y="486046"/>
                      <a:pt x="208936" y="485467"/>
                    </a:cubicBezTo>
                    <a:cubicBezTo>
                      <a:pt x="210257" y="484806"/>
                      <a:pt x="211394" y="483828"/>
                      <a:pt x="212623" y="483009"/>
                    </a:cubicBezTo>
                    <a:cubicBezTo>
                      <a:pt x="213442" y="481780"/>
                      <a:pt x="214420" y="480643"/>
                      <a:pt x="215081" y="479322"/>
                    </a:cubicBezTo>
                    <a:cubicBezTo>
                      <a:pt x="215660" y="478163"/>
                      <a:pt x="215501" y="476647"/>
                      <a:pt x="216310" y="475635"/>
                    </a:cubicBezTo>
                    <a:cubicBezTo>
                      <a:pt x="217233" y="474482"/>
                      <a:pt x="218768" y="473996"/>
                      <a:pt x="219997" y="473177"/>
                    </a:cubicBezTo>
                    <a:cubicBezTo>
                      <a:pt x="220407" y="471948"/>
                      <a:pt x="220310" y="470406"/>
                      <a:pt x="221226" y="469490"/>
                    </a:cubicBezTo>
                    <a:cubicBezTo>
                      <a:pt x="223315" y="467401"/>
                      <a:pt x="226511" y="466663"/>
                      <a:pt x="228600" y="464574"/>
                    </a:cubicBezTo>
                    <a:cubicBezTo>
                      <a:pt x="232647" y="460527"/>
                      <a:pt x="233780" y="458912"/>
                      <a:pt x="239662" y="455971"/>
                    </a:cubicBezTo>
                    <a:lnTo>
                      <a:pt x="249494" y="451055"/>
                    </a:lnTo>
                    <a:cubicBezTo>
                      <a:pt x="252175" y="443009"/>
                      <a:pt x="248451" y="450905"/>
                      <a:pt x="254410" y="446138"/>
                    </a:cubicBezTo>
                    <a:cubicBezTo>
                      <a:pt x="262352" y="439785"/>
                      <a:pt x="251288" y="444311"/>
                      <a:pt x="260555" y="441222"/>
                    </a:cubicBezTo>
                    <a:cubicBezTo>
                      <a:pt x="260965" y="439993"/>
                      <a:pt x="261205" y="438694"/>
                      <a:pt x="261784" y="437535"/>
                    </a:cubicBezTo>
                    <a:cubicBezTo>
                      <a:pt x="263088" y="434926"/>
                      <a:pt x="267952" y="429210"/>
                      <a:pt x="269158" y="427703"/>
                    </a:cubicBezTo>
                    <a:cubicBezTo>
                      <a:pt x="269568" y="426474"/>
                      <a:pt x="269758" y="425148"/>
                      <a:pt x="270387" y="424016"/>
                    </a:cubicBezTo>
                    <a:cubicBezTo>
                      <a:pt x="273862" y="417760"/>
                      <a:pt x="274031" y="417913"/>
                      <a:pt x="277762" y="414184"/>
                    </a:cubicBezTo>
                    <a:cubicBezTo>
                      <a:pt x="278581" y="412545"/>
                      <a:pt x="279902" y="411072"/>
                      <a:pt x="280220" y="409267"/>
                    </a:cubicBezTo>
                    <a:cubicBezTo>
                      <a:pt x="280808" y="405932"/>
                      <a:pt x="282377" y="376963"/>
                      <a:pt x="282678" y="374855"/>
                    </a:cubicBezTo>
                    <a:cubicBezTo>
                      <a:pt x="283592" y="368459"/>
                      <a:pt x="285314" y="367243"/>
                      <a:pt x="288823" y="362564"/>
                    </a:cubicBezTo>
                    <a:cubicBezTo>
                      <a:pt x="290986" y="356074"/>
                      <a:pt x="289333" y="359955"/>
                      <a:pt x="294968" y="351503"/>
                    </a:cubicBezTo>
                    <a:lnTo>
                      <a:pt x="297426" y="347816"/>
                    </a:lnTo>
                    <a:cubicBezTo>
                      <a:pt x="297836" y="336755"/>
                      <a:pt x="297942" y="325678"/>
                      <a:pt x="298655" y="314632"/>
                    </a:cubicBezTo>
                    <a:cubicBezTo>
                      <a:pt x="298764" y="312946"/>
                      <a:pt x="299420" y="311340"/>
                      <a:pt x="299884" y="309716"/>
                    </a:cubicBezTo>
                    <a:cubicBezTo>
                      <a:pt x="300582" y="307275"/>
                      <a:pt x="301533" y="304089"/>
                      <a:pt x="303571" y="302342"/>
                    </a:cubicBezTo>
                    <a:cubicBezTo>
                      <a:pt x="306509" y="299824"/>
                      <a:pt x="312208" y="297414"/>
                      <a:pt x="315862" y="296196"/>
                    </a:cubicBezTo>
                    <a:cubicBezTo>
                      <a:pt x="317464" y="295662"/>
                      <a:pt x="319139" y="295377"/>
                      <a:pt x="320778" y="294967"/>
                    </a:cubicBezTo>
                    <a:cubicBezTo>
                      <a:pt x="326621" y="291072"/>
                      <a:pt x="323064" y="292976"/>
                      <a:pt x="331839" y="290051"/>
                    </a:cubicBezTo>
                    <a:cubicBezTo>
                      <a:pt x="331855" y="290046"/>
                      <a:pt x="339213" y="287593"/>
                      <a:pt x="339213" y="287593"/>
                    </a:cubicBezTo>
                    <a:cubicBezTo>
                      <a:pt x="342742" y="286711"/>
                      <a:pt x="348510" y="285402"/>
                      <a:pt x="351503" y="283906"/>
                    </a:cubicBezTo>
                    <a:cubicBezTo>
                      <a:pt x="355873" y="281722"/>
                      <a:pt x="355888" y="281424"/>
                      <a:pt x="360107" y="280219"/>
                    </a:cubicBezTo>
                    <a:cubicBezTo>
                      <a:pt x="361945" y="279694"/>
                      <a:pt x="366746" y="278743"/>
                      <a:pt x="368710" y="277761"/>
                    </a:cubicBezTo>
                    <a:cubicBezTo>
                      <a:pt x="370031" y="277100"/>
                      <a:pt x="371076" y="275964"/>
                      <a:pt x="372397" y="275303"/>
                    </a:cubicBezTo>
                    <a:cubicBezTo>
                      <a:pt x="373556" y="274724"/>
                      <a:pt x="374893" y="274584"/>
                      <a:pt x="376084" y="274074"/>
                    </a:cubicBezTo>
                    <a:cubicBezTo>
                      <a:pt x="377768" y="273352"/>
                      <a:pt x="379316" y="272338"/>
                      <a:pt x="381000" y="271616"/>
                    </a:cubicBezTo>
                    <a:cubicBezTo>
                      <a:pt x="382191" y="271106"/>
                      <a:pt x="383496" y="270897"/>
                      <a:pt x="384687" y="270387"/>
                    </a:cubicBezTo>
                    <a:cubicBezTo>
                      <a:pt x="395314" y="265833"/>
                      <a:pt x="384645" y="269581"/>
                      <a:pt x="393291" y="266700"/>
                    </a:cubicBezTo>
                    <a:cubicBezTo>
                      <a:pt x="394520" y="265881"/>
                      <a:pt x="395934" y="265286"/>
                      <a:pt x="396978" y="264242"/>
                    </a:cubicBezTo>
                    <a:cubicBezTo>
                      <a:pt x="398022" y="263198"/>
                      <a:pt x="398283" y="261478"/>
                      <a:pt x="399436" y="260555"/>
                    </a:cubicBezTo>
                    <a:cubicBezTo>
                      <a:pt x="400448" y="259746"/>
                      <a:pt x="401894" y="259736"/>
                      <a:pt x="403123" y="259326"/>
                    </a:cubicBezTo>
                    <a:cubicBezTo>
                      <a:pt x="407504" y="254943"/>
                      <a:pt x="404070" y="258897"/>
                      <a:pt x="408039" y="251951"/>
                    </a:cubicBezTo>
                    <a:cubicBezTo>
                      <a:pt x="408772" y="250669"/>
                      <a:pt x="409714" y="249517"/>
                      <a:pt x="410497" y="248264"/>
                    </a:cubicBezTo>
                    <a:cubicBezTo>
                      <a:pt x="411763" y="246238"/>
                      <a:pt x="412955" y="244167"/>
                      <a:pt x="414184" y="242119"/>
                    </a:cubicBezTo>
                    <a:cubicBezTo>
                      <a:pt x="413774" y="237613"/>
                      <a:pt x="415982" y="231963"/>
                      <a:pt x="412955" y="228600"/>
                    </a:cubicBezTo>
                    <a:cubicBezTo>
                      <a:pt x="410746" y="226145"/>
                      <a:pt x="406426" y="229829"/>
                      <a:pt x="403123" y="229829"/>
                    </a:cubicBezTo>
                    <a:cubicBezTo>
                      <a:pt x="400157" y="229829"/>
                      <a:pt x="396200" y="228341"/>
                      <a:pt x="393291" y="227371"/>
                    </a:cubicBezTo>
                    <a:cubicBezTo>
                      <a:pt x="380791" y="214876"/>
                      <a:pt x="389316" y="224621"/>
                      <a:pt x="393291" y="181896"/>
                    </a:cubicBezTo>
                    <a:cubicBezTo>
                      <a:pt x="394052" y="173713"/>
                      <a:pt x="394774" y="173527"/>
                      <a:pt x="398207" y="168377"/>
                    </a:cubicBezTo>
                    <a:cubicBezTo>
                      <a:pt x="398617" y="166738"/>
                      <a:pt x="399436" y="165150"/>
                      <a:pt x="399436" y="163461"/>
                    </a:cubicBezTo>
                    <a:cubicBezTo>
                      <a:pt x="399436" y="138681"/>
                      <a:pt x="404088" y="140868"/>
                      <a:pt x="384687" y="145026"/>
                    </a:cubicBezTo>
                    <a:cubicBezTo>
                      <a:pt x="383420" y="145297"/>
                      <a:pt x="382229" y="145845"/>
                      <a:pt x="381000" y="146255"/>
                    </a:cubicBezTo>
                    <a:cubicBezTo>
                      <a:pt x="379361" y="147484"/>
                      <a:pt x="377821" y="148856"/>
                      <a:pt x="376084" y="149942"/>
                    </a:cubicBezTo>
                    <a:cubicBezTo>
                      <a:pt x="374530" y="150913"/>
                      <a:pt x="372341" y="150993"/>
                      <a:pt x="371168" y="152400"/>
                    </a:cubicBezTo>
                    <a:cubicBezTo>
                      <a:pt x="370087" y="153698"/>
                      <a:pt x="370473" y="155714"/>
                      <a:pt x="369939" y="157316"/>
                    </a:cubicBezTo>
                    <a:cubicBezTo>
                      <a:pt x="367342" y="165108"/>
                      <a:pt x="367978" y="161107"/>
                      <a:pt x="366252" y="167148"/>
                    </a:cubicBezTo>
                    <a:cubicBezTo>
                      <a:pt x="366047" y="167865"/>
                      <a:pt x="364531" y="174646"/>
                      <a:pt x="363794" y="175751"/>
                    </a:cubicBezTo>
                    <a:cubicBezTo>
                      <a:pt x="362830" y="177197"/>
                      <a:pt x="361336" y="178209"/>
                      <a:pt x="360107" y="179438"/>
                    </a:cubicBezTo>
                    <a:cubicBezTo>
                      <a:pt x="359288" y="181487"/>
                      <a:pt x="358424" y="183518"/>
                      <a:pt x="357649" y="185584"/>
                    </a:cubicBezTo>
                    <a:cubicBezTo>
                      <a:pt x="357194" y="186797"/>
                      <a:pt x="357249" y="188276"/>
                      <a:pt x="356420" y="189271"/>
                    </a:cubicBezTo>
                    <a:cubicBezTo>
                      <a:pt x="353082" y="193277"/>
                      <a:pt x="345358" y="200332"/>
                      <a:pt x="345358" y="200332"/>
                    </a:cubicBezTo>
                    <a:cubicBezTo>
                      <a:pt x="339631" y="186016"/>
                      <a:pt x="341085" y="192084"/>
                      <a:pt x="344129" y="164690"/>
                    </a:cubicBezTo>
                    <a:cubicBezTo>
                      <a:pt x="344292" y="163222"/>
                      <a:pt x="345854" y="162285"/>
                      <a:pt x="346587" y="161003"/>
                    </a:cubicBezTo>
                    <a:cubicBezTo>
                      <a:pt x="347496" y="159412"/>
                      <a:pt x="348226" y="157726"/>
                      <a:pt x="349045" y="156087"/>
                    </a:cubicBezTo>
                    <a:cubicBezTo>
                      <a:pt x="349455" y="153629"/>
                      <a:pt x="349785" y="151157"/>
                      <a:pt x="350274" y="148713"/>
                    </a:cubicBezTo>
                    <a:cubicBezTo>
                      <a:pt x="351528" y="142442"/>
                      <a:pt x="354043" y="139044"/>
                      <a:pt x="350274" y="131506"/>
                    </a:cubicBezTo>
                    <a:cubicBezTo>
                      <a:pt x="349287" y="129533"/>
                      <a:pt x="346177" y="129867"/>
                      <a:pt x="344129" y="129048"/>
                    </a:cubicBezTo>
                    <a:cubicBezTo>
                      <a:pt x="342081" y="129458"/>
                      <a:pt x="339940" y="129544"/>
                      <a:pt x="337984" y="130277"/>
                    </a:cubicBezTo>
                    <a:cubicBezTo>
                      <a:pt x="333614" y="131916"/>
                      <a:pt x="334570" y="133145"/>
                      <a:pt x="331839" y="136422"/>
                    </a:cubicBezTo>
                    <a:cubicBezTo>
                      <a:pt x="330726" y="137757"/>
                      <a:pt x="329265" y="138774"/>
                      <a:pt x="328152" y="140109"/>
                    </a:cubicBezTo>
                    <a:cubicBezTo>
                      <a:pt x="325319" y="143508"/>
                      <a:pt x="324974" y="145597"/>
                      <a:pt x="323236" y="149942"/>
                    </a:cubicBezTo>
                    <a:cubicBezTo>
                      <a:pt x="320483" y="169216"/>
                      <a:pt x="321914" y="172829"/>
                      <a:pt x="319549" y="161003"/>
                    </a:cubicBezTo>
                    <a:cubicBezTo>
                      <a:pt x="319139" y="137651"/>
                      <a:pt x="319098" y="114290"/>
                      <a:pt x="318320" y="90948"/>
                    </a:cubicBezTo>
                    <a:cubicBezTo>
                      <a:pt x="318277" y="89653"/>
                      <a:pt x="317670" y="88420"/>
                      <a:pt x="317091" y="87261"/>
                    </a:cubicBezTo>
                    <a:cubicBezTo>
                      <a:pt x="316430" y="85940"/>
                      <a:pt x="315452" y="84803"/>
                      <a:pt x="314632" y="83574"/>
                    </a:cubicBezTo>
                    <a:cubicBezTo>
                      <a:pt x="311707" y="74799"/>
                      <a:pt x="314330" y="77637"/>
                      <a:pt x="308487" y="73742"/>
                    </a:cubicBezTo>
                    <a:cubicBezTo>
                      <a:pt x="308077" y="72513"/>
                      <a:pt x="308533" y="69823"/>
                      <a:pt x="307258" y="70055"/>
                    </a:cubicBezTo>
                    <a:cubicBezTo>
                      <a:pt x="302752" y="70874"/>
                      <a:pt x="294968" y="76200"/>
                      <a:pt x="294968" y="76200"/>
                    </a:cubicBezTo>
                    <a:cubicBezTo>
                      <a:pt x="290903" y="92461"/>
                      <a:pt x="294795" y="75454"/>
                      <a:pt x="292510" y="114300"/>
                    </a:cubicBezTo>
                    <a:cubicBezTo>
                      <a:pt x="292340" y="117192"/>
                      <a:pt x="292043" y="120108"/>
                      <a:pt x="291281" y="122903"/>
                    </a:cubicBezTo>
                    <a:cubicBezTo>
                      <a:pt x="290799" y="124671"/>
                      <a:pt x="289466" y="126104"/>
                      <a:pt x="288823" y="127819"/>
                    </a:cubicBezTo>
                    <a:cubicBezTo>
                      <a:pt x="288230" y="129401"/>
                      <a:pt x="288004" y="131096"/>
                      <a:pt x="287594" y="132735"/>
                    </a:cubicBezTo>
                    <a:cubicBezTo>
                      <a:pt x="285546" y="129867"/>
                      <a:pt x="283137" y="127226"/>
                      <a:pt x="281449" y="124132"/>
                    </a:cubicBezTo>
                    <a:cubicBezTo>
                      <a:pt x="280640" y="122649"/>
                      <a:pt x="280586" y="120865"/>
                      <a:pt x="280220" y="119216"/>
                    </a:cubicBezTo>
                    <a:cubicBezTo>
                      <a:pt x="277327" y="106197"/>
                      <a:pt x="279392" y="110415"/>
                      <a:pt x="276532" y="88490"/>
                    </a:cubicBezTo>
                    <a:cubicBezTo>
                      <a:pt x="276056" y="84840"/>
                      <a:pt x="274631" y="84241"/>
                      <a:pt x="272845" y="81116"/>
                    </a:cubicBezTo>
                    <a:cubicBezTo>
                      <a:pt x="271936" y="79525"/>
                      <a:pt x="271296" y="77791"/>
                      <a:pt x="270387" y="76200"/>
                    </a:cubicBezTo>
                    <a:cubicBezTo>
                      <a:pt x="268206" y="72383"/>
                      <a:pt x="265279" y="69086"/>
                      <a:pt x="261784" y="66367"/>
                    </a:cubicBezTo>
                    <a:cubicBezTo>
                      <a:pt x="260338" y="65242"/>
                      <a:pt x="258459" y="64818"/>
                      <a:pt x="256868" y="63909"/>
                    </a:cubicBezTo>
                    <a:cubicBezTo>
                      <a:pt x="255586" y="63176"/>
                      <a:pt x="254410" y="62270"/>
                      <a:pt x="253181" y="61451"/>
                    </a:cubicBezTo>
                    <a:cubicBezTo>
                      <a:pt x="250723" y="61861"/>
                      <a:pt x="248036" y="61566"/>
                      <a:pt x="245807" y="62680"/>
                    </a:cubicBezTo>
                    <a:cubicBezTo>
                      <a:pt x="244486" y="63341"/>
                      <a:pt x="244272" y="65214"/>
                      <a:pt x="243349" y="66367"/>
                    </a:cubicBezTo>
                    <a:cubicBezTo>
                      <a:pt x="242625" y="67272"/>
                      <a:pt x="241710" y="68006"/>
                      <a:pt x="240891" y="68826"/>
                    </a:cubicBezTo>
                    <a:cubicBezTo>
                      <a:pt x="240481" y="70465"/>
                      <a:pt x="239836" y="72062"/>
                      <a:pt x="239662" y="73742"/>
                    </a:cubicBezTo>
                    <a:cubicBezTo>
                      <a:pt x="236277" y="106456"/>
                      <a:pt x="244561" y="97106"/>
                      <a:pt x="234745" y="106926"/>
                    </a:cubicBezTo>
                    <a:cubicBezTo>
                      <a:pt x="233516" y="105697"/>
                      <a:pt x="231991" y="104705"/>
                      <a:pt x="231058" y="103238"/>
                    </a:cubicBezTo>
                    <a:cubicBezTo>
                      <a:pt x="229091" y="100147"/>
                      <a:pt x="227031" y="96961"/>
                      <a:pt x="226142" y="93406"/>
                    </a:cubicBezTo>
                    <a:cubicBezTo>
                      <a:pt x="224285" y="85976"/>
                      <a:pt x="225447" y="90092"/>
                      <a:pt x="222455" y="81116"/>
                    </a:cubicBezTo>
                    <a:cubicBezTo>
                      <a:pt x="222045" y="79887"/>
                      <a:pt x="221439" y="78707"/>
                      <a:pt x="221226" y="77429"/>
                    </a:cubicBezTo>
                    <a:cubicBezTo>
                      <a:pt x="220816" y="74971"/>
                      <a:pt x="220872" y="72388"/>
                      <a:pt x="219997" y="70055"/>
                    </a:cubicBezTo>
                    <a:cubicBezTo>
                      <a:pt x="219590" y="68970"/>
                      <a:pt x="218358" y="68416"/>
                      <a:pt x="217539" y="67596"/>
                    </a:cubicBezTo>
                    <a:cubicBezTo>
                      <a:pt x="215627" y="58035"/>
                      <a:pt x="217747" y="64580"/>
                      <a:pt x="213852" y="57764"/>
                    </a:cubicBezTo>
                    <a:cubicBezTo>
                      <a:pt x="212943" y="56173"/>
                      <a:pt x="212689" y="54143"/>
                      <a:pt x="211394" y="52848"/>
                    </a:cubicBezTo>
                    <a:cubicBezTo>
                      <a:pt x="210478" y="51932"/>
                      <a:pt x="208936" y="52029"/>
                      <a:pt x="207707" y="51619"/>
                    </a:cubicBezTo>
                    <a:cubicBezTo>
                      <a:pt x="206888" y="50390"/>
                      <a:pt x="206293" y="48976"/>
                      <a:pt x="205249" y="47932"/>
                    </a:cubicBezTo>
                    <a:cubicBezTo>
                      <a:pt x="204205" y="46888"/>
                      <a:pt x="202757" y="46343"/>
                      <a:pt x="201562" y="45474"/>
                    </a:cubicBezTo>
                    <a:cubicBezTo>
                      <a:pt x="198249" y="43064"/>
                      <a:pt x="195393" y="39932"/>
                      <a:pt x="191729" y="38100"/>
                    </a:cubicBezTo>
                    <a:cubicBezTo>
                      <a:pt x="190090" y="37281"/>
                      <a:pt x="188279" y="36741"/>
                      <a:pt x="186813" y="35642"/>
                    </a:cubicBezTo>
                    <a:cubicBezTo>
                      <a:pt x="184959" y="34252"/>
                      <a:pt x="183656" y="32234"/>
                      <a:pt x="181897" y="30726"/>
                    </a:cubicBezTo>
                    <a:cubicBezTo>
                      <a:pt x="180775" y="29765"/>
                      <a:pt x="179439" y="29087"/>
                      <a:pt x="178210" y="28267"/>
                    </a:cubicBezTo>
                    <a:cubicBezTo>
                      <a:pt x="177391" y="27038"/>
                      <a:pt x="176733" y="25684"/>
                      <a:pt x="175752" y="24580"/>
                    </a:cubicBezTo>
                    <a:cubicBezTo>
                      <a:pt x="173443" y="21982"/>
                      <a:pt x="170306" y="20098"/>
                      <a:pt x="168378" y="17206"/>
                    </a:cubicBezTo>
                    <a:cubicBezTo>
                      <a:pt x="165919" y="13518"/>
                      <a:pt x="166330" y="13110"/>
                      <a:pt x="162232" y="11061"/>
                    </a:cubicBezTo>
                    <a:cubicBezTo>
                      <a:pt x="160259" y="10074"/>
                      <a:pt x="158160" y="9357"/>
                      <a:pt x="156087" y="8603"/>
                    </a:cubicBezTo>
                    <a:cubicBezTo>
                      <a:pt x="153652" y="7718"/>
                      <a:pt x="148713" y="6145"/>
                      <a:pt x="148713" y="6145"/>
                    </a:cubicBezTo>
                    <a:cubicBezTo>
                      <a:pt x="147894" y="4916"/>
                      <a:pt x="147508" y="3241"/>
                      <a:pt x="146255" y="2458"/>
                    </a:cubicBezTo>
                    <a:cubicBezTo>
                      <a:pt x="144058" y="1085"/>
                      <a:pt x="138881" y="0"/>
                      <a:pt x="138881" y="0"/>
                    </a:cubicBezTo>
                    <a:lnTo>
                      <a:pt x="84803" y="1229"/>
                    </a:lnTo>
                    <a:cubicBezTo>
                      <a:pt x="82982" y="1427"/>
                      <a:pt x="82988" y="4430"/>
                      <a:pt x="82345" y="6145"/>
                    </a:cubicBezTo>
                    <a:cubicBezTo>
                      <a:pt x="77325" y="19532"/>
                      <a:pt x="85501" y="2290"/>
                      <a:pt x="78658" y="15977"/>
                    </a:cubicBezTo>
                    <a:cubicBezTo>
                      <a:pt x="79068" y="19254"/>
                      <a:pt x="79195" y="22579"/>
                      <a:pt x="79887" y="25809"/>
                    </a:cubicBezTo>
                    <a:cubicBezTo>
                      <a:pt x="80430" y="28343"/>
                      <a:pt x="81717" y="30670"/>
                      <a:pt x="82345" y="33184"/>
                    </a:cubicBezTo>
                    <a:cubicBezTo>
                      <a:pt x="84201" y="40607"/>
                      <a:pt x="83042" y="36507"/>
                      <a:pt x="86032" y="45474"/>
                    </a:cubicBezTo>
                    <a:cubicBezTo>
                      <a:pt x="86442" y="46703"/>
                      <a:pt x="86184" y="48442"/>
                      <a:pt x="87262" y="49161"/>
                    </a:cubicBezTo>
                    <a:lnTo>
                      <a:pt x="94636" y="54077"/>
                    </a:lnTo>
                    <a:cubicBezTo>
                      <a:pt x="95455" y="55306"/>
                      <a:pt x="96851" y="56307"/>
                      <a:pt x="97094" y="57764"/>
                    </a:cubicBezTo>
                    <a:cubicBezTo>
                      <a:pt x="97877" y="62460"/>
                      <a:pt x="92454" y="62815"/>
                      <a:pt x="89720" y="63909"/>
                    </a:cubicBezTo>
                    <a:cubicBezTo>
                      <a:pt x="88901" y="65138"/>
                      <a:pt x="88383" y="66635"/>
                      <a:pt x="87262" y="67596"/>
                    </a:cubicBezTo>
                    <a:cubicBezTo>
                      <a:pt x="82474" y="71700"/>
                      <a:pt x="80334" y="71061"/>
                      <a:pt x="74971" y="73742"/>
                    </a:cubicBezTo>
                    <a:cubicBezTo>
                      <a:pt x="65441" y="78507"/>
                      <a:pt x="76864" y="74340"/>
                      <a:pt x="67597" y="77429"/>
                    </a:cubicBezTo>
                    <a:cubicBezTo>
                      <a:pt x="65139" y="81116"/>
                      <a:pt x="61869" y="84376"/>
                      <a:pt x="60223" y="88490"/>
                    </a:cubicBezTo>
                    <a:cubicBezTo>
                      <a:pt x="59404" y="90538"/>
                      <a:pt x="58752" y="92662"/>
                      <a:pt x="57765" y="94635"/>
                    </a:cubicBezTo>
                    <a:cubicBezTo>
                      <a:pt x="56054" y="98057"/>
                      <a:pt x="54338" y="99291"/>
                      <a:pt x="51620" y="102009"/>
                    </a:cubicBezTo>
                    <a:cubicBezTo>
                      <a:pt x="48335" y="115150"/>
                      <a:pt x="52803" y="100861"/>
                      <a:pt x="47932" y="109384"/>
                    </a:cubicBezTo>
                    <a:cubicBezTo>
                      <a:pt x="46837" y="111299"/>
                      <a:pt x="46461" y="113556"/>
                      <a:pt x="45474" y="115529"/>
                    </a:cubicBezTo>
                    <a:cubicBezTo>
                      <a:pt x="44813" y="116850"/>
                      <a:pt x="43875" y="118014"/>
                      <a:pt x="43016" y="119216"/>
                    </a:cubicBezTo>
                    <a:cubicBezTo>
                      <a:pt x="39074" y="124734"/>
                      <a:pt x="40108" y="123353"/>
                      <a:pt x="35642" y="127819"/>
                    </a:cubicBezTo>
                    <a:cubicBezTo>
                      <a:pt x="35232" y="129048"/>
                      <a:pt x="35329" y="130590"/>
                      <a:pt x="34413" y="131506"/>
                    </a:cubicBezTo>
                    <a:cubicBezTo>
                      <a:pt x="33497" y="132422"/>
                      <a:pt x="31479" y="131681"/>
                      <a:pt x="30726" y="132735"/>
                    </a:cubicBezTo>
                    <a:cubicBezTo>
                      <a:pt x="29220" y="134843"/>
                      <a:pt x="29427" y="137791"/>
                      <a:pt x="28268" y="140109"/>
                    </a:cubicBezTo>
                    <a:cubicBezTo>
                      <a:pt x="27449" y="141748"/>
                      <a:pt x="26532" y="143342"/>
                      <a:pt x="25810" y="145026"/>
                    </a:cubicBezTo>
                    <a:cubicBezTo>
                      <a:pt x="25300" y="146217"/>
                      <a:pt x="25497" y="147797"/>
                      <a:pt x="24581" y="148713"/>
                    </a:cubicBezTo>
                    <a:cubicBezTo>
                      <a:pt x="23665" y="149629"/>
                      <a:pt x="22123" y="149532"/>
                      <a:pt x="20894" y="149942"/>
                    </a:cubicBezTo>
                    <a:cubicBezTo>
                      <a:pt x="20075" y="151581"/>
                      <a:pt x="19609" y="153451"/>
                      <a:pt x="18436" y="154858"/>
                    </a:cubicBezTo>
                    <a:cubicBezTo>
                      <a:pt x="17490" y="155993"/>
                      <a:pt x="15931" y="156430"/>
                      <a:pt x="14749" y="157316"/>
                    </a:cubicBezTo>
                    <a:cubicBezTo>
                      <a:pt x="14286" y="157664"/>
                      <a:pt x="17412" y="145231"/>
                      <a:pt x="17207" y="145026"/>
                    </a:cubicBezTo>
                    <a:close/>
                  </a:path>
                </a:pathLst>
              </a:custGeom>
              <a:noFill/>
              <a:ln>
                <a:solidFill>
                  <a:srgbClr val="0000FF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>
                  <a:solidFill>
                    <a:schemeClr val="accent6"/>
                  </a:solidFill>
                </a:endParaRPr>
              </a:p>
            </p:txBody>
          </p:sp>
          <p:sp>
            <p:nvSpPr>
              <p:cNvPr id="115" name="任意多边形: 形状 114">
                <a:extLst>
                  <a:ext uri="{FF2B5EF4-FFF2-40B4-BE49-F238E27FC236}">
                    <a16:creationId xmlns:a16="http://schemas.microsoft.com/office/drawing/2014/main" id="{3D1FF686-BCB6-4C7E-A6EA-4417158DAF18}"/>
                  </a:ext>
                </a:extLst>
              </p:cNvPr>
              <p:cNvSpPr/>
              <p:nvPr/>
            </p:nvSpPr>
            <p:spPr>
              <a:xfrm>
                <a:off x="5351340" y="4543109"/>
                <a:ext cx="244692" cy="276533"/>
              </a:xfrm>
              <a:custGeom>
                <a:avLst/>
                <a:gdLst>
                  <a:gd name="connsiteX0" fmla="*/ 45589 w 244692"/>
                  <a:gd name="connsiteY0" fmla="*/ 14749 h 276533"/>
                  <a:gd name="connsiteX1" fmla="*/ 66483 w 244692"/>
                  <a:gd name="connsiteY1" fmla="*/ 13520 h 276533"/>
                  <a:gd name="connsiteX2" fmla="*/ 68941 w 244692"/>
                  <a:gd name="connsiteY2" fmla="*/ 8604 h 276533"/>
                  <a:gd name="connsiteX3" fmla="*/ 72628 w 244692"/>
                  <a:gd name="connsiteY3" fmla="*/ 6146 h 276533"/>
                  <a:gd name="connsiteX4" fmla="*/ 81231 w 244692"/>
                  <a:gd name="connsiteY4" fmla="*/ 3688 h 276533"/>
                  <a:gd name="connsiteX5" fmla="*/ 92292 w 244692"/>
                  <a:gd name="connsiteY5" fmla="*/ 0 h 276533"/>
                  <a:gd name="connsiteX6" fmla="*/ 152515 w 244692"/>
                  <a:gd name="connsiteY6" fmla="*/ 1229 h 276533"/>
                  <a:gd name="connsiteX7" fmla="*/ 169721 w 244692"/>
                  <a:gd name="connsiteY7" fmla="*/ 2459 h 276533"/>
                  <a:gd name="connsiteX8" fmla="*/ 177095 w 244692"/>
                  <a:gd name="connsiteY8" fmla="*/ 8604 h 276533"/>
                  <a:gd name="connsiteX9" fmla="*/ 183241 w 244692"/>
                  <a:gd name="connsiteY9" fmla="*/ 12291 h 276533"/>
                  <a:gd name="connsiteX10" fmla="*/ 188157 w 244692"/>
                  <a:gd name="connsiteY10" fmla="*/ 15978 h 276533"/>
                  <a:gd name="connsiteX11" fmla="*/ 193073 w 244692"/>
                  <a:gd name="connsiteY11" fmla="*/ 22123 h 276533"/>
                  <a:gd name="connsiteX12" fmla="*/ 197989 w 244692"/>
                  <a:gd name="connsiteY12" fmla="*/ 27039 h 276533"/>
                  <a:gd name="connsiteX13" fmla="*/ 200447 w 244692"/>
                  <a:gd name="connsiteY13" fmla="*/ 30726 h 276533"/>
                  <a:gd name="connsiteX14" fmla="*/ 207821 w 244692"/>
                  <a:gd name="connsiteY14" fmla="*/ 34413 h 276533"/>
                  <a:gd name="connsiteX15" fmla="*/ 210279 w 244692"/>
                  <a:gd name="connsiteY15" fmla="*/ 39329 h 276533"/>
                  <a:gd name="connsiteX16" fmla="*/ 217654 w 244692"/>
                  <a:gd name="connsiteY16" fmla="*/ 45475 h 276533"/>
                  <a:gd name="connsiteX17" fmla="*/ 221341 w 244692"/>
                  <a:gd name="connsiteY17" fmla="*/ 50391 h 276533"/>
                  <a:gd name="connsiteX18" fmla="*/ 225028 w 244692"/>
                  <a:gd name="connsiteY18" fmla="*/ 52849 h 276533"/>
                  <a:gd name="connsiteX19" fmla="*/ 228715 w 244692"/>
                  <a:gd name="connsiteY19" fmla="*/ 56536 h 276533"/>
                  <a:gd name="connsiteX20" fmla="*/ 229944 w 244692"/>
                  <a:gd name="connsiteY20" fmla="*/ 60223 h 276533"/>
                  <a:gd name="connsiteX21" fmla="*/ 233631 w 244692"/>
                  <a:gd name="connsiteY21" fmla="*/ 62681 h 276533"/>
                  <a:gd name="connsiteX22" fmla="*/ 238547 w 244692"/>
                  <a:gd name="connsiteY22" fmla="*/ 66368 h 276533"/>
                  <a:gd name="connsiteX23" fmla="*/ 242234 w 244692"/>
                  <a:gd name="connsiteY23" fmla="*/ 73742 h 276533"/>
                  <a:gd name="connsiteX24" fmla="*/ 244692 w 244692"/>
                  <a:gd name="connsiteY24" fmla="*/ 77429 h 276533"/>
                  <a:gd name="connsiteX25" fmla="*/ 243463 w 244692"/>
                  <a:gd name="connsiteY25" fmla="*/ 181897 h 276533"/>
                  <a:gd name="connsiteX26" fmla="*/ 239776 w 244692"/>
                  <a:gd name="connsiteY26" fmla="*/ 183126 h 276533"/>
                  <a:gd name="connsiteX27" fmla="*/ 237318 w 244692"/>
                  <a:gd name="connsiteY27" fmla="*/ 196646 h 276533"/>
                  <a:gd name="connsiteX28" fmla="*/ 234860 w 244692"/>
                  <a:gd name="connsiteY28" fmla="*/ 204020 h 276533"/>
                  <a:gd name="connsiteX29" fmla="*/ 233631 w 244692"/>
                  <a:gd name="connsiteY29" fmla="*/ 207707 h 276533"/>
                  <a:gd name="connsiteX30" fmla="*/ 232402 w 244692"/>
                  <a:gd name="connsiteY30" fmla="*/ 211394 h 276533"/>
                  <a:gd name="connsiteX31" fmla="*/ 231173 w 244692"/>
                  <a:gd name="connsiteY31" fmla="*/ 232288 h 276533"/>
                  <a:gd name="connsiteX32" fmla="*/ 229944 w 244692"/>
                  <a:gd name="connsiteY32" fmla="*/ 238433 h 276533"/>
                  <a:gd name="connsiteX33" fmla="*/ 226257 w 244692"/>
                  <a:gd name="connsiteY33" fmla="*/ 243349 h 276533"/>
                  <a:gd name="connsiteX34" fmla="*/ 221341 w 244692"/>
                  <a:gd name="connsiteY34" fmla="*/ 251952 h 276533"/>
                  <a:gd name="connsiteX35" fmla="*/ 216425 w 244692"/>
                  <a:gd name="connsiteY35" fmla="*/ 258097 h 276533"/>
                  <a:gd name="connsiteX36" fmla="*/ 206592 w 244692"/>
                  <a:gd name="connsiteY36" fmla="*/ 267929 h 276533"/>
                  <a:gd name="connsiteX37" fmla="*/ 201676 w 244692"/>
                  <a:gd name="connsiteY37" fmla="*/ 272846 h 276533"/>
                  <a:gd name="connsiteX38" fmla="*/ 151286 w 244692"/>
                  <a:gd name="connsiteY38" fmla="*/ 274075 h 276533"/>
                  <a:gd name="connsiteX39" fmla="*/ 116873 w 244692"/>
                  <a:gd name="connsiteY39" fmla="*/ 276533 h 276533"/>
                  <a:gd name="connsiteX40" fmla="*/ 56650 w 244692"/>
                  <a:gd name="connsiteY40" fmla="*/ 275304 h 276533"/>
                  <a:gd name="connsiteX41" fmla="*/ 51734 w 244692"/>
                  <a:gd name="connsiteY41" fmla="*/ 269159 h 276533"/>
                  <a:gd name="connsiteX42" fmla="*/ 49276 w 244692"/>
                  <a:gd name="connsiteY42" fmla="*/ 265471 h 276533"/>
                  <a:gd name="connsiteX43" fmla="*/ 45589 w 244692"/>
                  <a:gd name="connsiteY43" fmla="*/ 263013 h 276533"/>
                  <a:gd name="connsiteX44" fmla="*/ 41902 w 244692"/>
                  <a:gd name="connsiteY44" fmla="*/ 259326 h 276533"/>
                  <a:gd name="connsiteX45" fmla="*/ 33299 w 244692"/>
                  <a:gd name="connsiteY45" fmla="*/ 256868 h 276533"/>
                  <a:gd name="connsiteX46" fmla="*/ 29612 w 244692"/>
                  <a:gd name="connsiteY46" fmla="*/ 254410 h 276533"/>
                  <a:gd name="connsiteX47" fmla="*/ 22237 w 244692"/>
                  <a:gd name="connsiteY47" fmla="*/ 248265 h 276533"/>
                  <a:gd name="connsiteX48" fmla="*/ 18550 w 244692"/>
                  <a:gd name="connsiteY48" fmla="*/ 247036 h 276533"/>
                  <a:gd name="connsiteX49" fmla="*/ 12405 w 244692"/>
                  <a:gd name="connsiteY49" fmla="*/ 244578 h 276533"/>
                  <a:gd name="connsiteX50" fmla="*/ 7489 w 244692"/>
                  <a:gd name="connsiteY50" fmla="*/ 239662 h 276533"/>
                  <a:gd name="connsiteX51" fmla="*/ 2573 w 244692"/>
                  <a:gd name="connsiteY51" fmla="*/ 235975 h 276533"/>
                  <a:gd name="connsiteX52" fmla="*/ 115 w 244692"/>
                  <a:gd name="connsiteY52" fmla="*/ 228600 h 276533"/>
                  <a:gd name="connsiteX53" fmla="*/ 1344 w 244692"/>
                  <a:gd name="connsiteY53" fmla="*/ 210165 h 276533"/>
                  <a:gd name="connsiteX54" fmla="*/ 8718 w 244692"/>
                  <a:gd name="connsiteY54" fmla="*/ 207707 h 276533"/>
                  <a:gd name="connsiteX55" fmla="*/ 11176 w 244692"/>
                  <a:gd name="connsiteY55" fmla="*/ 197875 h 276533"/>
                  <a:gd name="connsiteX56" fmla="*/ 13634 w 244692"/>
                  <a:gd name="connsiteY56" fmla="*/ 194188 h 276533"/>
                  <a:gd name="connsiteX57" fmla="*/ 12405 w 244692"/>
                  <a:gd name="connsiteY57" fmla="*/ 126591 h 276533"/>
                  <a:gd name="connsiteX58" fmla="*/ 11176 w 244692"/>
                  <a:gd name="connsiteY58" fmla="*/ 119217 h 276533"/>
                  <a:gd name="connsiteX59" fmla="*/ 9947 w 244692"/>
                  <a:gd name="connsiteY59" fmla="*/ 115529 h 276533"/>
                  <a:gd name="connsiteX60" fmla="*/ 11176 w 244692"/>
                  <a:gd name="connsiteY60" fmla="*/ 66368 h 276533"/>
                  <a:gd name="connsiteX61" fmla="*/ 13634 w 244692"/>
                  <a:gd name="connsiteY61" fmla="*/ 57765 h 276533"/>
                  <a:gd name="connsiteX62" fmla="*/ 19779 w 244692"/>
                  <a:gd name="connsiteY62" fmla="*/ 46704 h 276533"/>
                  <a:gd name="connsiteX63" fmla="*/ 25925 w 244692"/>
                  <a:gd name="connsiteY63" fmla="*/ 40559 h 276533"/>
                  <a:gd name="connsiteX64" fmla="*/ 28383 w 244692"/>
                  <a:gd name="connsiteY64" fmla="*/ 33184 h 276533"/>
                  <a:gd name="connsiteX65" fmla="*/ 36986 w 244692"/>
                  <a:gd name="connsiteY65" fmla="*/ 27039 h 276533"/>
                  <a:gd name="connsiteX66" fmla="*/ 40673 w 244692"/>
                  <a:gd name="connsiteY66" fmla="*/ 24581 h 276533"/>
                  <a:gd name="connsiteX67" fmla="*/ 44360 w 244692"/>
                  <a:gd name="connsiteY67" fmla="*/ 23352 h 276533"/>
                  <a:gd name="connsiteX68" fmla="*/ 45589 w 244692"/>
                  <a:gd name="connsiteY68" fmla="*/ 14749 h 27653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</a:cxnLst>
                <a:rect l="l" t="t" r="r" b="b"/>
                <a:pathLst>
                  <a:path w="244692" h="276533">
                    <a:moveTo>
                      <a:pt x="45589" y="14749"/>
                    </a:moveTo>
                    <a:cubicBezTo>
                      <a:pt x="52554" y="14339"/>
                      <a:pt x="59736" y="15295"/>
                      <a:pt x="66483" y="13520"/>
                    </a:cubicBezTo>
                    <a:cubicBezTo>
                      <a:pt x="68255" y="13054"/>
                      <a:pt x="67768" y="10011"/>
                      <a:pt x="68941" y="8604"/>
                    </a:cubicBezTo>
                    <a:cubicBezTo>
                      <a:pt x="69887" y="7469"/>
                      <a:pt x="71257" y="6695"/>
                      <a:pt x="72628" y="6146"/>
                    </a:cubicBezTo>
                    <a:cubicBezTo>
                      <a:pt x="75397" y="5038"/>
                      <a:pt x="78384" y="4578"/>
                      <a:pt x="81231" y="3688"/>
                    </a:cubicBezTo>
                    <a:cubicBezTo>
                      <a:pt x="84941" y="2529"/>
                      <a:pt x="92292" y="0"/>
                      <a:pt x="92292" y="0"/>
                    </a:cubicBezTo>
                    <a:lnTo>
                      <a:pt x="152515" y="1229"/>
                    </a:lnTo>
                    <a:cubicBezTo>
                      <a:pt x="158262" y="1412"/>
                      <a:pt x="164059" y="1459"/>
                      <a:pt x="169721" y="2459"/>
                    </a:cubicBezTo>
                    <a:cubicBezTo>
                      <a:pt x="172220" y="2900"/>
                      <a:pt x="175463" y="7380"/>
                      <a:pt x="177095" y="8604"/>
                    </a:cubicBezTo>
                    <a:cubicBezTo>
                      <a:pt x="179006" y="10037"/>
                      <a:pt x="181253" y="10966"/>
                      <a:pt x="183241" y="12291"/>
                    </a:cubicBezTo>
                    <a:cubicBezTo>
                      <a:pt x="184945" y="13427"/>
                      <a:pt x="186518" y="14749"/>
                      <a:pt x="188157" y="15978"/>
                    </a:cubicBezTo>
                    <a:cubicBezTo>
                      <a:pt x="190225" y="22181"/>
                      <a:pt x="187885" y="17676"/>
                      <a:pt x="193073" y="22123"/>
                    </a:cubicBezTo>
                    <a:cubicBezTo>
                      <a:pt x="194833" y="23631"/>
                      <a:pt x="196481" y="25279"/>
                      <a:pt x="197989" y="27039"/>
                    </a:cubicBezTo>
                    <a:cubicBezTo>
                      <a:pt x="198950" y="28160"/>
                      <a:pt x="199403" y="29682"/>
                      <a:pt x="200447" y="30726"/>
                    </a:cubicBezTo>
                    <a:cubicBezTo>
                      <a:pt x="202829" y="33108"/>
                      <a:pt x="204822" y="33413"/>
                      <a:pt x="207821" y="34413"/>
                    </a:cubicBezTo>
                    <a:cubicBezTo>
                      <a:pt x="208640" y="36052"/>
                      <a:pt x="209263" y="37805"/>
                      <a:pt x="210279" y="39329"/>
                    </a:cubicBezTo>
                    <a:cubicBezTo>
                      <a:pt x="211935" y="41814"/>
                      <a:pt x="215787" y="43608"/>
                      <a:pt x="217654" y="45475"/>
                    </a:cubicBezTo>
                    <a:cubicBezTo>
                      <a:pt x="219102" y="46923"/>
                      <a:pt x="219893" y="48943"/>
                      <a:pt x="221341" y="50391"/>
                    </a:cubicBezTo>
                    <a:cubicBezTo>
                      <a:pt x="222385" y="51435"/>
                      <a:pt x="223893" y="51903"/>
                      <a:pt x="225028" y="52849"/>
                    </a:cubicBezTo>
                    <a:cubicBezTo>
                      <a:pt x="226363" y="53962"/>
                      <a:pt x="227486" y="55307"/>
                      <a:pt x="228715" y="56536"/>
                    </a:cubicBezTo>
                    <a:cubicBezTo>
                      <a:pt x="229125" y="57765"/>
                      <a:pt x="229135" y="59211"/>
                      <a:pt x="229944" y="60223"/>
                    </a:cubicBezTo>
                    <a:cubicBezTo>
                      <a:pt x="230867" y="61376"/>
                      <a:pt x="232429" y="61822"/>
                      <a:pt x="233631" y="62681"/>
                    </a:cubicBezTo>
                    <a:cubicBezTo>
                      <a:pt x="235298" y="63872"/>
                      <a:pt x="237099" y="64920"/>
                      <a:pt x="238547" y="66368"/>
                    </a:cubicBezTo>
                    <a:cubicBezTo>
                      <a:pt x="242069" y="69890"/>
                      <a:pt x="240235" y="69744"/>
                      <a:pt x="242234" y="73742"/>
                    </a:cubicBezTo>
                    <a:cubicBezTo>
                      <a:pt x="242895" y="75063"/>
                      <a:pt x="243873" y="76200"/>
                      <a:pt x="244692" y="77429"/>
                    </a:cubicBezTo>
                    <a:cubicBezTo>
                      <a:pt x="244282" y="112252"/>
                      <a:pt x="245081" y="147110"/>
                      <a:pt x="243463" y="181897"/>
                    </a:cubicBezTo>
                    <a:cubicBezTo>
                      <a:pt x="243403" y="183191"/>
                      <a:pt x="240274" y="181930"/>
                      <a:pt x="239776" y="183126"/>
                    </a:cubicBezTo>
                    <a:cubicBezTo>
                      <a:pt x="238014" y="187354"/>
                      <a:pt x="238367" y="192187"/>
                      <a:pt x="237318" y="196646"/>
                    </a:cubicBezTo>
                    <a:cubicBezTo>
                      <a:pt x="236725" y="199168"/>
                      <a:pt x="235679" y="201562"/>
                      <a:pt x="234860" y="204020"/>
                    </a:cubicBezTo>
                    <a:lnTo>
                      <a:pt x="233631" y="207707"/>
                    </a:lnTo>
                    <a:lnTo>
                      <a:pt x="232402" y="211394"/>
                    </a:lnTo>
                    <a:cubicBezTo>
                      <a:pt x="231992" y="218359"/>
                      <a:pt x="231805" y="225340"/>
                      <a:pt x="231173" y="232288"/>
                    </a:cubicBezTo>
                    <a:cubicBezTo>
                      <a:pt x="230984" y="234368"/>
                      <a:pt x="230792" y="236524"/>
                      <a:pt x="229944" y="238433"/>
                    </a:cubicBezTo>
                    <a:cubicBezTo>
                      <a:pt x="229112" y="240305"/>
                      <a:pt x="227486" y="241710"/>
                      <a:pt x="226257" y="243349"/>
                    </a:cubicBezTo>
                    <a:cubicBezTo>
                      <a:pt x="223439" y="251803"/>
                      <a:pt x="227293" y="241535"/>
                      <a:pt x="221341" y="251952"/>
                    </a:cubicBezTo>
                    <a:cubicBezTo>
                      <a:pt x="217688" y="258345"/>
                      <a:pt x="223421" y="253433"/>
                      <a:pt x="216425" y="258097"/>
                    </a:cubicBezTo>
                    <a:cubicBezTo>
                      <a:pt x="210492" y="266995"/>
                      <a:pt x="214150" y="264150"/>
                      <a:pt x="206592" y="267929"/>
                    </a:cubicBezTo>
                    <a:cubicBezTo>
                      <a:pt x="205432" y="271409"/>
                      <a:pt x="206113" y="272644"/>
                      <a:pt x="201676" y="272846"/>
                    </a:cubicBezTo>
                    <a:cubicBezTo>
                      <a:pt x="184892" y="273609"/>
                      <a:pt x="168083" y="273665"/>
                      <a:pt x="151286" y="274075"/>
                    </a:cubicBezTo>
                    <a:cubicBezTo>
                      <a:pt x="141484" y="274966"/>
                      <a:pt x="125840" y="276533"/>
                      <a:pt x="116873" y="276533"/>
                    </a:cubicBezTo>
                    <a:cubicBezTo>
                      <a:pt x="96794" y="276533"/>
                      <a:pt x="76724" y="275714"/>
                      <a:pt x="56650" y="275304"/>
                    </a:cubicBezTo>
                    <a:cubicBezTo>
                      <a:pt x="54101" y="265107"/>
                      <a:pt x="57795" y="274009"/>
                      <a:pt x="51734" y="269159"/>
                    </a:cubicBezTo>
                    <a:cubicBezTo>
                      <a:pt x="50580" y="268236"/>
                      <a:pt x="50321" y="266516"/>
                      <a:pt x="49276" y="265471"/>
                    </a:cubicBezTo>
                    <a:cubicBezTo>
                      <a:pt x="48232" y="264426"/>
                      <a:pt x="46724" y="263959"/>
                      <a:pt x="45589" y="263013"/>
                    </a:cubicBezTo>
                    <a:cubicBezTo>
                      <a:pt x="44254" y="261900"/>
                      <a:pt x="43348" y="260290"/>
                      <a:pt x="41902" y="259326"/>
                    </a:cubicBezTo>
                    <a:cubicBezTo>
                      <a:pt x="40844" y="258621"/>
                      <a:pt x="33955" y="257032"/>
                      <a:pt x="33299" y="256868"/>
                    </a:cubicBezTo>
                    <a:cubicBezTo>
                      <a:pt x="32070" y="256049"/>
                      <a:pt x="30747" y="255356"/>
                      <a:pt x="29612" y="254410"/>
                    </a:cubicBezTo>
                    <a:cubicBezTo>
                      <a:pt x="25533" y="251010"/>
                      <a:pt x="26817" y="250555"/>
                      <a:pt x="22237" y="248265"/>
                    </a:cubicBezTo>
                    <a:cubicBezTo>
                      <a:pt x="21078" y="247686"/>
                      <a:pt x="19763" y="247491"/>
                      <a:pt x="18550" y="247036"/>
                    </a:cubicBezTo>
                    <a:cubicBezTo>
                      <a:pt x="16484" y="246261"/>
                      <a:pt x="14453" y="245397"/>
                      <a:pt x="12405" y="244578"/>
                    </a:cubicBezTo>
                    <a:cubicBezTo>
                      <a:pt x="10766" y="242939"/>
                      <a:pt x="9233" y="241188"/>
                      <a:pt x="7489" y="239662"/>
                    </a:cubicBezTo>
                    <a:cubicBezTo>
                      <a:pt x="5947" y="238313"/>
                      <a:pt x="3709" y="237679"/>
                      <a:pt x="2573" y="235975"/>
                    </a:cubicBezTo>
                    <a:cubicBezTo>
                      <a:pt x="1136" y="233819"/>
                      <a:pt x="115" y="228600"/>
                      <a:pt x="115" y="228600"/>
                    </a:cubicBezTo>
                    <a:cubicBezTo>
                      <a:pt x="525" y="222455"/>
                      <a:pt x="-1001" y="215860"/>
                      <a:pt x="1344" y="210165"/>
                    </a:cubicBezTo>
                    <a:cubicBezTo>
                      <a:pt x="2331" y="207769"/>
                      <a:pt x="8718" y="207707"/>
                      <a:pt x="8718" y="207707"/>
                    </a:cubicBezTo>
                    <a:cubicBezTo>
                      <a:pt x="9185" y="205370"/>
                      <a:pt x="9916" y="200394"/>
                      <a:pt x="11176" y="197875"/>
                    </a:cubicBezTo>
                    <a:cubicBezTo>
                      <a:pt x="11837" y="196554"/>
                      <a:pt x="12815" y="195417"/>
                      <a:pt x="13634" y="194188"/>
                    </a:cubicBezTo>
                    <a:cubicBezTo>
                      <a:pt x="13224" y="171656"/>
                      <a:pt x="13143" y="149115"/>
                      <a:pt x="12405" y="126591"/>
                    </a:cubicBezTo>
                    <a:cubicBezTo>
                      <a:pt x="12323" y="124100"/>
                      <a:pt x="11717" y="121650"/>
                      <a:pt x="11176" y="119217"/>
                    </a:cubicBezTo>
                    <a:cubicBezTo>
                      <a:pt x="10895" y="117952"/>
                      <a:pt x="10357" y="116758"/>
                      <a:pt x="9947" y="115529"/>
                    </a:cubicBezTo>
                    <a:cubicBezTo>
                      <a:pt x="10357" y="99142"/>
                      <a:pt x="10132" y="82727"/>
                      <a:pt x="11176" y="66368"/>
                    </a:cubicBezTo>
                    <a:cubicBezTo>
                      <a:pt x="11366" y="63392"/>
                      <a:pt x="12777" y="60622"/>
                      <a:pt x="13634" y="57765"/>
                    </a:cubicBezTo>
                    <a:cubicBezTo>
                      <a:pt x="14959" y="53350"/>
                      <a:pt x="16057" y="50426"/>
                      <a:pt x="19779" y="46704"/>
                    </a:cubicBezTo>
                    <a:lnTo>
                      <a:pt x="25925" y="40559"/>
                    </a:lnTo>
                    <a:cubicBezTo>
                      <a:pt x="26744" y="38101"/>
                      <a:pt x="26227" y="34621"/>
                      <a:pt x="28383" y="33184"/>
                    </a:cubicBezTo>
                    <a:cubicBezTo>
                      <a:pt x="37072" y="27391"/>
                      <a:pt x="26315" y="34661"/>
                      <a:pt x="36986" y="27039"/>
                    </a:cubicBezTo>
                    <a:cubicBezTo>
                      <a:pt x="38188" y="26180"/>
                      <a:pt x="39352" y="25242"/>
                      <a:pt x="40673" y="24581"/>
                    </a:cubicBezTo>
                    <a:cubicBezTo>
                      <a:pt x="41832" y="24002"/>
                      <a:pt x="43131" y="23762"/>
                      <a:pt x="44360" y="23352"/>
                    </a:cubicBezTo>
                    <a:lnTo>
                      <a:pt x="45589" y="14749"/>
                    </a:lnTo>
                    <a:close/>
                  </a:path>
                </a:pathLst>
              </a:custGeom>
              <a:noFill/>
              <a:ln w="9525">
                <a:solidFill>
                  <a:srgbClr val="FF0000"/>
                </a:solidFill>
                <a:prstDash val="soli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108" name="文本框 107">
              <a:extLst>
                <a:ext uri="{FF2B5EF4-FFF2-40B4-BE49-F238E27FC236}">
                  <a16:creationId xmlns:a16="http://schemas.microsoft.com/office/drawing/2014/main" id="{E8709220-7345-4800-897B-A58C6D7AD128}"/>
                </a:ext>
              </a:extLst>
            </p:cNvPr>
            <p:cNvSpPr txBox="1"/>
            <p:nvPr/>
          </p:nvSpPr>
          <p:spPr>
            <a:xfrm>
              <a:off x="78414" y="2374310"/>
              <a:ext cx="129465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     Core</a:t>
              </a:r>
            </a:p>
            <a:p>
              <a:r>
                <a:rPr lang="en-US" altLang="zh-CN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zh-CN" sz="1000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d</a:t>
              </a:r>
              <a:r>
                <a:rPr lang="en-US" altLang="zh-CN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,Fluorescein+)</a:t>
              </a:r>
              <a:endParaRPr lang="zh-CN" alt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文本框 108">
              <a:extLst>
                <a:ext uri="{FF2B5EF4-FFF2-40B4-BE49-F238E27FC236}">
                  <a16:creationId xmlns:a16="http://schemas.microsoft.com/office/drawing/2014/main" id="{8CEB9157-CBD9-41EE-A2A3-40AA1159F3E1}"/>
                </a:ext>
              </a:extLst>
            </p:cNvPr>
            <p:cNvSpPr txBox="1"/>
            <p:nvPr/>
          </p:nvSpPr>
          <p:spPr>
            <a:xfrm>
              <a:off x="1307890" y="2391911"/>
              <a:ext cx="1842175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           Edge</a:t>
              </a:r>
            </a:p>
            <a:p>
              <a:r>
                <a:rPr lang="en-US" altLang="zh-CN" sz="1000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Gd-,Fluorescein-,T2FLAIR +)</a:t>
              </a:r>
              <a:endParaRPr lang="zh-CN" altLang="en-US" sz="10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0" name="直接箭头连接符 109">
              <a:extLst>
                <a:ext uri="{FF2B5EF4-FFF2-40B4-BE49-F238E27FC236}">
                  <a16:creationId xmlns:a16="http://schemas.microsoft.com/office/drawing/2014/main" id="{0EB14A7D-4009-4C49-BBE3-7620CDA019B3}"/>
                </a:ext>
              </a:extLst>
            </p:cNvPr>
            <p:cNvCxnSpPr>
              <a:cxnSpLocks/>
            </p:cNvCxnSpPr>
            <p:nvPr/>
          </p:nvCxnSpPr>
          <p:spPr>
            <a:xfrm>
              <a:off x="1948314" y="2177963"/>
              <a:ext cx="211874" cy="270796"/>
            </a:xfrm>
            <a:prstGeom prst="straightConnector1">
              <a:avLst/>
            </a:prstGeom>
            <a:ln>
              <a:solidFill>
                <a:srgbClr val="0000FF"/>
              </a:solidFill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11" name="文本框 110">
              <a:extLst>
                <a:ext uri="{FF2B5EF4-FFF2-40B4-BE49-F238E27FC236}">
                  <a16:creationId xmlns:a16="http://schemas.microsoft.com/office/drawing/2014/main" id="{29C0B3E2-6FDB-4C42-86DE-587C552991C1}"/>
                </a:ext>
              </a:extLst>
            </p:cNvPr>
            <p:cNvSpPr txBox="1"/>
            <p:nvPr/>
          </p:nvSpPr>
          <p:spPr>
            <a:xfrm>
              <a:off x="349859" y="1010770"/>
              <a:ext cx="8934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 MRI T1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Gd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文本框 111">
              <a:extLst>
                <a:ext uri="{FF2B5EF4-FFF2-40B4-BE49-F238E27FC236}">
                  <a16:creationId xmlns:a16="http://schemas.microsoft.com/office/drawing/2014/main" id="{3F045BC7-90B3-4631-9782-812982CDBBD0}"/>
                </a:ext>
              </a:extLst>
            </p:cNvPr>
            <p:cNvSpPr txBox="1"/>
            <p:nvPr/>
          </p:nvSpPr>
          <p:spPr>
            <a:xfrm>
              <a:off x="1527974" y="1014547"/>
              <a:ext cx="105255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 MRI T2 FLAIR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1698949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副标题 2">
            <a:extLst>
              <a:ext uri="{FF2B5EF4-FFF2-40B4-BE49-F238E27FC236}">
                <a16:creationId xmlns:a16="http://schemas.microsoft.com/office/drawing/2014/main" id="{EB2174D6-24C4-4803-9905-052F009EE6D2}"/>
              </a:ext>
            </a:extLst>
          </p:cNvPr>
          <p:cNvSpPr txBox="1">
            <a:spLocks/>
          </p:cNvSpPr>
          <p:nvPr/>
        </p:nvSpPr>
        <p:spPr>
          <a:xfrm>
            <a:off x="110677" y="326773"/>
            <a:ext cx="3014695" cy="72144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.2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3" name="表格 52">
            <a:extLst>
              <a:ext uri="{FF2B5EF4-FFF2-40B4-BE49-F238E27FC236}">
                <a16:creationId xmlns:a16="http://schemas.microsoft.com/office/drawing/2014/main" id="{B1D24584-4B95-4267-A5A8-29FDD5C4998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90151881"/>
              </p:ext>
            </p:extLst>
          </p:nvPr>
        </p:nvGraphicFramePr>
        <p:xfrm>
          <a:off x="246761" y="1332026"/>
          <a:ext cx="249337" cy="2860754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249337">
                  <a:extLst>
                    <a:ext uri="{9D8B030D-6E8A-4147-A177-3AD203B41FA5}">
                      <a16:colId xmlns:a16="http://schemas.microsoft.com/office/drawing/2014/main" val="2943570845"/>
                    </a:ext>
                  </a:extLst>
                </a:gridCol>
              </a:tblGrid>
              <a:tr h="15056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4</a:t>
                      </a:r>
                      <a:endParaRPr lang="en-US" altLang="zh-CN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782948695"/>
                  </a:ext>
                </a:extLst>
              </a:tr>
              <a:tr h="15056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6</a:t>
                      </a:r>
                      <a:endParaRPr lang="en-US" altLang="zh-C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4070249538"/>
                  </a:ext>
                </a:extLst>
              </a:tr>
              <a:tr h="15056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2</a:t>
                      </a:r>
                      <a:endParaRPr lang="en-US" altLang="zh-C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2282367142"/>
                  </a:ext>
                </a:extLst>
              </a:tr>
              <a:tr h="15056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6</a:t>
                      </a:r>
                      <a:endParaRPr lang="en-US" altLang="zh-CN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2640286493"/>
                  </a:ext>
                </a:extLst>
              </a:tr>
              <a:tr h="15056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7</a:t>
                      </a:r>
                      <a:endParaRPr lang="en-US" altLang="zh-CN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3408486502"/>
                  </a:ext>
                </a:extLst>
              </a:tr>
              <a:tr h="15056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0</a:t>
                      </a:r>
                      <a:endParaRPr lang="en-US" altLang="zh-CN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4245607528"/>
                  </a:ext>
                </a:extLst>
              </a:tr>
              <a:tr h="15056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7</a:t>
                      </a:r>
                      <a:endParaRPr lang="en-US" altLang="zh-C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4010419790"/>
                  </a:ext>
                </a:extLst>
              </a:tr>
              <a:tr h="15056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4</a:t>
                      </a:r>
                      <a:endParaRPr lang="en-US" altLang="zh-CN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3640393576"/>
                  </a:ext>
                </a:extLst>
              </a:tr>
              <a:tr h="15056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3</a:t>
                      </a:r>
                      <a:endParaRPr lang="en-US" altLang="zh-C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3391218190"/>
                  </a:ext>
                </a:extLst>
              </a:tr>
              <a:tr h="15056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6</a:t>
                      </a:r>
                      <a:endParaRPr lang="en-US" altLang="zh-CN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543855123"/>
                  </a:ext>
                </a:extLst>
              </a:tr>
              <a:tr h="15056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</a:t>
                      </a:r>
                      <a:endParaRPr lang="en-US" altLang="zh-C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154916669"/>
                  </a:ext>
                </a:extLst>
              </a:tr>
              <a:tr h="15056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4</a:t>
                      </a:r>
                      <a:endParaRPr lang="en-US" altLang="zh-C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2904796821"/>
                  </a:ext>
                </a:extLst>
              </a:tr>
              <a:tr h="1505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a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998114638"/>
                  </a:ext>
                </a:extLst>
              </a:tr>
              <a:tr h="1505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144117445"/>
                  </a:ext>
                </a:extLst>
              </a:tr>
              <a:tr h="15056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0</a:t>
                      </a:r>
                      <a:endParaRPr lang="en-US" altLang="zh-C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929880447"/>
                  </a:ext>
                </a:extLst>
              </a:tr>
              <a:tr h="15056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5</a:t>
                      </a:r>
                      <a:endParaRPr lang="en-US" altLang="zh-C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4107861968"/>
                  </a:ext>
                </a:extLst>
              </a:tr>
              <a:tr h="15056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3</a:t>
                      </a:r>
                      <a:endParaRPr lang="en-US" altLang="zh-C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921414446"/>
                  </a:ext>
                </a:extLst>
              </a:tr>
              <a:tr h="15056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8</a:t>
                      </a:r>
                      <a:endParaRPr lang="en-US" altLang="zh-C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3952975943"/>
                  </a:ext>
                </a:extLst>
              </a:tr>
              <a:tr h="1505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k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583760494"/>
                  </a:ext>
                </a:extLst>
              </a:tr>
            </a:tbl>
          </a:graphicData>
        </a:graphic>
      </p:graphicFrame>
      <p:grpSp>
        <p:nvGrpSpPr>
          <p:cNvPr id="84" name="组合 83">
            <a:extLst>
              <a:ext uri="{FF2B5EF4-FFF2-40B4-BE49-F238E27FC236}">
                <a16:creationId xmlns:a16="http://schemas.microsoft.com/office/drawing/2014/main" id="{3377D965-F2FA-42B9-A0A0-CBD66B71D669}"/>
              </a:ext>
            </a:extLst>
          </p:cNvPr>
          <p:cNvGrpSpPr>
            <a:grpSpLocks noChangeAspect="1"/>
          </p:cNvGrpSpPr>
          <p:nvPr/>
        </p:nvGrpSpPr>
        <p:grpSpPr>
          <a:xfrm>
            <a:off x="460217" y="1048221"/>
            <a:ext cx="2904489" cy="3420000"/>
            <a:chOff x="830972" y="1078601"/>
            <a:chExt cx="2253337" cy="2653277"/>
          </a:xfrm>
        </p:grpSpPr>
        <p:grpSp>
          <p:nvGrpSpPr>
            <p:cNvPr id="85" name="组合 84">
              <a:extLst>
                <a:ext uri="{FF2B5EF4-FFF2-40B4-BE49-F238E27FC236}">
                  <a16:creationId xmlns:a16="http://schemas.microsoft.com/office/drawing/2014/main" id="{05584E6B-D8E6-4572-96CD-899A42CF731D}"/>
                </a:ext>
              </a:extLst>
            </p:cNvPr>
            <p:cNvGrpSpPr/>
            <p:nvPr/>
          </p:nvGrpSpPr>
          <p:grpSpPr>
            <a:xfrm>
              <a:off x="830972" y="1078601"/>
              <a:ext cx="2253337" cy="2653277"/>
              <a:chOff x="830972" y="1078601"/>
              <a:chExt cx="2253337" cy="2653277"/>
            </a:xfrm>
          </p:grpSpPr>
          <p:grpSp>
            <p:nvGrpSpPr>
              <p:cNvPr id="87" name="组合 86">
                <a:extLst>
                  <a:ext uri="{FF2B5EF4-FFF2-40B4-BE49-F238E27FC236}">
                    <a16:creationId xmlns:a16="http://schemas.microsoft.com/office/drawing/2014/main" id="{D4043A0F-8D28-4088-99B2-AC6A35D6663D}"/>
                  </a:ext>
                </a:extLst>
              </p:cNvPr>
              <p:cNvGrpSpPr/>
              <p:nvPr/>
            </p:nvGrpSpPr>
            <p:grpSpPr>
              <a:xfrm>
                <a:off x="830972" y="1078601"/>
                <a:ext cx="1831883" cy="2653277"/>
                <a:chOff x="1102090" y="5822532"/>
                <a:chExt cx="2282901" cy="3079637"/>
              </a:xfrm>
            </p:grpSpPr>
            <p:sp>
              <p:nvSpPr>
                <p:cNvPr id="94" name="文本框 93">
                  <a:extLst>
                    <a:ext uri="{FF2B5EF4-FFF2-40B4-BE49-F238E27FC236}">
                      <a16:creationId xmlns:a16="http://schemas.microsoft.com/office/drawing/2014/main" id="{1F036587-D6B7-43A6-8E76-2D04870680EC}"/>
                    </a:ext>
                  </a:extLst>
                </p:cNvPr>
                <p:cNvSpPr txBox="1"/>
                <p:nvPr/>
              </p:nvSpPr>
              <p:spPr>
                <a:xfrm>
                  <a:off x="2368426" y="5822532"/>
                  <a:ext cx="882515" cy="2857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133	</a:t>
                  </a:r>
                  <a:endParaRPr lang="zh-CN" alt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95" name="组合 94">
                  <a:extLst>
                    <a:ext uri="{FF2B5EF4-FFF2-40B4-BE49-F238E27FC236}">
                      <a16:creationId xmlns:a16="http://schemas.microsoft.com/office/drawing/2014/main" id="{8814420A-97B9-44A3-B166-36D4D48F01BF}"/>
                    </a:ext>
                  </a:extLst>
                </p:cNvPr>
                <p:cNvGrpSpPr/>
                <p:nvPr/>
              </p:nvGrpSpPr>
              <p:grpSpPr>
                <a:xfrm>
                  <a:off x="1102090" y="5822532"/>
                  <a:ext cx="1199993" cy="3063110"/>
                  <a:chOff x="1102090" y="5822532"/>
                  <a:chExt cx="1199993" cy="3063110"/>
                </a:xfrm>
              </p:grpSpPr>
              <p:sp>
                <p:nvSpPr>
                  <p:cNvPr id="98" name="文本框 97">
                    <a:extLst>
                      <a:ext uri="{FF2B5EF4-FFF2-40B4-BE49-F238E27FC236}">
                        <a16:creationId xmlns:a16="http://schemas.microsoft.com/office/drawing/2014/main" id="{5E633BAB-F79A-4F87-B498-EA91199E3C08}"/>
                      </a:ext>
                    </a:extLst>
                  </p:cNvPr>
                  <p:cNvSpPr txBox="1"/>
                  <p:nvPr/>
                </p:nvSpPr>
                <p:spPr>
                  <a:xfrm>
                    <a:off x="1269033" y="5822532"/>
                    <a:ext cx="839875" cy="28578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D109	</a:t>
                    </a:r>
                    <a:endParaRPr lang="zh-CN" alt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9" name="文本框 98">
                    <a:extLst>
                      <a:ext uri="{FF2B5EF4-FFF2-40B4-BE49-F238E27FC236}">
                        <a16:creationId xmlns:a16="http://schemas.microsoft.com/office/drawing/2014/main" id="{33E6183A-F56C-494B-AA77-6DCA24F97D7A}"/>
                      </a:ext>
                    </a:extLst>
                  </p:cNvPr>
                  <p:cNvSpPr txBox="1"/>
                  <p:nvPr/>
                </p:nvSpPr>
                <p:spPr>
                  <a:xfrm>
                    <a:off x="1102090" y="8592596"/>
                    <a:ext cx="708162" cy="28578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re</a:t>
                    </a:r>
                    <a:endParaRPr lang="zh-CN" altLang="en-U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00" name="文本框 99">
                    <a:extLst>
                      <a:ext uri="{FF2B5EF4-FFF2-40B4-BE49-F238E27FC236}">
                        <a16:creationId xmlns:a16="http://schemas.microsoft.com/office/drawing/2014/main" id="{76BD3759-68B8-420C-8D52-F29A88E31D5A}"/>
                      </a:ext>
                    </a:extLst>
                  </p:cNvPr>
                  <p:cNvSpPr txBox="1"/>
                  <p:nvPr/>
                </p:nvSpPr>
                <p:spPr>
                  <a:xfrm>
                    <a:off x="1593921" y="8599855"/>
                    <a:ext cx="708162" cy="28578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dge</a:t>
                    </a:r>
                    <a:endParaRPr lang="zh-CN" altLang="en-U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96" name="文本框 95">
                  <a:extLst>
                    <a:ext uri="{FF2B5EF4-FFF2-40B4-BE49-F238E27FC236}">
                      <a16:creationId xmlns:a16="http://schemas.microsoft.com/office/drawing/2014/main" id="{8307F409-1872-4EF7-9B1A-7E277547FB76}"/>
                    </a:ext>
                  </a:extLst>
                </p:cNvPr>
                <p:cNvSpPr txBox="1"/>
                <p:nvPr/>
              </p:nvSpPr>
              <p:spPr>
                <a:xfrm>
                  <a:off x="2154348" y="8608578"/>
                  <a:ext cx="708162" cy="2857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re</a:t>
                  </a:r>
                  <a:endParaRPr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7" name="文本框 96">
                  <a:extLst>
                    <a:ext uri="{FF2B5EF4-FFF2-40B4-BE49-F238E27FC236}">
                      <a16:creationId xmlns:a16="http://schemas.microsoft.com/office/drawing/2014/main" id="{23AC55F6-1013-4779-A0F1-CEE3D374E1EC}"/>
                    </a:ext>
                  </a:extLst>
                </p:cNvPr>
                <p:cNvSpPr txBox="1"/>
                <p:nvPr/>
              </p:nvSpPr>
              <p:spPr>
                <a:xfrm>
                  <a:off x="2676829" y="8616382"/>
                  <a:ext cx="708162" cy="2857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dge</a:t>
                  </a:r>
                  <a:endParaRPr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88" name="图片 87">
                <a:extLst>
                  <a:ext uri="{FF2B5EF4-FFF2-40B4-BE49-F238E27FC236}">
                    <a16:creationId xmlns:a16="http://schemas.microsoft.com/office/drawing/2014/main" id="{23D3E9EF-D86A-4F21-8F92-3FCC8E8311A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846200" y="1298164"/>
                <a:ext cx="853737" cy="2221274"/>
              </a:xfrm>
              <a:prstGeom prst="rect">
                <a:avLst/>
              </a:prstGeom>
            </p:spPr>
          </p:pic>
          <p:pic>
            <p:nvPicPr>
              <p:cNvPr id="89" name="图片 88">
                <a:extLst>
                  <a:ext uri="{FF2B5EF4-FFF2-40B4-BE49-F238E27FC236}">
                    <a16:creationId xmlns:a16="http://schemas.microsoft.com/office/drawing/2014/main" id="{9EC9325A-DCE4-4428-992F-214628F3078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2566305" y="1305002"/>
                <a:ext cx="215723" cy="1247794"/>
              </a:xfrm>
              <a:prstGeom prst="rect">
                <a:avLst/>
              </a:prstGeom>
            </p:spPr>
          </p:pic>
          <p:sp>
            <p:nvSpPr>
              <p:cNvPr id="90" name="文本框 89">
                <a:extLst>
                  <a:ext uri="{FF2B5EF4-FFF2-40B4-BE49-F238E27FC236}">
                    <a16:creationId xmlns:a16="http://schemas.microsoft.com/office/drawing/2014/main" id="{16BD5832-F672-43FF-8708-AB3A8B6D55F9}"/>
                  </a:ext>
                </a:extLst>
              </p:cNvPr>
              <p:cNvSpPr txBox="1"/>
              <p:nvPr/>
            </p:nvSpPr>
            <p:spPr>
              <a:xfrm>
                <a:off x="2745755" y="1396145"/>
                <a:ext cx="27087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文本框 90">
                <a:extLst>
                  <a:ext uri="{FF2B5EF4-FFF2-40B4-BE49-F238E27FC236}">
                    <a16:creationId xmlns:a16="http://schemas.microsoft.com/office/drawing/2014/main" id="{D945483B-0578-42E0-9987-C6AF9EC2F637}"/>
                  </a:ext>
                </a:extLst>
              </p:cNvPr>
              <p:cNvSpPr txBox="1"/>
              <p:nvPr/>
            </p:nvSpPr>
            <p:spPr>
              <a:xfrm>
                <a:off x="2710591" y="2213504"/>
                <a:ext cx="34120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2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文本框 91">
                <a:extLst>
                  <a:ext uri="{FF2B5EF4-FFF2-40B4-BE49-F238E27FC236}">
                    <a16:creationId xmlns:a16="http://schemas.microsoft.com/office/drawing/2014/main" id="{A6B9A501-D0BE-45B9-8B67-3A388F5D8304}"/>
                  </a:ext>
                </a:extLst>
              </p:cNvPr>
              <p:cNvSpPr txBox="1"/>
              <p:nvPr/>
            </p:nvSpPr>
            <p:spPr>
              <a:xfrm>
                <a:off x="2745755" y="1810220"/>
                <a:ext cx="27087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文本框 92">
                <a:extLst>
                  <a:ext uri="{FF2B5EF4-FFF2-40B4-BE49-F238E27FC236}">
                    <a16:creationId xmlns:a16="http://schemas.microsoft.com/office/drawing/2014/main" id="{EA52458C-36BC-472F-B36A-8B727CCADED7}"/>
                  </a:ext>
                </a:extLst>
              </p:cNvPr>
              <p:cNvSpPr txBox="1"/>
              <p:nvPr/>
            </p:nvSpPr>
            <p:spPr>
              <a:xfrm>
                <a:off x="2745755" y="1492739"/>
                <a:ext cx="338554" cy="1187733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Log2 Fold Change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86" name="图片 85">
              <a:extLst>
                <a:ext uri="{FF2B5EF4-FFF2-40B4-BE49-F238E27FC236}">
                  <a16:creationId xmlns:a16="http://schemas.microsoft.com/office/drawing/2014/main" id="{7B898363-62D6-457C-8025-9AA8A8EA1BA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707727" y="1291038"/>
              <a:ext cx="846192" cy="22248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4923736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副标题 2">
            <a:extLst>
              <a:ext uri="{FF2B5EF4-FFF2-40B4-BE49-F238E27FC236}">
                <a16:creationId xmlns:a16="http://schemas.microsoft.com/office/drawing/2014/main" id="{F2DF7397-CAA3-41AE-896C-A7A7BFE31EDB}"/>
              </a:ext>
            </a:extLst>
          </p:cNvPr>
          <p:cNvSpPr txBox="1">
            <a:spLocks/>
          </p:cNvSpPr>
          <p:nvPr/>
        </p:nvSpPr>
        <p:spPr>
          <a:xfrm>
            <a:off x="169018" y="152952"/>
            <a:ext cx="3259982" cy="46750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.3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C7D5504E-2546-4192-B686-E144EC9C9DA6}"/>
              </a:ext>
            </a:extLst>
          </p:cNvPr>
          <p:cNvSpPr txBox="1"/>
          <p:nvPr/>
        </p:nvSpPr>
        <p:spPr>
          <a:xfrm>
            <a:off x="169018" y="1142490"/>
            <a:ext cx="46217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A</a:t>
            </a:r>
          </a:p>
        </p:txBody>
      </p:sp>
      <p:sp>
        <p:nvSpPr>
          <p:cNvPr id="64" name="矩形 63">
            <a:extLst>
              <a:ext uri="{FF2B5EF4-FFF2-40B4-BE49-F238E27FC236}">
                <a16:creationId xmlns:a16="http://schemas.microsoft.com/office/drawing/2014/main" id="{B5DAB745-E19A-48D8-9741-CE82D07430B1}"/>
              </a:ext>
            </a:extLst>
          </p:cNvPr>
          <p:cNvSpPr/>
          <p:nvPr/>
        </p:nvSpPr>
        <p:spPr>
          <a:xfrm>
            <a:off x="85377" y="3437337"/>
            <a:ext cx="2696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48044CE1-4E18-4A57-9D1F-84AC6FE0B532}"/>
              </a:ext>
            </a:extLst>
          </p:cNvPr>
          <p:cNvSpPr txBox="1"/>
          <p:nvPr/>
        </p:nvSpPr>
        <p:spPr>
          <a:xfrm>
            <a:off x="2001203" y="5467598"/>
            <a:ext cx="7580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altLang="zh-CN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6" name="组合 65">
            <a:extLst>
              <a:ext uri="{FF2B5EF4-FFF2-40B4-BE49-F238E27FC236}">
                <a16:creationId xmlns:a16="http://schemas.microsoft.com/office/drawing/2014/main" id="{814A81FD-B77C-4C28-9B3C-BC2E66FDE5F7}"/>
              </a:ext>
            </a:extLst>
          </p:cNvPr>
          <p:cNvGrpSpPr/>
          <p:nvPr/>
        </p:nvGrpSpPr>
        <p:grpSpPr>
          <a:xfrm>
            <a:off x="-47914" y="3653622"/>
            <a:ext cx="2310484" cy="2235009"/>
            <a:chOff x="72584" y="3139694"/>
            <a:chExt cx="2310484" cy="2235009"/>
          </a:xfrm>
        </p:grpSpPr>
        <p:grpSp>
          <p:nvGrpSpPr>
            <p:cNvPr id="67" name="组合 66">
              <a:extLst>
                <a:ext uri="{FF2B5EF4-FFF2-40B4-BE49-F238E27FC236}">
                  <a16:creationId xmlns:a16="http://schemas.microsoft.com/office/drawing/2014/main" id="{15A58B7B-3739-43AF-A909-BD05C78C04C0}"/>
                </a:ext>
              </a:extLst>
            </p:cNvPr>
            <p:cNvGrpSpPr/>
            <p:nvPr/>
          </p:nvGrpSpPr>
          <p:grpSpPr>
            <a:xfrm>
              <a:off x="72584" y="3139694"/>
              <a:ext cx="2310484" cy="2235009"/>
              <a:chOff x="72584" y="3139694"/>
              <a:chExt cx="2310484" cy="2235009"/>
            </a:xfrm>
          </p:grpSpPr>
          <p:sp>
            <p:nvSpPr>
              <p:cNvPr id="70" name="文本框 69">
                <a:extLst>
                  <a:ext uri="{FF2B5EF4-FFF2-40B4-BE49-F238E27FC236}">
                    <a16:creationId xmlns:a16="http://schemas.microsoft.com/office/drawing/2014/main" id="{882949A3-FE08-4979-AEEE-86FE1C3EF960}"/>
                  </a:ext>
                </a:extLst>
              </p:cNvPr>
              <p:cNvSpPr txBox="1"/>
              <p:nvPr/>
            </p:nvSpPr>
            <p:spPr>
              <a:xfrm>
                <a:off x="960312" y="3139694"/>
                <a:ext cx="75809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g1005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71" name="组合 70">
                <a:extLst>
                  <a:ext uri="{FF2B5EF4-FFF2-40B4-BE49-F238E27FC236}">
                    <a16:creationId xmlns:a16="http://schemas.microsoft.com/office/drawing/2014/main" id="{ABE6637E-6BD4-40DC-9D53-A9E74B5C350F}"/>
                  </a:ext>
                </a:extLst>
              </p:cNvPr>
              <p:cNvGrpSpPr/>
              <p:nvPr/>
            </p:nvGrpSpPr>
            <p:grpSpPr>
              <a:xfrm>
                <a:off x="72584" y="3339753"/>
                <a:ext cx="2310484" cy="2034950"/>
                <a:chOff x="72604" y="3352253"/>
                <a:chExt cx="2310484" cy="2034950"/>
              </a:xfrm>
            </p:grpSpPr>
            <p:sp>
              <p:nvSpPr>
                <p:cNvPr id="72" name="文本框 71">
                  <a:extLst>
                    <a:ext uri="{FF2B5EF4-FFF2-40B4-BE49-F238E27FC236}">
                      <a16:creationId xmlns:a16="http://schemas.microsoft.com/office/drawing/2014/main" id="{97AF8A87-40A2-4A4A-BD4C-E6F90F99B53D}"/>
                    </a:ext>
                  </a:extLst>
                </p:cNvPr>
                <p:cNvSpPr txBox="1"/>
                <p:nvPr/>
              </p:nvSpPr>
              <p:spPr>
                <a:xfrm>
                  <a:off x="969873" y="5140982"/>
                  <a:ext cx="1060535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109-FITC</a:t>
                  </a:r>
                  <a:endParaRPr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73" name="图片 72">
                  <a:extLst>
                    <a:ext uri="{FF2B5EF4-FFF2-40B4-BE49-F238E27FC236}">
                      <a16:creationId xmlns:a16="http://schemas.microsoft.com/office/drawing/2014/main" id="{805DF301-B0FA-4CFA-83F1-258045DA151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9135" b="6911"/>
                <a:stretch/>
              </p:blipFill>
              <p:spPr>
                <a:xfrm>
                  <a:off x="570568" y="3352253"/>
                  <a:ext cx="1705514" cy="1675595"/>
                </a:xfrm>
                <a:prstGeom prst="rect">
                  <a:avLst/>
                </a:prstGeom>
              </p:spPr>
            </p:pic>
            <p:sp>
              <p:nvSpPr>
                <p:cNvPr id="74" name="文本框 73">
                  <a:extLst>
                    <a:ext uri="{FF2B5EF4-FFF2-40B4-BE49-F238E27FC236}">
                      <a16:creationId xmlns:a16="http://schemas.microsoft.com/office/drawing/2014/main" id="{006EED4A-5F7F-4E1A-BB14-DDBF6A001424}"/>
                    </a:ext>
                  </a:extLst>
                </p:cNvPr>
                <p:cNvSpPr txBox="1"/>
                <p:nvPr/>
              </p:nvSpPr>
              <p:spPr>
                <a:xfrm rot="16200000">
                  <a:off x="-183332" y="4069843"/>
                  <a:ext cx="75809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ell count</a:t>
                  </a:r>
                  <a:endParaRPr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5" name="文本框 74">
                  <a:extLst>
                    <a:ext uri="{FF2B5EF4-FFF2-40B4-BE49-F238E27FC236}">
                      <a16:creationId xmlns:a16="http://schemas.microsoft.com/office/drawing/2014/main" id="{026E11B3-18E4-4705-9977-59C8DFD6EBFA}"/>
                    </a:ext>
                  </a:extLst>
                </p:cNvPr>
                <p:cNvSpPr txBox="1"/>
                <p:nvPr/>
              </p:nvSpPr>
              <p:spPr>
                <a:xfrm>
                  <a:off x="191521" y="4522270"/>
                  <a:ext cx="75809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0</a:t>
                  </a:r>
                  <a:endParaRPr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6" name="文本框 75">
                  <a:extLst>
                    <a:ext uri="{FF2B5EF4-FFF2-40B4-BE49-F238E27FC236}">
                      <a16:creationId xmlns:a16="http://schemas.microsoft.com/office/drawing/2014/main" id="{E8FBFC93-AFBC-4034-B696-F4A42A174695}"/>
                    </a:ext>
                  </a:extLst>
                </p:cNvPr>
                <p:cNvSpPr txBox="1"/>
                <p:nvPr/>
              </p:nvSpPr>
              <p:spPr>
                <a:xfrm>
                  <a:off x="202239" y="4187590"/>
                  <a:ext cx="75809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00</a:t>
                  </a:r>
                  <a:endParaRPr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7" name="文本框 76">
                  <a:extLst>
                    <a:ext uri="{FF2B5EF4-FFF2-40B4-BE49-F238E27FC236}">
                      <a16:creationId xmlns:a16="http://schemas.microsoft.com/office/drawing/2014/main" id="{C91CACC5-2221-4D82-A9EE-A5C201C03315}"/>
                    </a:ext>
                  </a:extLst>
                </p:cNvPr>
                <p:cNvSpPr txBox="1"/>
                <p:nvPr/>
              </p:nvSpPr>
              <p:spPr>
                <a:xfrm>
                  <a:off x="202239" y="3858599"/>
                  <a:ext cx="75809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000</a:t>
                  </a:r>
                  <a:endParaRPr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8" name="文本框 77">
                  <a:extLst>
                    <a:ext uri="{FF2B5EF4-FFF2-40B4-BE49-F238E27FC236}">
                      <a16:creationId xmlns:a16="http://schemas.microsoft.com/office/drawing/2014/main" id="{86BA67A5-FC28-43BF-B63B-8F9A793F4CAE}"/>
                    </a:ext>
                  </a:extLst>
                </p:cNvPr>
                <p:cNvSpPr txBox="1"/>
                <p:nvPr/>
              </p:nvSpPr>
              <p:spPr>
                <a:xfrm>
                  <a:off x="202239" y="3526764"/>
                  <a:ext cx="75809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000</a:t>
                  </a:r>
                  <a:endParaRPr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9" name="文本框 78">
                  <a:extLst>
                    <a:ext uri="{FF2B5EF4-FFF2-40B4-BE49-F238E27FC236}">
                      <a16:creationId xmlns:a16="http://schemas.microsoft.com/office/drawing/2014/main" id="{B0F74C69-0D04-428C-B4E1-77FF5830DD20}"/>
                    </a:ext>
                  </a:extLst>
                </p:cNvPr>
                <p:cNvSpPr txBox="1"/>
                <p:nvPr/>
              </p:nvSpPr>
              <p:spPr>
                <a:xfrm>
                  <a:off x="1301237" y="4974038"/>
                  <a:ext cx="75809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lang="en-US" altLang="zh-CN" sz="1000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lang="zh-CN" altLang="en-US" sz="1000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0" name="文本框 79">
                  <a:extLst>
                    <a:ext uri="{FF2B5EF4-FFF2-40B4-BE49-F238E27FC236}">
                      <a16:creationId xmlns:a16="http://schemas.microsoft.com/office/drawing/2014/main" id="{CD0F17EA-7368-4153-8AF9-96ACF4F481DC}"/>
                    </a:ext>
                  </a:extLst>
                </p:cNvPr>
                <p:cNvSpPr txBox="1"/>
                <p:nvPr/>
              </p:nvSpPr>
              <p:spPr>
                <a:xfrm>
                  <a:off x="1624995" y="4974038"/>
                  <a:ext cx="75809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lang="en-US" altLang="zh-CN" sz="1000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endParaRPr lang="zh-CN" altLang="en-US" sz="1000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1" name="文本框 80">
                  <a:extLst>
                    <a:ext uri="{FF2B5EF4-FFF2-40B4-BE49-F238E27FC236}">
                      <a16:creationId xmlns:a16="http://schemas.microsoft.com/office/drawing/2014/main" id="{41BFCFCA-F2E8-4E95-B7AC-D369A9C4D536}"/>
                    </a:ext>
                  </a:extLst>
                </p:cNvPr>
                <p:cNvSpPr txBox="1"/>
                <p:nvPr/>
              </p:nvSpPr>
              <p:spPr>
                <a:xfrm>
                  <a:off x="391637" y="4831768"/>
                  <a:ext cx="75809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2" name="文本框 81">
                  <a:extLst>
                    <a:ext uri="{FF2B5EF4-FFF2-40B4-BE49-F238E27FC236}">
                      <a16:creationId xmlns:a16="http://schemas.microsoft.com/office/drawing/2014/main" id="{30ADE35B-4842-4461-B247-3D7CEA2EAEEC}"/>
                    </a:ext>
                  </a:extLst>
                </p:cNvPr>
                <p:cNvSpPr txBox="1"/>
                <p:nvPr/>
              </p:nvSpPr>
              <p:spPr>
                <a:xfrm>
                  <a:off x="795564" y="4993196"/>
                  <a:ext cx="314185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67F46044-F5FC-4361-B62E-282D2ABD1C3C}"/>
                </a:ext>
              </a:extLst>
            </p:cNvPr>
            <p:cNvSpPr txBox="1"/>
            <p:nvPr/>
          </p:nvSpPr>
          <p:spPr>
            <a:xfrm>
              <a:off x="915595" y="3350231"/>
              <a:ext cx="3141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289D2720-726D-4999-BAD3-9F723C53AFE8}"/>
                </a:ext>
              </a:extLst>
            </p:cNvPr>
            <p:cNvSpPr txBox="1"/>
            <p:nvPr/>
          </p:nvSpPr>
          <p:spPr>
            <a:xfrm>
              <a:off x="1298642" y="4461012"/>
              <a:ext cx="3141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3" name="组合 82">
            <a:extLst>
              <a:ext uri="{FF2B5EF4-FFF2-40B4-BE49-F238E27FC236}">
                <a16:creationId xmlns:a16="http://schemas.microsoft.com/office/drawing/2014/main" id="{62D2165F-C2AA-4863-B7AB-B37E96A34374}"/>
              </a:ext>
            </a:extLst>
          </p:cNvPr>
          <p:cNvGrpSpPr/>
          <p:nvPr/>
        </p:nvGrpSpPr>
        <p:grpSpPr>
          <a:xfrm>
            <a:off x="2061397" y="3649004"/>
            <a:ext cx="2654535" cy="2242172"/>
            <a:chOff x="2220811" y="3143219"/>
            <a:chExt cx="2654535" cy="2242172"/>
          </a:xfrm>
        </p:grpSpPr>
        <p:pic>
          <p:nvPicPr>
            <p:cNvPr id="84" name="图片 83">
              <a:extLst>
                <a:ext uri="{FF2B5EF4-FFF2-40B4-BE49-F238E27FC236}">
                  <a16:creationId xmlns:a16="http://schemas.microsoft.com/office/drawing/2014/main" id="{6BDBA6B4-ED65-44C9-8A54-5FF13AB0AEB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742291" y="3363360"/>
              <a:ext cx="1688839" cy="1688400"/>
            </a:xfrm>
            <a:prstGeom prst="rect">
              <a:avLst/>
            </a:prstGeom>
          </p:spPr>
        </p:pic>
        <p:grpSp>
          <p:nvGrpSpPr>
            <p:cNvPr id="85" name="组合 84">
              <a:extLst>
                <a:ext uri="{FF2B5EF4-FFF2-40B4-BE49-F238E27FC236}">
                  <a16:creationId xmlns:a16="http://schemas.microsoft.com/office/drawing/2014/main" id="{3F360A37-800B-4207-B139-2EC3B2C476D6}"/>
                </a:ext>
              </a:extLst>
            </p:cNvPr>
            <p:cNvGrpSpPr/>
            <p:nvPr/>
          </p:nvGrpSpPr>
          <p:grpSpPr>
            <a:xfrm>
              <a:off x="2220811" y="3143219"/>
              <a:ext cx="2654535" cy="2242172"/>
              <a:chOff x="2220811" y="3143219"/>
              <a:chExt cx="2654535" cy="2242172"/>
            </a:xfrm>
          </p:grpSpPr>
          <p:grpSp>
            <p:nvGrpSpPr>
              <p:cNvPr id="86" name="组合 85">
                <a:extLst>
                  <a:ext uri="{FF2B5EF4-FFF2-40B4-BE49-F238E27FC236}">
                    <a16:creationId xmlns:a16="http://schemas.microsoft.com/office/drawing/2014/main" id="{1C22C75F-3DF1-40A3-9F7E-F52FAA300522}"/>
                  </a:ext>
                </a:extLst>
              </p:cNvPr>
              <p:cNvGrpSpPr/>
              <p:nvPr/>
            </p:nvGrpSpPr>
            <p:grpSpPr>
              <a:xfrm>
                <a:off x="2220811" y="3143219"/>
                <a:ext cx="2654535" cy="2242172"/>
                <a:chOff x="2276082" y="3143219"/>
                <a:chExt cx="2654535" cy="2242172"/>
              </a:xfrm>
            </p:grpSpPr>
            <p:sp>
              <p:nvSpPr>
                <p:cNvPr id="89" name="文本框 88">
                  <a:extLst>
                    <a:ext uri="{FF2B5EF4-FFF2-40B4-BE49-F238E27FC236}">
                      <a16:creationId xmlns:a16="http://schemas.microsoft.com/office/drawing/2014/main" id="{7BD45DCD-6699-412B-A427-D7DFCD11E4EB}"/>
                    </a:ext>
                  </a:extLst>
                </p:cNvPr>
                <p:cNvSpPr txBox="1"/>
                <p:nvPr/>
              </p:nvSpPr>
              <p:spPr>
                <a:xfrm rot="16200000">
                  <a:off x="2020146" y="4081966"/>
                  <a:ext cx="75809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ell count</a:t>
                  </a:r>
                  <a:endParaRPr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90" name="组合 89">
                  <a:extLst>
                    <a:ext uri="{FF2B5EF4-FFF2-40B4-BE49-F238E27FC236}">
                      <a16:creationId xmlns:a16="http://schemas.microsoft.com/office/drawing/2014/main" id="{B359F4CC-0396-45EF-824A-2530CB582D43}"/>
                    </a:ext>
                  </a:extLst>
                </p:cNvPr>
                <p:cNvGrpSpPr/>
                <p:nvPr/>
              </p:nvGrpSpPr>
              <p:grpSpPr>
                <a:xfrm>
                  <a:off x="2418960" y="3143219"/>
                  <a:ext cx="2511657" cy="2242172"/>
                  <a:chOff x="2428484" y="3150201"/>
                  <a:chExt cx="2511657" cy="2242172"/>
                </a:xfrm>
              </p:grpSpPr>
              <p:sp>
                <p:nvSpPr>
                  <p:cNvPr id="91" name="文本框 90">
                    <a:extLst>
                      <a:ext uri="{FF2B5EF4-FFF2-40B4-BE49-F238E27FC236}">
                        <a16:creationId xmlns:a16="http://schemas.microsoft.com/office/drawing/2014/main" id="{3D9B1BDC-D3D6-4376-9D24-E4039D6CC863}"/>
                      </a:ext>
                    </a:extLst>
                  </p:cNvPr>
                  <p:cNvSpPr txBox="1"/>
                  <p:nvPr/>
                </p:nvSpPr>
                <p:spPr>
                  <a:xfrm>
                    <a:off x="3383448" y="3150201"/>
                    <a:ext cx="758093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1051</a:t>
                    </a:r>
                    <a:endParaRPr lang="zh-CN" altLang="en-U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2" name="文本框 91">
                    <a:extLst>
                      <a:ext uri="{FF2B5EF4-FFF2-40B4-BE49-F238E27FC236}">
                        <a16:creationId xmlns:a16="http://schemas.microsoft.com/office/drawing/2014/main" id="{59EE6108-B2FE-43A3-A414-63F9CA0448F5}"/>
                      </a:ext>
                    </a:extLst>
                  </p:cNvPr>
                  <p:cNvSpPr txBox="1"/>
                  <p:nvPr/>
                </p:nvSpPr>
                <p:spPr>
                  <a:xfrm>
                    <a:off x="3211308" y="5146152"/>
                    <a:ext cx="994831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D109-FITC</a:t>
                    </a:r>
                    <a:endParaRPr lang="zh-CN" altLang="en-U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3" name="文本框 92">
                    <a:extLst>
                      <a:ext uri="{FF2B5EF4-FFF2-40B4-BE49-F238E27FC236}">
                        <a16:creationId xmlns:a16="http://schemas.microsoft.com/office/drawing/2014/main" id="{708728AE-7299-4D7F-A6D8-5D7F403A48AF}"/>
                      </a:ext>
                    </a:extLst>
                  </p:cNvPr>
                  <p:cNvSpPr txBox="1"/>
                  <p:nvPr/>
                </p:nvSpPr>
                <p:spPr>
                  <a:xfrm>
                    <a:off x="2625355" y="4860596"/>
                    <a:ext cx="758093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</a:t>
                    </a:r>
                    <a:endParaRPr lang="zh-CN" altLang="en-U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4" name="文本框 93">
                    <a:extLst>
                      <a:ext uri="{FF2B5EF4-FFF2-40B4-BE49-F238E27FC236}">
                        <a16:creationId xmlns:a16="http://schemas.microsoft.com/office/drawing/2014/main" id="{2BA1921B-F9AF-45EE-BFF0-E52D1812F3FC}"/>
                      </a:ext>
                    </a:extLst>
                  </p:cNvPr>
                  <p:cNvSpPr txBox="1"/>
                  <p:nvPr/>
                </p:nvSpPr>
                <p:spPr>
                  <a:xfrm>
                    <a:off x="2434293" y="4358843"/>
                    <a:ext cx="758093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00</a:t>
                    </a:r>
                    <a:endParaRPr lang="zh-CN" altLang="en-U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5" name="文本框 94">
                    <a:extLst>
                      <a:ext uri="{FF2B5EF4-FFF2-40B4-BE49-F238E27FC236}">
                        <a16:creationId xmlns:a16="http://schemas.microsoft.com/office/drawing/2014/main" id="{E81AEA4F-F218-4742-89E2-0CC12E2FD1C7}"/>
                      </a:ext>
                    </a:extLst>
                  </p:cNvPr>
                  <p:cNvSpPr txBox="1"/>
                  <p:nvPr/>
                </p:nvSpPr>
                <p:spPr>
                  <a:xfrm>
                    <a:off x="2434293" y="3867330"/>
                    <a:ext cx="758093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000</a:t>
                    </a:r>
                    <a:endParaRPr lang="zh-CN" altLang="en-U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6" name="文本框 95">
                    <a:extLst>
                      <a:ext uri="{FF2B5EF4-FFF2-40B4-BE49-F238E27FC236}">
                        <a16:creationId xmlns:a16="http://schemas.microsoft.com/office/drawing/2014/main" id="{9D9CC421-1345-46EA-830B-A426E8480DD1}"/>
                      </a:ext>
                    </a:extLst>
                  </p:cNvPr>
                  <p:cNvSpPr txBox="1"/>
                  <p:nvPr/>
                </p:nvSpPr>
                <p:spPr>
                  <a:xfrm>
                    <a:off x="2428484" y="3364302"/>
                    <a:ext cx="758093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000</a:t>
                    </a:r>
                    <a:endParaRPr lang="zh-CN" altLang="en-U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7" name="文本框 96">
                    <a:extLst>
                      <a:ext uri="{FF2B5EF4-FFF2-40B4-BE49-F238E27FC236}">
                        <a16:creationId xmlns:a16="http://schemas.microsoft.com/office/drawing/2014/main" id="{EEAB2C4D-5E02-4E71-83B8-0EAD279C6D97}"/>
                      </a:ext>
                    </a:extLst>
                  </p:cNvPr>
                  <p:cNvSpPr txBox="1"/>
                  <p:nvPr/>
                </p:nvSpPr>
                <p:spPr>
                  <a:xfrm>
                    <a:off x="3535066" y="4993196"/>
                    <a:ext cx="758093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  <a:r>
                      <a:rPr lang="en-US" altLang="zh-CN" sz="10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</a:t>
                    </a:r>
                    <a:endParaRPr lang="zh-CN" altLang="en-US" sz="1000" baseline="30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8" name="文本框 97">
                    <a:extLst>
                      <a:ext uri="{FF2B5EF4-FFF2-40B4-BE49-F238E27FC236}">
                        <a16:creationId xmlns:a16="http://schemas.microsoft.com/office/drawing/2014/main" id="{AE6391FA-E012-4B09-8946-C8D981F59444}"/>
                      </a:ext>
                    </a:extLst>
                  </p:cNvPr>
                  <p:cNvSpPr txBox="1"/>
                  <p:nvPr/>
                </p:nvSpPr>
                <p:spPr>
                  <a:xfrm>
                    <a:off x="3858824" y="4993196"/>
                    <a:ext cx="758093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  <a:r>
                      <a:rPr lang="en-US" altLang="zh-CN" sz="10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</a:t>
                    </a:r>
                    <a:endParaRPr lang="zh-CN" altLang="en-US" sz="1000" baseline="30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9" name="文本框 98">
                    <a:extLst>
                      <a:ext uri="{FF2B5EF4-FFF2-40B4-BE49-F238E27FC236}">
                        <a16:creationId xmlns:a16="http://schemas.microsoft.com/office/drawing/2014/main" id="{E0CF8BA6-24E3-4073-8CD7-75296D2D176B}"/>
                      </a:ext>
                    </a:extLst>
                  </p:cNvPr>
                  <p:cNvSpPr txBox="1"/>
                  <p:nvPr/>
                </p:nvSpPr>
                <p:spPr>
                  <a:xfrm>
                    <a:off x="4182048" y="4993196"/>
                    <a:ext cx="758093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  <a:r>
                      <a:rPr lang="en-US" altLang="zh-CN" sz="10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</a:t>
                    </a:r>
                    <a:endParaRPr lang="zh-CN" altLang="en-US" sz="1000" baseline="30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00" name="文本框 99">
                    <a:extLst>
                      <a:ext uri="{FF2B5EF4-FFF2-40B4-BE49-F238E27FC236}">
                        <a16:creationId xmlns:a16="http://schemas.microsoft.com/office/drawing/2014/main" id="{1950F711-AB87-4EB0-AD00-26BC83BFBD36}"/>
                      </a:ext>
                    </a:extLst>
                  </p:cNvPr>
                  <p:cNvSpPr txBox="1"/>
                  <p:nvPr/>
                </p:nvSpPr>
                <p:spPr>
                  <a:xfrm>
                    <a:off x="3029393" y="5012354"/>
                    <a:ext cx="314185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</a:t>
                    </a:r>
                    <a:endParaRPr lang="zh-CN" altLang="en-U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sp>
            <p:nvSpPr>
              <p:cNvPr id="87" name="文本框 86">
                <a:extLst>
                  <a:ext uri="{FF2B5EF4-FFF2-40B4-BE49-F238E27FC236}">
                    <a16:creationId xmlns:a16="http://schemas.microsoft.com/office/drawing/2014/main" id="{D52B73F2-C3DF-4C80-8B92-60640EED8E0B}"/>
                  </a:ext>
                </a:extLst>
              </p:cNvPr>
              <p:cNvSpPr txBox="1"/>
              <p:nvPr/>
            </p:nvSpPr>
            <p:spPr>
              <a:xfrm>
                <a:off x="3116302" y="3382257"/>
                <a:ext cx="31418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zh-CN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文本框 87">
                <a:extLst>
                  <a:ext uri="{FF2B5EF4-FFF2-40B4-BE49-F238E27FC236}">
                    <a16:creationId xmlns:a16="http://schemas.microsoft.com/office/drawing/2014/main" id="{6844AB72-8C0E-4F28-8070-D8FA4FC98D88}"/>
                  </a:ext>
                </a:extLst>
              </p:cNvPr>
              <p:cNvSpPr txBox="1"/>
              <p:nvPr/>
            </p:nvSpPr>
            <p:spPr>
              <a:xfrm>
                <a:off x="3465757" y="4479616"/>
                <a:ext cx="31418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0" name="组合 9">
            <a:extLst>
              <a:ext uri="{FF2B5EF4-FFF2-40B4-BE49-F238E27FC236}">
                <a16:creationId xmlns:a16="http://schemas.microsoft.com/office/drawing/2014/main" id="{2C7409AE-A33A-4862-B7C4-CD9D56C8FE6B}"/>
              </a:ext>
            </a:extLst>
          </p:cNvPr>
          <p:cNvGrpSpPr/>
          <p:nvPr/>
        </p:nvGrpSpPr>
        <p:grpSpPr>
          <a:xfrm>
            <a:off x="4392174" y="3884096"/>
            <a:ext cx="2462499" cy="1923357"/>
            <a:chOff x="4241016" y="3233518"/>
            <a:chExt cx="2462499" cy="1923357"/>
          </a:xfrm>
        </p:grpSpPr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644F2701-A08B-4E49-BD8E-A871C86D42E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04" t="8153" b="12348"/>
            <a:stretch/>
          </p:blipFill>
          <p:spPr>
            <a:xfrm>
              <a:off x="4423334" y="3433103"/>
              <a:ext cx="2280181" cy="1446092"/>
            </a:xfrm>
            <a:prstGeom prst="rect">
              <a:avLst/>
            </a:prstGeom>
          </p:spPr>
        </p:pic>
        <p:sp>
          <p:nvSpPr>
            <p:cNvPr id="103" name="文本框 102">
              <a:extLst>
                <a:ext uri="{FF2B5EF4-FFF2-40B4-BE49-F238E27FC236}">
                  <a16:creationId xmlns:a16="http://schemas.microsoft.com/office/drawing/2014/main" id="{8A63B8E0-20DB-4146-843C-AA5C607C6283}"/>
                </a:ext>
              </a:extLst>
            </p:cNvPr>
            <p:cNvSpPr txBox="1"/>
            <p:nvPr/>
          </p:nvSpPr>
          <p:spPr>
            <a:xfrm>
              <a:off x="6007472" y="3378111"/>
              <a:ext cx="3447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108" name="文本框 107">
              <a:extLst>
                <a:ext uri="{FF2B5EF4-FFF2-40B4-BE49-F238E27FC236}">
                  <a16:creationId xmlns:a16="http://schemas.microsoft.com/office/drawing/2014/main" id="{2ADC6390-42CA-47F7-B4A8-6A8DF690866E}"/>
                </a:ext>
              </a:extLst>
            </p:cNvPr>
            <p:cNvSpPr txBox="1"/>
            <p:nvPr/>
          </p:nvSpPr>
          <p:spPr>
            <a:xfrm>
              <a:off x="4871162" y="3530837"/>
              <a:ext cx="3447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109" name="文本框 108">
              <a:extLst>
                <a:ext uri="{FF2B5EF4-FFF2-40B4-BE49-F238E27FC236}">
                  <a16:creationId xmlns:a16="http://schemas.microsoft.com/office/drawing/2014/main" id="{187AEC5C-A7EE-41BA-9E59-41322D32197A}"/>
                </a:ext>
              </a:extLst>
            </p:cNvPr>
            <p:cNvSpPr txBox="1"/>
            <p:nvPr/>
          </p:nvSpPr>
          <p:spPr>
            <a:xfrm rot="16200000">
              <a:off x="3472528" y="4008493"/>
              <a:ext cx="17831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Relative mRNA expression</a:t>
              </a:r>
            </a:p>
          </p:txBody>
        </p:sp>
        <p:sp>
          <p:nvSpPr>
            <p:cNvPr id="110" name="文本框 109">
              <a:extLst>
                <a:ext uri="{FF2B5EF4-FFF2-40B4-BE49-F238E27FC236}">
                  <a16:creationId xmlns:a16="http://schemas.microsoft.com/office/drawing/2014/main" id="{C898990D-0668-4AA5-A849-ECB8EDC9AC67}"/>
                </a:ext>
              </a:extLst>
            </p:cNvPr>
            <p:cNvSpPr txBox="1"/>
            <p:nvPr/>
          </p:nvSpPr>
          <p:spPr>
            <a:xfrm>
              <a:off x="4729498" y="4798050"/>
              <a:ext cx="2462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文本框 110">
              <a:extLst>
                <a:ext uri="{FF2B5EF4-FFF2-40B4-BE49-F238E27FC236}">
                  <a16:creationId xmlns:a16="http://schemas.microsoft.com/office/drawing/2014/main" id="{2CF00F41-DE7C-461B-8C7C-5C5BE40BA622}"/>
                </a:ext>
              </a:extLst>
            </p:cNvPr>
            <p:cNvSpPr txBox="1"/>
            <p:nvPr/>
          </p:nvSpPr>
          <p:spPr>
            <a:xfrm>
              <a:off x="5124243" y="4796693"/>
              <a:ext cx="2462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文本框 111">
              <a:extLst>
                <a:ext uri="{FF2B5EF4-FFF2-40B4-BE49-F238E27FC236}">
                  <a16:creationId xmlns:a16="http://schemas.microsoft.com/office/drawing/2014/main" id="{B5BD6EC5-076D-4BDB-8306-E92A950BF4A6}"/>
                </a:ext>
              </a:extLst>
            </p:cNvPr>
            <p:cNvSpPr txBox="1"/>
            <p:nvPr/>
          </p:nvSpPr>
          <p:spPr>
            <a:xfrm>
              <a:off x="5875304" y="4795453"/>
              <a:ext cx="2462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文本框 112">
              <a:extLst>
                <a:ext uri="{FF2B5EF4-FFF2-40B4-BE49-F238E27FC236}">
                  <a16:creationId xmlns:a16="http://schemas.microsoft.com/office/drawing/2014/main" id="{73EE8999-4377-4DA9-AF87-1D0CAA8DA2A8}"/>
                </a:ext>
              </a:extLst>
            </p:cNvPr>
            <p:cNvSpPr txBox="1"/>
            <p:nvPr/>
          </p:nvSpPr>
          <p:spPr>
            <a:xfrm>
              <a:off x="6270049" y="4794096"/>
              <a:ext cx="2462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文本框 113">
              <a:extLst>
                <a:ext uri="{FF2B5EF4-FFF2-40B4-BE49-F238E27FC236}">
                  <a16:creationId xmlns:a16="http://schemas.microsoft.com/office/drawing/2014/main" id="{2FBE6D65-15EC-4661-9599-E17A35CF156D}"/>
                </a:ext>
              </a:extLst>
            </p:cNvPr>
            <p:cNvSpPr txBox="1"/>
            <p:nvPr/>
          </p:nvSpPr>
          <p:spPr>
            <a:xfrm>
              <a:off x="5156742" y="4910654"/>
              <a:ext cx="11550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D109 FACS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文本框 115">
              <a:extLst>
                <a:ext uri="{FF2B5EF4-FFF2-40B4-BE49-F238E27FC236}">
                  <a16:creationId xmlns:a16="http://schemas.microsoft.com/office/drawing/2014/main" id="{B28E4154-A8CB-4582-A3CC-198AC83F2EBC}"/>
                </a:ext>
              </a:extLst>
            </p:cNvPr>
            <p:cNvSpPr txBox="1"/>
            <p:nvPr/>
          </p:nvSpPr>
          <p:spPr>
            <a:xfrm>
              <a:off x="4807828" y="3242996"/>
              <a:ext cx="5359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g1005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文本框 116">
              <a:extLst>
                <a:ext uri="{FF2B5EF4-FFF2-40B4-BE49-F238E27FC236}">
                  <a16:creationId xmlns:a16="http://schemas.microsoft.com/office/drawing/2014/main" id="{DA275CA4-58DA-4726-8046-9B42F0C62C87}"/>
                </a:ext>
              </a:extLst>
            </p:cNvPr>
            <p:cNvSpPr txBox="1"/>
            <p:nvPr/>
          </p:nvSpPr>
          <p:spPr>
            <a:xfrm>
              <a:off x="5998415" y="3233518"/>
              <a:ext cx="53898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g1051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" name="组合 6">
            <a:extLst>
              <a:ext uri="{FF2B5EF4-FFF2-40B4-BE49-F238E27FC236}">
                <a16:creationId xmlns:a16="http://schemas.microsoft.com/office/drawing/2014/main" id="{7B104005-76F6-4D6C-A49F-83833D1A2790}"/>
              </a:ext>
            </a:extLst>
          </p:cNvPr>
          <p:cNvGrpSpPr/>
          <p:nvPr/>
        </p:nvGrpSpPr>
        <p:grpSpPr>
          <a:xfrm>
            <a:off x="44998" y="1324810"/>
            <a:ext cx="3047009" cy="2212694"/>
            <a:chOff x="44998" y="674729"/>
            <a:chExt cx="3047009" cy="2212694"/>
          </a:xfrm>
        </p:grpSpPr>
        <p:grpSp>
          <p:nvGrpSpPr>
            <p:cNvPr id="149" name="组合 148">
              <a:extLst>
                <a:ext uri="{FF2B5EF4-FFF2-40B4-BE49-F238E27FC236}">
                  <a16:creationId xmlns:a16="http://schemas.microsoft.com/office/drawing/2014/main" id="{191F0DC2-8488-4EEF-AB1A-A61EF11577DD}"/>
                </a:ext>
              </a:extLst>
            </p:cNvPr>
            <p:cNvGrpSpPr/>
            <p:nvPr/>
          </p:nvGrpSpPr>
          <p:grpSpPr>
            <a:xfrm>
              <a:off x="44998" y="674729"/>
              <a:ext cx="3011906" cy="2212694"/>
              <a:chOff x="109717" y="6889733"/>
              <a:chExt cx="3011906" cy="2212694"/>
            </a:xfrm>
          </p:grpSpPr>
          <p:graphicFrame>
            <p:nvGraphicFramePr>
              <p:cNvPr id="150" name="Chart 3">
                <a:extLst>
                  <a:ext uri="{FF2B5EF4-FFF2-40B4-BE49-F238E27FC236}">
                    <a16:creationId xmlns:a16="http://schemas.microsoft.com/office/drawing/2014/main" id="{40D1B461-998B-4E23-8285-A3F90BDC8268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109717" y="6889733"/>
              <a:ext cx="1505953" cy="220227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graphicFrame>
            <p:nvGraphicFramePr>
              <p:cNvPr id="151" name="Chart 4">
                <a:extLst>
                  <a:ext uri="{FF2B5EF4-FFF2-40B4-BE49-F238E27FC236}">
                    <a16:creationId xmlns:a16="http://schemas.microsoft.com/office/drawing/2014/main" id="{72C469D1-D6D1-4660-B6E0-4551AAD8876A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1615670" y="6899227"/>
              <a:ext cx="1505953" cy="220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</p:grpSp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DEFF461C-8554-488B-A03F-AB33BCE746DB}"/>
                </a:ext>
              </a:extLst>
            </p:cNvPr>
            <p:cNvSpPr txBox="1"/>
            <p:nvPr/>
          </p:nvSpPr>
          <p:spPr>
            <a:xfrm>
              <a:off x="460767" y="2577643"/>
              <a:ext cx="120848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g267 shCD109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C382EFC7-183D-4AD1-9B1E-AB1F8540BC8C}"/>
                </a:ext>
              </a:extLst>
            </p:cNvPr>
            <p:cNvSpPr txBox="1"/>
            <p:nvPr/>
          </p:nvSpPr>
          <p:spPr>
            <a:xfrm>
              <a:off x="460767" y="2356008"/>
              <a:ext cx="693596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g267 NT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2CA5A696-74C1-4F74-ACEA-E0D5408DF630}"/>
                </a:ext>
              </a:extLst>
            </p:cNvPr>
            <p:cNvSpPr txBox="1"/>
            <p:nvPr/>
          </p:nvSpPr>
          <p:spPr>
            <a:xfrm>
              <a:off x="1883523" y="2366530"/>
              <a:ext cx="120848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g1005 CD109 +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F8C2E0DB-AABB-416D-A827-172275DFFF9E}"/>
                </a:ext>
              </a:extLst>
            </p:cNvPr>
            <p:cNvSpPr txBox="1"/>
            <p:nvPr/>
          </p:nvSpPr>
          <p:spPr>
            <a:xfrm>
              <a:off x="1883523" y="2585352"/>
              <a:ext cx="120848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g1005 CD109 -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653170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副标题 2">
            <a:extLst>
              <a:ext uri="{FF2B5EF4-FFF2-40B4-BE49-F238E27FC236}">
                <a16:creationId xmlns:a16="http://schemas.microsoft.com/office/drawing/2014/main" id="{F2DF7397-CAA3-41AE-896C-A7A7BFE31EDB}"/>
              </a:ext>
            </a:extLst>
          </p:cNvPr>
          <p:cNvSpPr txBox="1">
            <a:spLocks/>
          </p:cNvSpPr>
          <p:nvPr/>
        </p:nvSpPr>
        <p:spPr>
          <a:xfrm>
            <a:off x="169018" y="152952"/>
            <a:ext cx="3259982" cy="46750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.4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01432D4F-744B-4FFA-9AEB-30178274F6B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406" t="16463" r="9113"/>
          <a:stretch/>
        </p:blipFill>
        <p:spPr>
          <a:xfrm>
            <a:off x="594463" y="1263377"/>
            <a:ext cx="1987145" cy="1332000"/>
          </a:xfrm>
          <a:prstGeom prst="rect">
            <a:avLst/>
          </a:prstGeom>
        </p:spPr>
      </p:pic>
      <p:grpSp>
        <p:nvGrpSpPr>
          <p:cNvPr id="10" name="组合 9">
            <a:extLst>
              <a:ext uri="{FF2B5EF4-FFF2-40B4-BE49-F238E27FC236}">
                <a16:creationId xmlns:a16="http://schemas.microsoft.com/office/drawing/2014/main" id="{1DD40634-7437-4EE4-9CD5-F16D27A4657F}"/>
              </a:ext>
            </a:extLst>
          </p:cNvPr>
          <p:cNvGrpSpPr>
            <a:grpSpLocks noChangeAspect="1"/>
          </p:cNvGrpSpPr>
          <p:nvPr/>
        </p:nvGrpSpPr>
        <p:grpSpPr>
          <a:xfrm>
            <a:off x="281612" y="1029377"/>
            <a:ext cx="2461620" cy="1800000"/>
            <a:chOff x="3604471" y="667413"/>
            <a:chExt cx="2666905" cy="1950110"/>
          </a:xfrm>
        </p:grpSpPr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B19E6550-F129-4E5B-B5BA-C525C2146F73}"/>
                </a:ext>
              </a:extLst>
            </p:cNvPr>
            <p:cNvSpPr txBox="1"/>
            <p:nvPr/>
          </p:nvSpPr>
          <p:spPr>
            <a:xfrm>
              <a:off x="4448945" y="937361"/>
              <a:ext cx="7166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i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LAGL1</a:t>
              </a:r>
              <a:endParaRPr lang="zh-CN" altLang="en-US" sz="1000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08F29A52-EDB4-41D4-8E67-4C9859EBE1A8}"/>
                </a:ext>
              </a:extLst>
            </p:cNvPr>
            <p:cNvSpPr txBox="1"/>
            <p:nvPr/>
          </p:nvSpPr>
          <p:spPr>
            <a:xfrm rot="16200000">
              <a:off x="2846155" y="1425729"/>
              <a:ext cx="1950110" cy="4334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ES GSCs vs. NP</a:t>
              </a:r>
            </a:p>
            <a:p>
              <a:pPr algn="ct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og</a:t>
              </a:r>
              <a:r>
                <a:rPr lang="en-US" altLang="zh-CN" sz="10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fold-change(MES/NP)</a:t>
              </a: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584357FB-81C8-4BB4-B26C-5FAF828708BE}"/>
                </a:ext>
              </a:extLst>
            </p:cNvPr>
            <p:cNvSpPr txBox="1"/>
            <p:nvPr/>
          </p:nvSpPr>
          <p:spPr>
            <a:xfrm>
              <a:off x="4075304" y="668240"/>
              <a:ext cx="2196072" cy="2667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2H2 ZF Gene family in GSC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" name="直接箭头连接符 13">
              <a:extLst>
                <a:ext uri="{FF2B5EF4-FFF2-40B4-BE49-F238E27FC236}">
                  <a16:creationId xmlns:a16="http://schemas.microsoft.com/office/drawing/2014/main" id="{EF26170F-5D85-426C-B698-10464FCB727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78496" y="1104687"/>
              <a:ext cx="376529" cy="93071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76863878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副标题 2">
            <a:extLst>
              <a:ext uri="{FF2B5EF4-FFF2-40B4-BE49-F238E27FC236}">
                <a16:creationId xmlns:a16="http://schemas.microsoft.com/office/drawing/2014/main" id="{D90E6C4C-0811-4F54-AC55-9D6F73A46276}"/>
              </a:ext>
            </a:extLst>
          </p:cNvPr>
          <p:cNvSpPr txBox="1">
            <a:spLocks/>
          </p:cNvSpPr>
          <p:nvPr/>
        </p:nvSpPr>
        <p:spPr>
          <a:xfrm>
            <a:off x="155105" y="152564"/>
            <a:ext cx="3173883" cy="46750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.5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7" name="组合 146">
            <a:extLst>
              <a:ext uri="{FF2B5EF4-FFF2-40B4-BE49-F238E27FC236}">
                <a16:creationId xmlns:a16="http://schemas.microsoft.com/office/drawing/2014/main" id="{D3C9935B-2FB0-4A77-B944-4ABBC2F47FB5}"/>
              </a:ext>
            </a:extLst>
          </p:cNvPr>
          <p:cNvGrpSpPr/>
          <p:nvPr/>
        </p:nvGrpSpPr>
        <p:grpSpPr>
          <a:xfrm>
            <a:off x="634204" y="992083"/>
            <a:ext cx="2309490" cy="1716736"/>
            <a:chOff x="564311" y="3349520"/>
            <a:chExt cx="2309490" cy="1716736"/>
          </a:xfrm>
        </p:grpSpPr>
        <p:grpSp>
          <p:nvGrpSpPr>
            <p:cNvPr id="113" name="组合 112">
              <a:extLst>
                <a:ext uri="{FF2B5EF4-FFF2-40B4-BE49-F238E27FC236}">
                  <a16:creationId xmlns:a16="http://schemas.microsoft.com/office/drawing/2014/main" id="{3DF39ADD-DCEB-4CEA-A64A-B1E587A4D1AE}"/>
                </a:ext>
              </a:extLst>
            </p:cNvPr>
            <p:cNvGrpSpPr/>
            <p:nvPr/>
          </p:nvGrpSpPr>
          <p:grpSpPr>
            <a:xfrm>
              <a:off x="564311" y="3349520"/>
              <a:ext cx="2309490" cy="1716736"/>
              <a:chOff x="564311" y="3349520"/>
              <a:chExt cx="2309490" cy="1716736"/>
            </a:xfrm>
          </p:grpSpPr>
          <p:grpSp>
            <p:nvGrpSpPr>
              <p:cNvPr id="116" name="组合 115">
                <a:extLst>
                  <a:ext uri="{FF2B5EF4-FFF2-40B4-BE49-F238E27FC236}">
                    <a16:creationId xmlns:a16="http://schemas.microsoft.com/office/drawing/2014/main" id="{79B63FFF-9990-47F1-9E16-1167C9D0A657}"/>
                  </a:ext>
                </a:extLst>
              </p:cNvPr>
              <p:cNvGrpSpPr/>
              <p:nvPr/>
            </p:nvGrpSpPr>
            <p:grpSpPr>
              <a:xfrm>
                <a:off x="564311" y="3349520"/>
                <a:ext cx="2309490" cy="1716736"/>
                <a:chOff x="582873" y="3135399"/>
                <a:chExt cx="2309490" cy="1716736"/>
              </a:xfrm>
            </p:grpSpPr>
            <p:grpSp>
              <p:nvGrpSpPr>
                <p:cNvPr id="4" name="组合 3">
                  <a:extLst>
                    <a:ext uri="{FF2B5EF4-FFF2-40B4-BE49-F238E27FC236}">
                      <a16:creationId xmlns:a16="http://schemas.microsoft.com/office/drawing/2014/main" id="{D982248D-587A-4F36-B2FB-875AF8091744}"/>
                    </a:ext>
                  </a:extLst>
                </p:cNvPr>
                <p:cNvGrpSpPr/>
                <p:nvPr/>
              </p:nvGrpSpPr>
              <p:grpSpPr>
                <a:xfrm>
                  <a:off x="582873" y="3278156"/>
                  <a:ext cx="2309490" cy="1573979"/>
                  <a:chOff x="582873" y="3278156"/>
                  <a:chExt cx="2309490" cy="1573979"/>
                </a:xfrm>
              </p:grpSpPr>
              <p:sp>
                <p:nvSpPr>
                  <p:cNvPr id="102" name="矩形 101">
                    <a:extLst>
                      <a:ext uri="{FF2B5EF4-FFF2-40B4-BE49-F238E27FC236}">
                        <a16:creationId xmlns:a16="http://schemas.microsoft.com/office/drawing/2014/main" id="{64FA0AE9-1E2D-43B5-8B1E-49EEDC521C46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57864" y="3853916"/>
                    <a:ext cx="1296240" cy="246221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LAGL1/B-Actin(%)</a:t>
                    </a:r>
                    <a:endParaRPr lang="zh-CN" altLang="en-U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03" name="矩形 102">
                    <a:extLst>
                      <a:ext uri="{FF2B5EF4-FFF2-40B4-BE49-F238E27FC236}">
                        <a16:creationId xmlns:a16="http://schemas.microsoft.com/office/drawing/2014/main" id="{EEDEDF78-EA52-4FFA-BFF0-ED778D96D0B4}"/>
                      </a:ext>
                    </a:extLst>
                  </p:cNvPr>
                  <p:cNvSpPr/>
                  <p:nvPr/>
                </p:nvSpPr>
                <p:spPr>
                  <a:xfrm>
                    <a:off x="759510" y="4254792"/>
                    <a:ext cx="398381" cy="246221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</a:t>
                    </a:r>
                  </a:p>
                </p:txBody>
              </p:sp>
              <p:sp>
                <p:nvSpPr>
                  <p:cNvPr id="104" name="矩形 103">
                    <a:extLst>
                      <a:ext uri="{FF2B5EF4-FFF2-40B4-BE49-F238E27FC236}">
                        <a16:creationId xmlns:a16="http://schemas.microsoft.com/office/drawing/2014/main" id="{21768565-FB27-4E71-807F-B1999FE4402B}"/>
                      </a:ext>
                    </a:extLst>
                  </p:cNvPr>
                  <p:cNvSpPr/>
                  <p:nvPr/>
                </p:nvSpPr>
                <p:spPr>
                  <a:xfrm>
                    <a:off x="829962" y="4499507"/>
                    <a:ext cx="398381" cy="246221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</a:t>
                    </a:r>
                  </a:p>
                </p:txBody>
              </p:sp>
              <p:sp>
                <p:nvSpPr>
                  <p:cNvPr id="105" name="矩形 104">
                    <a:extLst>
                      <a:ext uri="{FF2B5EF4-FFF2-40B4-BE49-F238E27FC236}">
                        <a16:creationId xmlns:a16="http://schemas.microsoft.com/office/drawing/2014/main" id="{EAF253E7-2697-432D-AACC-68E0F7C493DD}"/>
                      </a:ext>
                    </a:extLst>
                  </p:cNvPr>
                  <p:cNvSpPr/>
                  <p:nvPr/>
                </p:nvSpPr>
                <p:spPr>
                  <a:xfrm>
                    <a:off x="1128855" y="4603505"/>
                    <a:ext cx="398381" cy="246221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OE</a:t>
                    </a:r>
                  </a:p>
                </p:txBody>
              </p:sp>
              <p:sp>
                <p:nvSpPr>
                  <p:cNvPr id="106" name="矩形 105">
                    <a:extLst>
                      <a:ext uri="{FF2B5EF4-FFF2-40B4-BE49-F238E27FC236}">
                        <a16:creationId xmlns:a16="http://schemas.microsoft.com/office/drawing/2014/main" id="{2D340DD0-6478-4EA9-97EC-9DCBC14BA99D}"/>
                      </a:ext>
                    </a:extLst>
                  </p:cNvPr>
                  <p:cNvSpPr/>
                  <p:nvPr/>
                </p:nvSpPr>
                <p:spPr>
                  <a:xfrm>
                    <a:off x="759509" y="4012247"/>
                    <a:ext cx="398381" cy="246221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0</a:t>
                    </a:r>
                  </a:p>
                </p:txBody>
              </p:sp>
              <p:sp>
                <p:nvSpPr>
                  <p:cNvPr id="107" name="矩形 106">
                    <a:extLst>
                      <a:ext uri="{FF2B5EF4-FFF2-40B4-BE49-F238E27FC236}">
                        <a16:creationId xmlns:a16="http://schemas.microsoft.com/office/drawing/2014/main" id="{7CB80A9D-D824-4D5A-BB44-62AAC89C4739}"/>
                      </a:ext>
                    </a:extLst>
                  </p:cNvPr>
                  <p:cNvSpPr/>
                  <p:nvPr/>
                </p:nvSpPr>
                <p:spPr>
                  <a:xfrm>
                    <a:off x="759508" y="3766026"/>
                    <a:ext cx="398381" cy="246221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0</a:t>
                    </a:r>
                  </a:p>
                </p:txBody>
              </p:sp>
              <p:sp>
                <p:nvSpPr>
                  <p:cNvPr id="108" name="矩形 107">
                    <a:extLst>
                      <a:ext uri="{FF2B5EF4-FFF2-40B4-BE49-F238E27FC236}">
                        <a16:creationId xmlns:a16="http://schemas.microsoft.com/office/drawing/2014/main" id="{98F8211B-A961-4A6B-8C50-2A930B7D75FC}"/>
                      </a:ext>
                    </a:extLst>
                  </p:cNvPr>
                  <p:cNvSpPr/>
                  <p:nvPr/>
                </p:nvSpPr>
                <p:spPr>
                  <a:xfrm>
                    <a:off x="759507" y="3524892"/>
                    <a:ext cx="398381" cy="246221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80</a:t>
                    </a:r>
                  </a:p>
                </p:txBody>
              </p:sp>
              <p:sp>
                <p:nvSpPr>
                  <p:cNvPr id="109" name="矩形 108">
                    <a:extLst>
                      <a:ext uri="{FF2B5EF4-FFF2-40B4-BE49-F238E27FC236}">
                        <a16:creationId xmlns:a16="http://schemas.microsoft.com/office/drawing/2014/main" id="{EECEBB29-536A-4DD3-8C9A-458BD8E10D97}"/>
                      </a:ext>
                    </a:extLst>
                  </p:cNvPr>
                  <p:cNvSpPr/>
                  <p:nvPr/>
                </p:nvSpPr>
                <p:spPr>
                  <a:xfrm>
                    <a:off x="689507" y="3278156"/>
                    <a:ext cx="398381" cy="246221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</a:t>
                    </a:r>
                  </a:p>
                </p:txBody>
              </p:sp>
              <p:sp>
                <p:nvSpPr>
                  <p:cNvPr id="110" name="矩形 109">
                    <a:extLst>
                      <a:ext uri="{FF2B5EF4-FFF2-40B4-BE49-F238E27FC236}">
                        <a16:creationId xmlns:a16="http://schemas.microsoft.com/office/drawing/2014/main" id="{0F323915-505B-4A9C-A410-B9E7CB45F0D8}"/>
                      </a:ext>
                    </a:extLst>
                  </p:cNvPr>
                  <p:cNvSpPr/>
                  <p:nvPr/>
                </p:nvSpPr>
                <p:spPr>
                  <a:xfrm>
                    <a:off x="1500866" y="4603504"/>
                    <a:ext cx="509528" cy="246221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trl</a:t>
                    </a:r>
                  </a:p>
                </p:txBody>
              </p:sp>
              <p:sp>
                <p:nvSpPr>
                  <p:cNvPr id="111" name="矩形 110">
                    <a:extLst>
                      <a:ext uri="{FF2B5EF4-FFF2-40B4-BE49-F238E27FC236}">
                        <a16:creationId xmlns:a16="http://schemas.microsoft.com/office/drawing/2014/main" id="{0C0A15F9-BD26-4E0E-A07A-8B0D10719323}"/>
                      </a:ext>
                    </a:extLst>
                  </p:cNvPr>
                  <p:cNvSpPr/>
                  <p:nvPr/>
                </p:nvSpPr>
                <p:spPr>
                  <a:xfrm>
                    <a:off x="1930848" y="4605914"/>
                    <a:ext cx="534553" cy="246221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h#1</a:t>
                    </a:r>
                  </a:p>
                </p:txBody>
              </p:sp>
              <p:sp>
                <p:nvSpPr>
                  <p:cNvPr id="112" name="矩形 111">
                    <a:extLst>
                      <a:ext uri="{FF2B5EF4-FFF2-40B4-BE49-F238E27FC236}">
                        <a16:creationId xmlns:a16="http://schemas.microsoft.com/office/drawing/2014/main" id="{4BFEAE82-89A3-41FD-81C5-970E240BBD1E}"/>
                      </a:ext>
                    </a:extLst>
                  </p:cNvPr>
                  <p:cNvSpPr/>
                  <p:nvPr/>
                </p:nvSpPr>
                <p:spPr>
                  <a:xfrm>
                    <a:off x="2357810" y="4598708"/>
                    <a:ext cx="534553" cy="246221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h#2</a:t>
                    </a:r>
                  </a:p>
                </p:txBody>
              </p:sp>
            </p:grpSp>
            <p:sp>
              <p:nvSpPr>
                <p:cNvPr id="115" name="矩形 114">
                  <a:extLst>
                    <a:ext uri="{FF2B5EF4-FFF2-40B4-BE49-F238E27FC236}">
                      <a16:creationId xmlns:a16="http://schemas.microsoft.com/office/drawing/2014/main" id="{C3CACE04-9BCA-4FF2-917C-67FF13B27BB7}"/>
                    </a:ext>
                  </a:extLst>
                </p:cNvPr>
                <p:cNvSpPr/>
                <p:nvPr/>
              </p:nvSpPr>
              <p:spPr>
                <a:xfrm>
                  <a:off x="1675831" y="3135399"/>
                  <a:ext cx="1037403" cy="246221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0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g1051E</a:t>
                  </a:r>
                  <a:endParaRPr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3" name="图片 2">
                <a:extLst>
                  <a:ext uri="{FF2B5EF4-FFF2-40B4-BE49-F238E27FC236}">
                    <a16:creationId xmlns:a16="http://schemas.microsoft.com/office/drawing/2014/main" id="{049916DE-319A-4DBC-A13E-1C5EA844C87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1016866" y="3563571"/>
                <a:ext cx="1856935" cy="1285200"/>
              </a:xfrm>
              <a:prstGeom prst="rect">
                <a:avLst/>
              </a:prstGeom>
            </p:spPr>
          </p:pic>
        </p:grpSp>
        <p:sp>
          <p:nvSpPr>
            <p:cNvPr id="137" name="文本框 136">
              <a:extLst>
                <a:ext uri="{FF2B5EF4-FFF2-40B4-BE49-F238E27FC236}">
                  <a16:creationId xmlns:a16="http://schemas.microsoft.com/office/drawing/2014/main" id="{777CC1D4-47BF-427C-A03A-6F87FA594EAF}"/>
                </a:ext>
              </a:extLst>
            </p:cNvPr>
            <p:cNvSpPr txBox="1"/>
            <p:nvPr/>
          </p:nvSpPr>
          <p:spPr>
            <a:xfrm>
              <a:off x="1396695" y="3501193"/>
              <a:ext cx="351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文本框 140">
              <a:extLst>
                <a:ext uri="{FF2B5EF4-FFF2-40B4-BE49-F238E27FC236}">
                  <a16:creationId xmlns:a16="http://schemas.microsoft.com/office/drawing/2014/main" id="{4D2BC355-ED49-4B42-BCC2-BF23198AEA62}"/>
                </a:ext>
              </a:extLst>
            </p:cNvPr>
            <p:cNvSpPr txBox="1"/>
            <p:nvPr/>
          </p:nvSpPr>
          <p:spPr>
            <a:xfrm>
              <a:off x="1772305" y="3651808"/>
              <a:ext cx="351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文本框 142">
              <a:extLst>
                <a:ext uri="{FF2B5EF4-FFF2-40B4-BE49-F238E27FC236}">
                  <a16:creationId xmlns:a16="http://schemas.microsoft.com/office/drawing/2014/main" id="{7ABC529B-0FBB-4BE8-89D7-F510628E37A5}"/>
                </a:ext>
              </a:extLst>
            </p:cNvPr>
            <p:cNvSpPr txBox="1"/>
            <p:nvPr/>
          </p:nvSpPr>
          <p:spPr>
            <a:xfrm>
              <a:off x="2004652" y="3802058"/>
              <a:ext cx="351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6" name="组合 145">
            <a:extLst>
              <a:ext uri="{FF2B5EF4-FFF2-40B4-BE49-F238E27FC236}">
                <a16:creationId xmlns:a16="http://schemas.microsoft.com/office/drawing/2014/main" id="{43E1B14D-03D4-4A0F-A317-8560C7181469}"/>
              </a:ext>
            </a:extLst>
          </p:cNvPr>
          <p:cNvGrpSpPr/>
          <p:nvPr/>
        </p:nvGrpSpPr>
        <p:grpSpPr>
          <a:xfrm>
            <a:off x="3173931" y="1014118"/>
            <a:ext cx="2309490" cy="1716736"/>
            <a:chOff x="3104038" y="3371555"/>
            <a:chExt cx="2309490" cy="1716736"/>
          </a:xfrm>
        </p:grpSpPr>
        <p:grpSp>
          <p:nvGrpSpPr>
            <p:cNvPr id="8" name="组合 7">
              <a:extLst>
                <a:ext uri="{FF2B5EF4-FFF2-40B4-BE49-F238E27FC236}">
                  <a16:creationId xmlns:a16="http://schemas.microsoft.com/office/drawing/2014/main" id="{5187F373-2BFB-478F-8F99-A082FDB9C803}"/>
                </a:ext>
              </a:extLst>
            </p:cNvPr>
            <p:cNvGrpSpPr/>
            <p:nvPr/>
          </p:nvGrpSpPr>
          <p:grpSpPr>
            <a:xfrm>
              <a:off x="3104038" y="3371555"/>
              <a:ext cx="2309490" cy="1716736"/>
              <a:chOff x="3104038" y="3371555"/>
              <a:chExt cx="2309490" cy="1716736"/>
            </a:xfrm>
          </p:grpSpPr>
          <p:grpSp>
            <p:nvGrpSpPr>
              <p:cNvPr id="117" name="组合 116">
                <a:extLst>
                  <a:ext uri="{FF2B5EF4-FFF2-40B4-BE49-F238E27FC236}">
                    <a16:creationId xmlns:a16="http://schemas.microsoft.com/office/drawing/2014/main" id="{A46DC426-A753-44EC-9C97-187A3392CBE9}"/>
                  </a:ext>
                </a:extLst>
              </p:cNvPr>
              <p:cNvGrpSpPr/>
              <p:nvPr/>
            </p:nvGrpSpPr>
            <p:grpSpPr>
              <a:xfrm>
                <a:off x="3104038" y="3371555"/>
                <a:ext cx="2309490" cy="1716736"/>
                <a:chOff x="582873" y="3135399"/>
                <a:chExt cx="2309490" cy="1716736"/>
              </a:xfrm>
            </p:grpSpPr>
            <p:grpSp>
              <p:nvGrpSpPr>
                <p:cNvPr id="120" name="组合 119">
                  <a:extLst>
                    <a:ext uri="{FF2B5EF4-FFF2-40B4-BE49-F238E27FC236}">
                      <a16:creationId xmlns:a16="http://schemas.microsoft.com/office/drawing/2014/main" id="{20C23AAF-B003-4F98-B9A2-618F8D439642}"/>
                    </a:ext>
                  </a:extLst>
                </p:cNvPr>
                <p:cNvGrpSpPr/>
                <p:nvPr/>
              </p:nvGrpSpPr>
              <p:grpSpPr>
                <a:xfrm>
                  <a:off x="582873" y="3278156"/>
                  <a:ext cx="2309490" cy="1573979"/>
                  <a:chOff x="582873" y="3278156"/>
                  <a:chExt cx="2309490" cy="1573979"/>
                </a:xfrm>
              </p:grpSpPr>
              <p:sp>
                <p:nvSpPr>
                  <p:cNvPr id="122" name="矩形 121">
                    <a:extLst>
                      <a:ext uri="{FF2B5EF4-FFF2-40B4-BE49-F238E27FC236}">
                        <a16:creationId xmlns:a16="http://schemas.microsoft.com/office/drawing/2014/main" id="{C785DAE5-389E-407F-AE38-73EEBD2C48FC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57864" y="3853916"/>
                    <a:ext cx="1296240" cy="246221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LAGL1/B-Actin(%)</a:t>
                    </a:r>
                    <a:endParaRPr lang="zh-CN" altLang="en-U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3" name="矩形 122">
                    <a:extLst>
                      <a:ext uri="{FF2B5EF4-FFF2-40B4-BE49-F238E27FC236}">
                        <a16:creationId xmlns:a16="http://schemas.microsoft.com/office/drawing/2014/main" id="{7F06E83D-0A97-415D-900A-D4573219E9CC}"/>
                      </a:ext>
                    </a:extLst>
                  </p:cNvPr>
                  <p:cNvSpPr/>
                  <p:nvPr/>
                </p:nvSpPr>
                <p:spPr>
                  <a:xfrm>
                    <a:off x="759510" y="4254792"/>
                    <a:ext cx="398381" cy="246221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</a:t>
                    </a:r>
                  </a:p>
                </p:txBody>
              </p:sp>
              <p:sp>
                <p:nvSpPr>
                  <p:cNvPr id="124" name="矩形 123">
                    <a:extLst>
                      <a:ext uri="{FF2B5EF4-FFF2-40B4-BE49-F238E27FC236}">
                        <a16:creationId xmlns:a16="http://schemas.microsoft.com/office/drawing/2014/main" id="{981B7E63-7F0D-4174-A3BC-491E98C6C2CD}"/>
                      </a:ext>
                    </a:extLst>
                  </p:cNvPr>
                  <p:cNvSpPr/>
                  <p:nvPr/>
                </p:nvSpPr>
                <p:spPr>
                  <a:xfrm>
                    <a:off x="829962" y="4499507"/>
                    <a:ext cx="398381" cy="246221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</a:t>
                    </a:r>
                  </a:p>
                </p:txBody>
              </p:sp>
              <p:sp>
                <p:nvSpPr>
                  <p:cNvPr id="125" name="矩形 124">
                    <a:extLst>
                      <a:ext uri="{FF2B5EF4-FFF2-40B4-BE49-F238E27FC236}">
                        <a16:creationId xmlns:a16="http://schemas.microsoft.com/office/drawing/2014/main" id="{49A5C596-765D-4106-9F34-438BB40D1B11}"/>
                      </a:ext>
                    </a:extLst>
                  </p:cNvPr>
                  <p:cNvSpPr/>
                  <p:nvPr/>
                </p:nvSpPr>
                <p:spPr>
                  <a:xfrm>
                    <a:off x="1128855" y="4603505"/>
                    <a:ext cx="398381" cy="246221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OE</a:t>
                    </a:r>
                  </a:p>
                </p:txBody>
              </p:sp>
              <p:sp>
                <p:nvSpPr>
                  <p:cNvPr id="126" name="矩形 125">
                    <a:extLst>
                      <a:ext uri="{FF2B5EF4-FFF2-40B4-BE49-F238E27FC236}">
                        <a16:creationId xmlns:a16="http://schemas.microsoft.com/office/drawing/2014/main" id="{569A6132-6EA5-4B43-B974-6864ED6A7D05}"/>
                      </a:ext>
                    </a:extLst>
                  </p:cNvPr>
                  <p:cNvSpPr/>
                  <p:nvPr/>
                </p:nvSpPr>
                <p:spPr>
                  <a:xfrm>
                    <a:off x="759509" y="4012247"/>
                    <a:ext cx="398381" cy="246221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0</a:t>
                    </a:r>
                  </a:p>
                </p:txBody>
              </p:sp>
              <p:sp>
                <p:nvSpPr>
                  <p:cNvPr id="127" name="矩形 126">
                    <a:extLst>
                      <a:ext uri="{FF2B5EF4-FFF2-40B4-BE49-F238E27FC236}">
                        <a16:creationId xmlns:a16="http://schemas.microsoft.com/office/drawing/2014/main" id="{82506745-534D-4FC8-AC7E-6EBBDC68F932}"/>
                      </a:ext>
                    </a:extLst>
                  </p:cNvPr>
                  <p:cNvSpPr/>
                  <p:nvPr/>
                </p:nvSpPr>
                <p:spPr>
                  <a:xfrm>
                    <a:off x="759508" y="3766026"/>
                    <a:ext cx="398381" cy="246221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0</a:t>
                    </a:r>
                  </a:p>
                </p:txBody>
              </p:sp>
              <p:sp>
                <p:nvSpPr>
                  <p:cNvPr id="128" name="矩形 127">
                    <a:extLst>
                      <a:ext uri="{FF2B5EF4-FFF2-40B4-BE49-F238E27FC236}">
                        <a16:creationId xmlns:a16="http://schemas.microsoft.com/office/drawing/2014/main" id="{77947073-290B-4724-A149-00A85EF5490E}"/>
                      </a:ext>
                    </a:extLst>
                  </p:cNvPr>
                  <p:cNvSpPr/>
                  <p:nvPr/>
                </p:nvSpPr>
                <p:spPr>
                  <a:xfrm>
                    <a:off x="759507" y="3524892"/>
                    <a:ext cx="398381" cy="246221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80</a:t>
                    </a:r>
                  </a:p>
                </p:txBody>
              </p:sp>
              <p:sp>
                <p:nvSpPr>
                  <p:cNvPr id="129" name="矩形 128">
                    <a:extLst>
                      <a:ext uri="{FF2B5EF4-FFF2-40B4-BE49-F238E27FC236}">
                        <a16:creationId xmlns:a16="http://schemas.microsoft.com/office/drawing/2014/main" id="{08A09701-E17C-443E-BAB3-5C9DC5C0A81B}"/>
                      </a:ext>
                    </a:extLst>
                  </p:cNvPr>
                  <p:cNvSpPr/>
                  <p:nvPr/>
                </p:nvSpPr>
                <p:spPr>
                  <a:xfrm>
                    <a:off x="689507" y="3278156"/>
                    <a:ext cx="398381" cy="246221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</a:t>
                    </a:r>
                  </a:p>
                </p:txBody>
              </p:sp>
              <p:sp>
                <p:nvSpPr>
                  <p:cNvPr id="130" name="矩形 129">
                    <a:extLst>
                      <a:ext uri="{FF2B5EF4-FFF2-40B4-BE49-F238E27FC236}">
                        <a16:creationId xmlns:a16="http://schemas.microsoft.com/office/drawing/2014/main" id="{74E37A0F-2DEB-421B-8846-08CE1186DD1B}"/>
                      </a:ext>
                    </a:extLst>
                  </p:cNvPr>
                  <p:cNvSpPr/>
                  <p:nvPr/>
                </p:nvSpPr>
                <p:spPr>
                  <a:xfrm>
                    <a:off x="1500866" y="4603504"/>
                    <a:ext cx="509528" cy="246221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trl</a:t>
                    </a:r>
                  </a:p>
                </p:txBody>
              </p:sp>
              <p:sp>
                <p:nvSpPr>
                  <p:cNvPr id="131" name="矩形 130">
                    <a:extLst>
                      <a:ext uri="{FF2B5EF4-FFF2-40B4-BE49-F238E27FC236}">
                        <a16:creationId xmlns:a16="http://schemas.microsoft.com/office/drawing/2014/main" id="{2B5A4C72-E1E1-456B-BE8B-DCA87093F90A}"/>
                      </a:ext>
                    </a:extLst>
                  </p:cNvPr>
                  <p:cNvSpPr/>
                  <p:nvPr/>
                </p:nvSpPr>
                <p:spPr>
                  <a:xfrm>
                    <a:off x="1930848" y="4605914"/>
                    <a:ext cx="534553" cy="246221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h#1</a:t>
                    </a:r>
                  </a:p>
                </p:txBody>
              </p:sp>
              <p:sp>
                <p:nvSpPr>
                  <p:cNvPr id="132" name="矩形 131">
                    <a:extLst>
                      <a:ext uri="{FF2B5EF4-FFF2-40B4-BE49-F238E27FC236}">
                        <a16:creationId xmlns:a16="http://schemas.microsoft.com/office/drawing/2014/main" id="{5DA7C7FD-5700-49E1-943F-99588F90F1D6}"/>
                      </a:ext>
                    </a:extLst>
                  </p:cNvPr>
                  <p:cNvSpPr/>
                  <p:nvPr/>
                </p:nvSpPr>
                <p:spPr>
                  <a:xfrm>
                    <a:off x="2357810" y="4598708"/>
                    <a:ext cx="534553" cy="246221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h#2</a:t>
                    </a:r>
                  </a:p>
                </p:txBody>
              </p:sp>
            </p:grpSp>
            <p:sp>
              <p:nvSpPr>
                <p:cNvPr id="119" name="矩形 118">
                  <a:extLst>
                    <a:ext uri="{FF2B5EF4-FFF2-40B4-BE49-F238E27FC236}">
                      <a16:creationId xmlns:a16="http://schemas.microsoft.com/office/drawing/2014/main" id="{88983BFE-F833-4D7B-970A-7D3B014485CF}"/>
                    </a:ext>
                  </a:extLst>
                </p:cNvPr>
                <p:cNvSpPr/>
                <p:nvPr/>
              </p:nvSpPr>
              <p:spPr>
                <a:xfrm>
                  <a:off x="1675831" y="3135399"/>
                  <a:ext cx="1037403" cy="246221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0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g101027E</a:t>
                  </a:r>
                  <a:endParaRPr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A929591F-7259-4919-8E59-99CA1291DE4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542525" y="3559859"/>
                <a:ext cx="1856935" cy="1285200"/>
              </a:xfrm>
              <a:prstGeom prst="rect">
                <a:avLst/>
              </a:prstGeom>
            </p:spPr>
          </p:pic>
        </p:grpSp>
        <p:sp>
          <p:nvSpPr>
            <p:cNvPr id="121" name="文本框 120">
              <a:extLst>
                <a:ext uri="{FF2B5EF4-FFF2-40B4-BE49-F238E27FC236}">
                  <a16:creationId xmlns:a16="http://schemas.microsoft.com/office/drawing/2014/main" id="{2D69AEBF-5EC0-4D1D-AA9B-C89DBCF075CD}"/>
                </a:ext>
              </a:extLst>
            </p:cNvPr>
            <p:cNvSpPr txBox="1"/>
            <p:nvPr/>
          </p:nvSpPr>
          <p:spPr>
            <a:xfrm>
              <a:off x="3949392" y="3425843"/>
              <a:ext cx="351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文本框 138">
              <a:extLst>
                <a:ext uri="{FF2B5EF4-FFF2-40B4-BE49-F238E27FC236}">
                  <a16:creationId xmlns:a16="http://schemas.microsoft.com/office/drawing/2014/main" id="{52DD7420-A87C-4CFB-95FC-AC7F971D7E3F}"/>
                </a:ext>
              </a:extLst>
            </p:cNvPr>
            <p:cNvSpPr txBox="1"/>
            <p:nvPr/>
          </p:nvSpPr>
          <p:spPr>
            <a:xfrm>
              <a:off x="4503881" y="3847640"/>
              <a:ext cx="351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文本框 144">
              <a:extLst>
                <a:ext uri="{FF2B5EF4-FFF2-40B4-BE49-F238E27FC236}">
                  <a16:creationId xmlns:a16="http://schemas.microsoft.com/office/drawing/2014/main" id="{3F2BB0D4-DDA1-4C6A-94E0-3ADE0E38E30C}"/>
                </a:ext>
              </a:extLst>
            </p:cNvPr>
            <p:cNvSpPr txBox="1"/>
            <p:nvPr/>
          </p:nvSpPr>
          <p:spPr>
            <a:xfrm>
              <a:off x="4310409" y="3702893"/>
              <a:ext cx="351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3" name="文本框 152">
            <a:extLst>
              <a:ext uri="{FF2B5EF4-FFF2-40B4-BE49-F238E27FC236}">
                <a16:creationId xmlns:a16="http://schemas.microsoft.com/office/drawing/2014/main" id="{D71C9020-04C7-4F59-BBB0-8BE2DBD26BD3}"/>
              </a:ext>
            </a:extLst>
          </p:cNvPr>
          <p:cNvSpPr txBox="1"/>
          <p:nvPr/>
        </p:nvSpPr>
        <p:spPr>
          <a:xfrm>
            <a:off x="170242" y="782991"/>
            <a:ext cx="46217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A</a:t>
            </a:r>
          </a:p>
        </p:txBody>
      </p:sp>
      <p:grpSp>
        <p:nvGrpSpPr>
          <p:cNvPr id="114" name="组合 113">
            <a:extLst>
              <a:ext uri="{FF2B5EF4-FFF2-40B4-BE49-F238E27FC236}">
                <a16:creationId xmlns:a16="http://schemas.microsoft.com/office/drawing/2014/main" id="{405540DB-B723-42D4-A905-55160DD70B5B}"/>
              </a:ext>
            </a:extLst>
          </p:cNvPr>
          <p:cNvGrpSpPr/>
          <p:nvPr/>
        </p:nvGrpSpPr>
        <p:grpSpPr>
          <a:xfrm>
            <a:off x="3516981" y="3359071"/>
            <a:ext cx="3078956" cy="1800000"/>
            <a:chOff x="500062" y="921544"/>
            <a:chExt cx="3078956" cy="1800000"/>
          </a:xfrm>
        </p:grpSpPr>
        <p:pic>
          <p:nvPicPr>
            <p:cNvPr id="118" name="图片 117">
              <a:extLst>
                <a:ext uri="{FF2B5EF4-FFF2-40B4-BE49-F238E27FC236}">
                  <a16:creationId xmlns:a16="http://schemas.microsoft.com/office/drawing/2014/main" id="{4F4A9FB2-B457-4323-A618-4494DD3E12E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20" t="68094" r="52084" b="2478"/>
            <a:stretch/>
          </p:blipFill>
          <p:spPr>
            <a:xfrm>
              <a:off x="500062" y="921544"/>
              <a:ext cx="2741344" cy="1800000"/>
            </a:xfrm>
            <a:prstGeom prst="rect">
              <a:avLst/>
            </a:prstGeom>
          </p:spPr>
        </p:pic>
        <p:grpSp>
          <p:nvGrpSpPr>
            <p:cNvPr id="133" name="组合 132">
              <a:extLst>
                <a:ext uri="{FF2B5EF4-FFF2-40B4-BE49-F238E27FC236}">
                  <a16:creationId xmlns:a16="http://schemas.microsoft.com/office/drawing/2014/main" id="{A90E697A-207D-4BBA-BE43-FF29C424925C}"/>
                </a:ext>
              </a:extLst>
            </p:cNvPr>
            <p:cNvGrpSpPr/>
            <p:nvPr/>
          </p:nvGrpSpPr>
          <p:grpSpPr>
            <a:xfrm>
              <a:off x="3075239" y="1248948"/>
              <a:ext cx="503779" cy="515519"/>
              <a:chOff x="4104087" y="2408794"/>
              <a:chExt cx="503779" cy="515519"/>
            </a:xfrm>
          </p:grpSpPr>
          <p:cxnSp>
            <p:nvCxnSpPr>
              <p:cNvPr id="134" name="直接连接符 133">
                <a:extLst>
                  <a:ext uri="{FF2B5EF4-FFF2-40B4-BE49-F238E27FC236}">
                    <a16:creationId xmlns:a16="http://schemas.microsoft.com/office/drawing/2014/main" id="{DCCF3FAB-876A-4A5A-9351-73F3F146F2A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73364" y="2408794"/>
                <a:ext cx="0" cy="241963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5" name="文本框 134">
                <a:extLst>
                  <a:ext uri="{FF2B5EF4-FFF2-40B4-BE49-F238E27FC236}">
                    <a16:creationId xmlns:a16="http://schemas.microsoft.com/office/drawing/2014/main" id="{EB42D63B-97A0-4AE8-966F-2C651A0886C2}"/>
                  </a:ext>
                </a:extLst>
              </p:cNvPr>
              <p:cNvSpPr txBox="1"/>
              <p:nvPr/>
            </p:nvSpPr>
            <p:spPr>
              <a:xfrm>
                <a:off x="4104087" y="2473136"/>
                <a:ext cx="338554" cy="190069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36" name="直接连接符 135">
                <a:extLst>
                  <a:ext uri="{FF2B5EF4-FFF2-40B4-BE49-F238E27FC236}">
                    <a16:creationId xmlns:a16="http://schemas.microsoft.com/office/drawing/2014/main" id="{19DD3E5A-E0DD-4277-990C-9B0ABEE7131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343300" y="2571522"/>
                <a:ext cx="0" cy="241963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8" name="文本框 137">
                <a:extLst>
                  <a:ext uri="{FF2B5EF4-FFF2-40B4-BE49-F238E27FC236}">
                    <a16:creationId xmlns:a16="http://schemas.microsoft.com/office/drawing/2014/main" id="{2A925BB8-B0EA-4ED6-9C43-01B39D4DB208}"/>
                  </a:ext>
                </a:extLst>
              </p:cNvPr>
              <p:cNvSpPr txBox="1"/>
              <p:nvPr/>
            </p:nvSpPr>
            <p:spPr>
              <a:xfrm>
                <a:off x="4174023" y="2635864"/>
                <a:ext cx="338554" cy="190069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40" name="直接连接符 139">
                <a:extLst>
                  <a:ext uri="{FF2B5EF4-FFF2-40B4-BE49-F238E27FC236}">
                    <a16:creationId xmlns:a16="http://schemas.microsoft.com/office/drawing/2014/main" id="{28047CD0-C97E-4DF6-8DFE-E2FD56CBD82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23020" y="2564313"/>
                <a:ext cx="0" cy="36000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2" name="文本框 141">
                <a:extLst>
                  <a:ext uri="{FF2B5EF4-FFF2-40B4-BE49-F238E27FC236}">
                    <a16:creationId xmlns:a16="http://schemas.microsoft.com/office/drawing/2014/main" id="{BCEB6146-8DCA-45FE-82F6-81E286C90FC9}"/>
                  </a:ext>
                </a:extLst>
              </p:cNvPr>
              <p:cNvSpPr txBox="1"/>
              <p:nvPr/>
            </p:nvSpPr>
            <p:spPr>
              <a:xfrm>
                <a:off x="4269312" y="2646482"/>
                <a:ext cx="338554" cy="190069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44" name="组合 143">
            <a:extLst>
              <a:ext uri="{FF2B5EF4-FFF2-40B4-BE49-F238E27FC236}">
                <a16:creationId xmlns:a16="http://schemas.microsoft.com/office/drawing/2014/main" id="{31E911EB-FC8C-4B3E-923D-335BDA1E359B}"/>
              </a:ext>
            </a:extLst>
          </p:cNvPr>
          <p:cNvGrpSpPr/>
          <p:nvPr/>
        </p:nvGrpSpPr>
        <p:grpSpPr>
          <a:xfrm>
            <a:off x="316570" y="3359071"/>
            <a:ext cx="3080816" cy="1800000"/>
            <a:chOff x="500061" y="3350421"/>
            <a:chExt cx="3080816" cy="1800000"/>
          </a:xfrm>
        </p:grpSpPr>
        <p:pic>
          <p:nvPicPr>
            <p:cNvPr id="148" name="图片 147">
              <a:extLst>
                <a:ext uri="{FF2B5EF4-FFF2-40B4-BE49-F238E27FC236}">
                  <a16:creationId xmlns:a16="http://schemas.microsoft.com/office/drawing/2014/main" id="{FACA2E10-21BD-4F18-9A08-A0ABFEBB18F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327" t="68198" r="2777" b="2374"/>
            <a:stretch/>
          </p:blipFill>
          <p:spPr>
            <a:xfrm>
              <a:off x="500061" y="3350421"/>
              <a:ext cx="2741344" cy="1800000"/>
            </a:xfrm>
            <a:prstGeom prst="rect">
              <a:avLst/>
            </a:prstGeom>
          </p:spPr>
        </p:pic>
        <p:grpSp>
          <p:nvGrpSpPr>
            <p:cNvPr id="149" name="组合 148">
              <a:extLst>
                <a:ext uri="{FF2B5EF4-FFF2-40B4-BE49-F238E27FC236}">
                  <a16:creationId xmlns:a16="http://schemas.microsoft.com/office/drawing/2014/main" id="{62C02421-51B2-41FB-93D3-BFB777EA07CF}"/>
                </a:ext>
              </a:extLst>
            </p:cNvPr>
            <p:cNvGrpSpPr/>
            <p:nvPr/>
          </p:nvGrpSpPr>
          <p:grpSpPr>
            <a:xfrm>
              <a:off x="3077098" y="3691454"/>
              <a:ext cx="503779" cy="515519"/>
              <a:chOff x="4104087" y="2408794"/>
              <a:chExt cx="503779" cy="515519"/>
            </a:xfrm>
          </p:grpSpPr>
          <p:cxnSp>
            <p:nvCxnSpPr>
              <p:cNvPr id="150" name="直接连接符 149">
                <a:extLst>
                  <a:ext uri="{FF2B5EF4-FFF2-40B4-BE49-F238E27FC236}">
                    <a16:creationId xmlns:a16="http://schemas.microsoft.com/office/drawing/2014/main" id="{5E35E088-50F5-4789-B4F8-C8AC6A3ED7F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73364" y="2408794"/>
                <a:ext cx="0" cy="241963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51" name="文本框 150">
                <a:extLst>
                  <a:ext uri="{FF2B5EF4-FFF2-40B4-BE49-F238E27FC236}">
                    <a16:creationId xmlns:a16="http://schemas.microsoft.com/office/drawing/2014/main" id="{C7FA534F-3DBD-4FF3-A581-6A20A95C4621}"/>
                  </a:ext>
                </a:extLst>
              </p:cNvPr>
              <p:cNvSpPr txBox="1"/>
              <p:nvPr/>
            </p:nvSpPr>
            <p:spPr>
              <a:xfrm>
                <a:off x="4104087" y="2473136"/>
                <a:ext cx="338554" cy="190069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52" name="直接连接符 151">
                <a:extLst>
                  <a:ext uri="{FF2B5EF4-FFF2-40B4-BE49-F238E27FC236}">
                    <a16:creationId xmlns:a16="http://schemas.microsoft.com/office/drawing/2014/main" id="{C9FD5BCF-A2EB-4CC4-BE8D-274A4BBA037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343300" y="2571522"/>
                <a:ext cx="0" cy="241963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54" name="文本框 153">
                <a:extLst>
                  <a:ext uri="{FF2B5EF4-FFF2-40B4-BE49-F238E27FC236}">
                    <a16:creationId xmlns:a16="http://schemas.microsoft.com/office/drawing/2014/main" id="{D9CE9E73-7CB0-4953-8AEE-F7A33A80A4F7}"/>
                  </a:ext>
                </a:extLst>
              </p:cNvPr>
              <p:cNvSpPr txBox="1"/>
              <p:nvPr/>
            </p:nvSpPr>
            <p:spPr>
              <a:xfrm>
                <a:off x="4174023" y="2635864"/>
                <a:ext cx="338554" cy="190069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55" name="直接连接符 154">
                <a:extLst>
                  <a:ext uri="{FF2B5EF4-FFF2-40B4-BE49-F238E27FC236}">
                    <a16:creationId xmlns:a16="http://schemas.microsoft.com/office/drawing/2014/main" id="{B9498B67-FDA6-41F6-8C35-A08FE18694F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23020" y="2564313"/>
                <a:ext cx="0" cy="36000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56" name="文本框 155">
                <a:extLst>
                  <a:ext uri="{FF2B5EF4-FFF2-40B4-BE49-F238E27FC236}">
                    <a16:creationId xmlns:a16="http://schemas.microsoft.com/office/drawing/2014/main" id="{7ADB7089-ACFF-4078-8C17-8568D6DC29A3}"/>
                  </a:ext>
                </a:extLst>
              </p:cNvPr>
              <p:cNvSpPr txBox="1"/>
              <p:nvPr/>
            </p:nvSpPr>
            <p:spPr>
              <a:xfrm>
                <a:off x="4269312" y="2646482"/>
                <a:ext cx="338554" cy="190069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2" name="文本框 1">
            <a:extLst>
              <a:ext uri="{FF2B5EF4-FFF2-40B4-BE49-F238E27FC236}">
                <a16:creationId xmlns:a16="http://schemas.microsoft.com/office/drawing/2014/main" id="{717E2528-FA56-4C83-AE58-2B30CDE44EB1}"/>
              </a:ext>
            </a:extLst>
          </p:cNvPr>
          <p:cNvSpPr txBox="1"/>
          <p:nvPr/>
        </p:nvSpPr>
        <p:spPr>
          <a:xfrm>
            <a:off x="224998" y="2801037"/>
            <a:ext cx="46217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428795105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副标题 2">
            <a:extLst>
              <a:ext uri="{FF2B5EF4-FFF2-40B4-BE49-F238E27FC236}">
                <a16:creationId xmlns:a16="http://schemas.microsoft.com/office/drawing/2014/main" id="{D90E6C4C-0811-4F54-AC55-9D6F73A46276}"/>
              </a:ext>
            </a:extLst>
          </p:cNvPr>
          <p:cNvSpPr txBox="1">
            <a:spLocks/>
          </p:cNvSpPr>
          <p:nvPr/>
        </p:nvSpPr>
        <p:spPr>
          <a:xfrm>
            <a:off x="155105" y="152564"/>
            <a:ext cx="3173883" cy="46750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.6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" name="组合 21">
            <a:extLst>
              <a:ext uri="{FF2B5EF4-FFF2-40B4-BE49-F238E27FC236}">
                <a16:creationId xmlns:a16="http://schemas.microsoft.com/office/drawing/2014/main" id="{DD9AFFB1-1B54-4517-AC5E-BAAA68691D99}"/>
              </a:ext>
            </a:extLst>
          </p:cNvPr>
          <p:cNvGrpSpPr/>
          <p:nvPr/>
        </p:nvGrpSpPr>
        <p:grpSpPr>
          <a:xfrm>
            <a:off x="90811" y="1050450"/>
            <a:ext cx="3018826" cy="3112959"/>
            <a:chOff x="88647" y="3207379"/>
            <a:chExt cx="3018826" cy="3112959"/>
          </a:xfrm>
        </p:grpSpPr>
        <p:grpSp>
          <p:nvGrpSpPr>
            <p:cNvPr id="23" name="组合 22">
              <a:extLst>
                <a:ext uri="{FF2B5EF4-FFF2-40B4-BE49-F238E27FC236}">
                  <a16:creationId xmlns:a16="http://schemas.microsoft.com/office/drawing/2014/main" id="{722C74D2-9B69-436B-B2DF-D1B909F01938}"/>
                </a:ext>
              </a:extLst>
            </p:cNvPr>
            <p:cNvGrpSpPr/>
            <p:nvPr/>
          </p:nvGrpSpPr>
          <p:grpSpPr>
            <a:xfrm>
              <a:off x="772190" y="3429000"/>
              <a:ext cx="2223580" cy="706740"/>
              <a:chOff x="772190" y="3429000"/>
              <a:chExt cx="2223580" cy="706740"/>
            </a:xfrm>
          </p:grpSpPr>
          <p:pic>
            <p:nvPicPr>
              <p:cNvPr id="61" name="图片 60">
                <a:extLst>
                  <a:ext uri="{FF2B5EF4-FFF2-40B4-BE49-F238E27FC236}">
                    <a16:creationId xmlns:a16="http://schemas.microsoft.com/office/drawing/2014/main" id="{733FC82D-E30C-4186-A942-CC7E6835719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772190" y="3429000"/>
                <a:ext cx="957603" cy="695402"/>
              </a:xfrm>
              <a:prstGeom prst="rect">
                <a:avLst/>
              </a:prstGeom>
            </p:spPr>
          </p:pic>
          <p:pic>
            <p:nvPicPr>
              <p:cNvPr id="62" name="图片 61">
                <a:extLst>
                  <a:ext uri="{FF2B5EF4-FFF2-40B4-BE49-F238E27FC236}">
                    <a16:creationId xmlns:a16="http://schemas.microsoft.com/office/drawing/2014/main" id="{DE0E7B09-92BA-4864-81D6-5205880D4A2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1759066" y="3440338"/>
                <a:ext cx="957603" cy="695402"/>
              </a:xfrm>
              <a:prstGeom prst="rect">
                <a:avLst/>
              </a:prstGeom>
            </p:spPr>
          </p:pic>
          <p:grpSp>
            <p:nvGrpSpPr>
              <p:cNvPr id="63" name="组合 62">
                <a:extLst>
                  <a:ext uri="{FF2B5EF4-FFF2-40B4-BE49-F238E27FC236}">
                    <a16:creationId xmlns:a16="http://schemas.microsoft.com/office/drawing/2014/main" id="{BE5CC6E9-0EA9-4937-BFBC-7E3C8E649B58}"/>
                  </a:ext>
                </a:extLst>
              </p:cNvPr>
              <p:cNvGrpSpPr/>
              <p:nvPr/>
            </p:nvGrpSpPr>
            <p:grpSpPr>
              <a:xfrm>
                <a:off x="2220403" y="3864662"/>
                <a:ext cx="775367" cy="246221"/>
                <a:chOff x="7452596" y="2864931"/>
                <a:chExt cx="1605586" cy="509861"/>
              </a:xfrm>
            </p:grpSpPr>
            <p:cxnSp>
              <p:nvCxnSpPr>
                <p:cNvPr id="67" name="直接连接符 66">
                  <a:extLst>
                    <a:ext uri="{FF2B5EF4-FFF2-40B4-BE49-F238E27FC236}">
                      <a16:creationId xmlns:a16="http://schemas.microsoft.com/office/drawing/2014/main" id="{03953A40-330B-4266-AEF6-2F59CE45A577}"/>
                    </a:ext>
                  </a:extLst>
                </p:cNvPr>
                <p:cNvCxnSpPr/>
                <p:nvPr/>
              </p:nvCxnSpPr>
              <p:spPr>
                <a:xfrm>
                  <a:off x="7897506" y="3294797"/>
                  <a:ext cx="5220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8" name="文本框 67">
                  <a:extLst>
                    <a:ext uri="{FF2B5EF4-FFF2-40B4-BE49-F238E27FC236}">
                      <a16:creationId xmlns:a16="http://schemas.microsoft.com/office/drawing/2014/main" id="{44D2723A-CFC4-4339-ACB2-79F92A7B8F5C}"/>
                    </a:ext>
                  </a:extLst>
                </p:cNvPr>
                <p:cNvSpPr txBox="1"/>
                <p:nvPr/>
              </p:nvSpPr>
              <p:spPr>
                <a:xfrm>
                  <a:off x="7452596" y="2864931"/>
                  <a:ext cx="1605586" cy="50986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um</a:t>
                  </a:r>
                  <a:endParaRPr lang="zh-CN" alt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64" name="矩形 63">
                <a:extLst>
                  <a:ext uri="{FF2B5EF4-FFF2-40B4-BE49-F238E27FC236}">
                    <a16:creationId xmlns:a16="http://schemas.microsoft.com/office/drawing/2014/main" id="{9092849A-7B5B-481A-87BE-B5F3B5433447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400130" y="3799692"/>
                <a:ext cx="95618" cy="70828"/>
              </a:xfrm>
              <a:prstGeom prst="rect">
                <a:avLst/>
              </a:prstGeom>
              <a:noFill/>
              <a:ln w="25400" cmpd="sng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cxnSp>
            <p:nvCxnSpPr>
              <p:cNvPr id="65" name="直接连接符 64">
                <a:extLst>
                  <a:ext uri="{FF2B5EF4-FFF2-40B4-BE49-F238E27FC236}">
                    <a16:creationId xmlns:a16="http://schemas.microsoft.com/office/drawing/2014/main" id="{8C0830FF-7F72-4920-8360-0E78A81370E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494850" y="3429000"/>
                <a:ext cx="264215" cy="370692"/>
              </a:xfrm>
              <a:prstGeom prst="line">
                <a:avLst/>
              </a:prstGeom>
              <a:ln w="12700">
                <a:solidFill>
                  <a:srgbClr val="2F528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直接连接符 65">
                <a:extLst>
                  <a:ext uri="{FF2B5EF4-FFF2-40B4-BE49-F238E27FC236}">
                    <a16:creationId xmlns:a16="http://schemas.microsoft.com/office/drawing/2014/main" id="{D6BF9FFB-E0DC-4588-9BB5-73D8547987A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04680" y="3872102"/>
                <a:ext cx="254385" cy="261229"/>
              </a:xfrm>
              <a:prstGeom prst="line">
                <a:avLst/>
              </a:prstGeom>
              <a:ln w="12700">
                <a:solidFill>
                  <a:srgbClr val="2F528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4" name="组合 23">
              <a:extLst>
                <a:ext uri="{FF2B5EF4-FFF2-40B4-BE49-F238E27FC236}">
                  <a16:creationId xmlns:a16="http://schemas.microsoft.com/office/drawing/2014/main" id="{0CBC6D99-6E3B-4184-8FEB-596C8E7072B9}"/>
                </a:ext>
              </a:extLst>
            </p:cNvPr>
            <p:cNvGrpSpPr/>
            <p:nvPr/>
          </p:nvGrpSpPr>
          <p:grpSpPr>
            <a:xfrm>
              <a:off x="772191" y="4162869"/>
              <a:ext cx="1944479" cy="701071"/>
              <a:chOff x="772191" y="4162869"/>
              <a:chExt cx="1944479" cy="701071"/>
            </a:xfrm>
          </p:grpSpPr>
          <p:pic>
            <p:nvPicPr>
              <p:cNvPr id="48" name="图片 47">
                <a:extLst>
                  <a:ext uri="{FF2B5EF4-FFF2-40B4-BE49-F238E27FC236}">
                    <a16:creationId xmlns:a16="http://schemas.microsoft.com/office/drawing/2014/main" id="{1C763A04-D3F0-46B2-8009-F6ABA928902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t="-1294"/>
              <a:stretch/>
            </p:blipFill>
            <p:spPr>
              <a:xfrm>
                <a:off x="772191" y="4168538"/>
                <a:ext cx="957603" cy="695402"/>
              </a:xfrm>
              <a:prstGeom prst="rect">
                <a:avLst/>
              </a:prstGeom>
            </p:spPr>
          </p:pic>
          <p:pic>
            <p:nvPicPr>
              <p:cNvPr id="49" name="图片 48">
                <a:extLst>
                  <a:ext uri="{FF2B5EF4-FFF2-40B4-BE49-F238E27FC236}">
                    <a16:creationId xmlns:a16="http://schemas.microsoft.com/office/drawing/2014/main" id="{720F3903-727D-4517-B3A5-8F291F7CA9E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1759066" y="4168538"/>
                <a:ext cx="957604" cy="695402"/>
              </a:xfrm>
              <a:prstGeom prst="rect">
                <a:avLst/>
              </a:prstGeom>
            </p:spPr>
          </p:pic>
          <p:cxnSp>
            <p:nvCxnSpPr>
              <p:cNvPr id="50" name="直接连接符 49">
                <a:extLst>
                  <a:ext uri="{FF2B5EF4-FFF2-40B4-BE49-F238E27FC236}">
                    <a16:creationId xmlns:a16="http://schemas.microsoft.com/office/drawing/2014/main" id="{101D7D8B-22E1-48C7-A7E3-0A2DA5652474}"/>
                  </a:ext>
                </a:extLst>
              </p:cNvPr>
              <p:cNvCxnSpPr/>
              <p:nvPr/>
            </p:nvCxnSpPr>
            <p:spPr>
              <a:xfrm>
                <a:off x="2435258" y="4812814"/>
                <a:ext cx="252083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" name="矩形 50">
                <a:extLst>
                  <a:ext uri="{FF2B5EF4-FFF2-40B4-BE49-F238E27FC236}">
                    <a16:creationId xmlns:a16="http://schemas.microsoft.com/office/drawing/2014/main" id="{83578BB7-83B4-4E13-A77D-7F9B09C9774A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425710" y="4631517"/>
                <a:ext cx="95618" cy="70828"/>
              </a:xfrm>
              <a:prstGeom prst="rect">
                <a:avLst/>
              </a:prstGeom>
              <a:noFill/>
              <a:ln w="25400" cmpd="sng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cxnSp>
            <p:nvCxnSpPr>
              <p:cNvPr id="52" name="直接连接符 51">
                <a:extLst>
                  <a:ext uri="{FF2B5EF4-FFF2-40B4-BE49-F238E27FC236}">
                    <a16:creationId xmlns:a16="http://schemas.microsoft.com/office/drawing/2014/main" id="{4B929BAB-8352-44DA-98B7-95FF72E97A1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530671" y="4162869"/>
                <a:ext cx="220192" cy="468648"/>
              </a:xfrm>
              <a:prstGeom prst="line">
                <a:avLst/>
              </a:prstGeom>
              <a:ln w="12700">
                <a:solidFill>
                  <a:srgbClr val="2F528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直接连接符 59">
                <a:extLst>
                  <a:ext uri="{FF2B5EF4-FFF2-40B4-BE49-F238E27FC236}">
                    <a16:creationId xmlns:a16="http://schemas.microsoft.com/office/drawing/2014/main" id="{33762575-36A8-4485-ADEA-D2E4706792D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30671" y="4705777"/>
                <a:ext cx="228394" cy="135885"/>
              </a:xfrm>
              <a:prstGeom prst="line">
                <a:avLst/>
              </a:prstGeom>
              <a:ln w="12700">
                <a:solidFill>
                  <a:srgbClr val="2F528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5" name="组合 24">
              <a:extLst>
                <a:ext uri="{FF2B5EF4-FFF2-40B4-BE49-F238E27FC236}">
                  <a16:creationId xmlns:a16="http://schemas.microsoft.com/office/drawing/2014/main" id="{46E3E6CA-D8D6-4719-B84B-BF46C7507EE7}"/>
                </a:ext>
              </a:extLst>
            </p:cNvPr>
            <p:cNvGrpSpPr/>
            <p:nvPr/>
          </p:nvGrpSpPr>
          <p:grpSpPr>
            <a:xfrm>
              <a:off x="772190" y="4894327"/>
              <a:ext cx="1944479" cy="697812"/>
              <a:chOff x="772190" y="4894327"/>
              <a:chExt cx="1944479" cy="697812"/>
            </a:xfrm>
          </p:grpSpPr>
          <p:pic>
            <p:nvPicPr>
              <p:cNvPr id="42" name="图片 41">
                <a:extLst>
                  <a:ext uri="{FF2B5EF4-FFF2-40B4-BE49-F238E27FC236}">
                    <a16:creationId xmlns:a16="http://schemas.microsoft.com/office/drawing/2014/main" id="{AA8A0D18-8CF1-4962-8C17-4BE32EB37E6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 flipH="1">
                <a:off x="772190" y="4896737"/>
                <a:ext cx="957604" cy="695402"/>
              </a:xfrm>
              <a:prstGeom prst="rect">
                <a:avLst/>
              </a:prstGeom>
            </p:spPr>
          </p:pic>
          <p:pic>
            <p:nvPicPr>
              <p:cNvPr id="43" name="图片 42">
                <a:extLst>
                  <a:ext uri="{FF2B5EF4-FFF2-40B4-BE49-F238E27FC236}">
                    <a16:creationId xmlns:a16="http://schemas.microsoft.com/office/drawing/2014/main" id="{891AB2D7-90A2-4BA0-B480-938DFE849A4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1759065" y="4896737"/>
                <a:ext cx="957604" cy="695402"/>
              </a:xfrm>
              <a:prstGeom prst="rect">
                <a:avLst/>
              </a:prstGeom>
            </p:spPr>
          </p:pic>
          <p:cxnSp>
            <p:nvCxnSpPr>
              <p:cNvPr id="44" name="直接连接符 43">
                <a:extLst>
                  <a:ext uri="{FF2B5EF4-FFF2-40B4-BE49-F238E27FC236}">
                    <a16:creationId xmlns:a16="http://schemas.microsoft.com/office/drawing/2014/main" id="{2A5FAE3F-5E15-4330-B828-E877BB06ECA1}"/>
                  </a:ext>
                </a:extLst>
              </p:cNvPr>
              <p:cNvCxnSpPr/>
              <p:nvPr/>
            </p:nvCxnSpPr>
            <p:spPr>
              <a:xfrm>
                <a:off x="2409275" y="5541013"/>
                <a:ext cx="252083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" name="矩形 44">
                <a:extLst>
                  <a:ext uri="{FF2B5EF4-FFF2-40B4-BE49-F238E27FC236}">
                    <a16:creationId xmlns:a16="http://schemas.microsoft.com/office/drawing/2014/main" id="{06D6A85E-22B9-4A14-BB1D-A4F6D7415CF8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521326" y="5070106"/>
                <a:ext cx="95618" cy="70828"/>
              </a:xfrm>
              <a:prstGeom prst="rect">
                <a:avLst/>
              </a:prstGeom>
              <a:noFill/>
              <a:ln w="25400" cmpd="sng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cxnSp>
            <p:nvCxnSpPr>
              <p:cNvPr id="46" name="直接连接符 45">
                <a:extLst>
                  <a:ext uri="{FF2B5EF4-FFF2-40B4-BE49-F238E27FC236}">
                    <a16:creationId xmlns:a16="http://schemas.microsoft.com/office/drawing/2014/main" id="{16A948FB-E427-4550-A0E2-BB7B4994EF8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601729" y="4894327"/>
                <a:ext cx="157336" cy="189917"/>
              </a:xfrm>
              <a:prstGeom prst="line">
                <a:avLst/>
              </a:prstGeom>
              <a:ln w="12700">
                <a:solidFill>
                  <a:srgbClr val="2F528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直接连接符 46">
                <a:extLst>
                  <a:ext uri="{FF2B5EF4-FFF2-40B4-BE49-F238E27FC236}">
                    <a16:creationId xmlns:a16="http://schemas.microsoft.com/office/drawing/2014/main" id="{F7064FA5-A396-48D2-927B-25CB85C531C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16944" y="5140934"/>
                <a:ext cx="151017" cy="424599"/>
              </a:xfrm>
              <a:prstGeom prst="line">
                <a:avLst/>
              </a:prstGeom>
              <a:ln w="12700">
                <a:solidFill>
                  <a:srgbClr val="2F528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6" name="组合 25">
              <a:extLst>
                <a:ext uri="{FF2B5EF4-FFF2-40B4-BE49-F238E27FC236}">
                  <a16:creationId xmlns:a16="http://schemas.microsoft.com/office/drawing/2014/main" id="{0C24D231-E877-4F80-A3A6-F6C31E7F140F}"/>
                </a:ext>
              </a:extLst>
            </p:cNvPr>
            <p:cNvGrpSpPr/>
            <p:nvPr/>
          </p:nvGrpSpPr>
          <p:grpSpPr>
            <a:xfrm>
              <a:off x="772190" y="5622225"/>
              <a:ext cx="1944480" cy="698113"/>
              <a:chOff x="772190" y="5622225"/>
              <a:chExt cx="1944480" cy="698113"/>
            </a:xfrm>
          </p:grpSpPr>
          <p:pic>
            <p:nvPicPr>
              <p:cNvPr id="36" name="图片 35">
                <a:extLst>
                  <a:ext uri="{FF2B5EF4-FFF2-40B4-BE49-F238E27FC236}">
                    <a16:creationId xmlns:a16="http://schemas.microsoft.com/office/drawing/2014/main" id="{7C1A7F47-002F-480A-AC22-4D58982D974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772190" y="5624936"/>
                <a:ext cx="957603" cy="695402"/>
              </a:xfrm>
              <a:prstGeom prst="rect">
                <a:avLst/>
              </a:prstGeom>
            </p:spPr>
          </p:pic>
          <p:pic>
            <p:nvPicPr>
              <p:cNvPr id="37" name="图片 36">
                <a:extLst>
                  <a:ext uri="{FF2B5EF4-FFF2-40B4-BE49-F238E27FC236}">
                    <a16:creationId xmlns:a16="http://schemas.microsoft.com/office/drawing/2014/main" id="{B4A2F172-F4B2-468B-8709-493508883F2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1759066" y="5624936"/>
                <a:ext cx="957604" cy="695402"/>
              </a:xfrm>
              <a:prstGeom prst="rect">
                <a:avLst/>
              </a:prstGeom>
            </p:spPr>
          </p:pic>
          <p:cxnSp>
            <p:nvCxnSpPr>
              <p:cNvPr id="38" name="直接连接符 37">
                <a:extLst>
                  <a:ext uri="{FF2B5EF4-FFF2-40B4-BE49-F238E27FC236}">
                    <a16:creationId xmlns:a16="http://schemas.microsoft.com/office/drawing/2014/main" id="{4F059DB0-D661-41B7-8DE7-BAA9E393CAAA}"/>
                  </a:ext>
                </a:extLst>
              </p:cNvPr>
              <p:cNvCxnSpPr/>
              <p:nvPr/>
            </p:nvCxnSpPr>
            <p:spPr>
              <a:xfrm>
                <a:off x="2433598" y="6269212"/>
                <a:ext cx="252083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" name="矩形 38">
                <a:extLst>
                  <a:ext uri="{FF2B5EF4-FFF2-40B4-BE49-F238E27FC236}">
                    <a16:creationId xmlns:a16="http://schemas.microsoft.com/office/drawing/2014/main" id="{30C0E29B-185E-463C-A689-44AAC5BBD5E5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313895" y="5946163"/>
                <a:ext cx="95618" cy="70828"/>
              </a:xfrm>
              <a:prstGeom prst="rect">
                <a:avLst/>
              </a:prstGeom>
              <a:noFill/>
              <a:ln w="25400" cmpd="sng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cxnSp>
            <p:nvCxnSpPr>
              <p:cNvPr id="40" name="直接连接符 39">
                <a:extLst>
                  <a:ext uri="{FF2B5EF4-FFF2-40B4-BE49-F238E27FC236}">
                    <a16:creationId xmlns:a16="http://schemas.microsoft.com/office/drawing/2014/main" id="{1F0DB5AC-8C09-4E08-B6FB-33469B0AE1E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409513" y="5622225"/>
                <a:ext cx="358448" cy="314072"/>
              </a:xfrm>
              <a:prstGeom prst="line">
                <a:avLst/>
              </a:prstGeom>
              <a:ln w="12700">
                <a:solidFill>
                  <a:srgbClr val="2F528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直接连接符 40">
                <a:extLst>
                  <a:ext uri="{FF2B5EF4-FFF2-40B4-BE49-F238E27FC236}">
                    <a16:creationId xmlns:a16="http://schemas.microsoft.com/office/drawing/2014/main" id="{06EEA584-92CC-4D56-81B5-A04F322D9FE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09513" y="6026857"/>
                <a:ext cx="341350" cy="289138"/>
              </a:xfrm>
              <a:prstGeom prst="line">
                <a:avLst/>
              </a:prstGeom>
              <a:ln w="12700">
                <a:solidFill>
                  <a:srgbClr val="2F528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5E42ED52-2681-4E5F-99FE-A6720F8BF6F8}"/>
                </a:ext>
              </a:extLst>
            </p:cNvPr>
            <p:cNvSpPr txBox="1"/>
            <p:nvPr/>
          </p:nvSpPr>
          <p:spPr>
            <a:xfrm>
              <a:off x="300281" y="3690562"/>
              <a:ext cx="424778" cy="1415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OE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FBAC4F1C-0641-46AA-9DA8-7A2E9DD5E726}"/>
                </a:ext>
              </a:extLst>
            </p:cNvPr>
            <p:cNvSpPr txBox="1"/>
            <p:nvPr/>
          </p:nvSpPr>
          <p:spPr>
            <a:xfrm>
              <a:off x="313088" y="4445029"/>
              <a:ext cx="5891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2B9229CE-AA2C-4F49-BE48-E2E09E165CB0}"/>
                </a:ext>
              </a:extLst>
            </p:cNvPr>
            <p:cNvSpPr txBox="1"/>
            <p:nvPr/>
          </p:nvSpPr>
          <p:spPr>
            <a:xfrm>
              <a:off x="276837" y="5162891"/>
              <a:ext cx="5891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Sh#1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32B18E02-1531-4B2D-8A0F-11CA3E5D17D3}"/>
                </a:ext>
              </a:extLst>
            </p:cNvPr>
            <p:cNvSpPr txBox="1"/>
            <p:nvPr/>
          </p:nvSpPr>
          <p:spPr>
            <a:xfrm>
              <a:off x="291726" y="5849526"/>
              <a:ext cx="5891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Sh#2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8FED0E9A-EB99-4777-B6C3-987034DC6A1F}"/>
                </a:ext>
              </a:extLst>
            </p:cNvPr>
            <p:cNvSpPr txBox="1"/>
            <p:nvPr/>
          </p:nvSpPr>
          <p:spPr>
            <a:xfrm>
              <a:off x="698484" y="3207379"/>
              <a:ext cx="240898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g1051E human mitochondria staining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28EEF045-4EFF-40D8-AB03-61CA09DB9FE2}"/>
                </a:ext>
              </a:extLst>
            </p:cNvPr>
            <p:cNvSpPr txBox="1"/>
            <p:nvPr/>
          </p:nvSpPr>
          <p:spPr>
            <a:xfrm rot="16200000">
              <a:off x="-157724" y="4654949"/>
              <a:ext cx="7389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LAGL1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5" name="直接连接符 34">
              <a:extLst>
                <a:ext uri="{FF2B5EF4-FFF2-40B4-BE49-F238E27FC236}">
                  <a16:creationId xmlns:a16="http://schemas.microsoft.com/office/drawing/2014/main" id="{3C174705-DD9C-407B-B80E-2FBCDE560890}"/>
                </a:ext>
              </a:extLst>
            </p:cNvPr>
            <p:cNvCxnSpPr/>
            <p:nvPr/>
          </p:nvCxnSpPr>
          <p:spPr>
            <a:xfrm>
              <a:off x="334869" y="3443311"/>
              <a:ext cx="0" cy="2841257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9" name="组合 68">
            <a:extLst>
              <a:ext uri="{FF2B5EF4-FFF2-40B4-BE49-F238E27FC236}">
                <a16:creationId xmlns:a16="http://schemas.microsoft.com/office/drawing/2014/main" id="{A31C14A3-B76C-4E3A-9785-AB7F2B65F94E}"/>
              </a:ext>
            </a:extLst>
          </p:cNvPr>
          <p:cNvGrpSpPr/>
          <p:nvPr/>
        </p:nvGrpSpPr>
        <p:grpSpPr>
          <a:xfrm>
            <a:off x="2975549" y="1085288"/>
            <a:ext cx="2898758" cy="2405623"/>
            <a:chOff x="2833749" y="3228019"/>
            <a:chExt cx="2898758" cy="2405623"/>
          </a:xfrm>
        </p:grpSpPr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83F1E693-A089-4D7E-B54C-C77DB759D976}"/>
                </a:ext>
              </a:extLst>
            </p:cNvPr>
            <p:cNvSpPr txBox="1"/>
            <p:nvPr/>
          </p:nvSpPr>
          <p:spPr>
            <a:xfrm>
              <a:off x="4944739" y="5168173"/>
              <a:ext cx="67871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zh-CN" altLang="en-US" sz="1000" dirty="0">
                <a:latin typeface="Arial Black" panose="020B0A04020102020204" pitchFamily="34" charset="0"/>
              </a:endParaRPr>
            </a:p>
          </p:txBody>
        </p:sp>
        <p:grpSp>
          <p:nvGrpSpPr>
            <p:cNvPr id="71" name="组合 70">
              <a:extLst>
                <a:ext uri="{FF2B5EF4-FFF2-40B4-BE49-F238E27FC236}">
                  <a16:creationId xmlns:a16="http://schemas.microsoft.com/office/drawing/2014/main" id="{2CFCF1E2-93EB-44E2-A727-ABCF405C84AA}"/>
                </a:ext>
              </a:extLst>
            </p:cNvPr>
            <p:cNvGrpSpPr/>
            <p:nvPr/>
          </p:nvGrpSpPr>
          <p:grpSpPr>
            <a:xfrm>
              <a:off x="3500376" y="3451991"/>
              <a:ext cx="1997537" cy="695402"/>
              <a:chOff x="3175773" y="3464858"/>
              <a:chExt cx="1997537" cy="695402"/>
            </a:xfrm>
          </p:grpSpPr>
          <p:pic>
            <p:nvPicPr>
              <p:cNvPr id="94" name="图片 93">
                <a:extLst>
                  <a:ext uri="{FF2B5EF4-FFF2-40B4-BE49-F238E27FC236}">
                    <a16:creationId xmlns:a16="http://schemas.microsoft.com/office/drawing/2014/main" id="{8E4F95F9-14BE-4110-B203-11EF7E83E0F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b="-751"/>
              <a:stretch/>
            </p:blipFill>
            <p:spPr>
              <a:xfrm>
                <a:off x="3175773" y="3464858"/>
                <a:ext cx="957603" cy="695402"/>
              </a:xfrm>
              <a:prstGeom prst="rect">
                <a:avLst/>
              </a:prstGeom>
            </p:spPr>
          </p:pic>
          <p:pic>
            <p:nvPicPr>
              <p:cNvPr id="95" name="图片 94">
                <a:extLst>
                  <a:ext uri="{FF2B5EF4-FFF2-40B4-BE49-F238E27FC236}">
                    <a16:creationId xmlns:a16="http://schemas.microsoft.com/office/drawing/2014/main" id="{4D5C341B-139E-414C-80B7-F157349D47E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4215705" y="3464858"/>
                <a:ext cx="957605" cy="695402"/>
              </a:xfrm>
              <a:prstGeom prst="rect">
                <a:avLst/>
              </a:prstGeom>
            </p:spPr>
          </p:pic>
          <p:sp>
            <p:nvSpPr>
              <p:cNvPr id="96" name="矩形 95">
                <a:extLst>
                  <a:ext uri="{FF2B5EF4-FFF2-40B4-BE49-F238E27FC236}">
                    <a16:creationId xmlns:a16="http://schemas.microsoft.com/office/drawing/2014/main" id="{1EAA4CCC-37DD-4590-9A7C-958BDCBD1F9F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811958" y="3771076"/>
                <a:ext cx="95618" cy="70828"/>
              </a:xfrm>
              <a:prstGeom prst="rect">
                <a:avLst/>
              </a:prstGeom>
              <a:noFill/>
              <a:ln w="25400" cmpd="sng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cxnSp>
            <p:nvCxnSpPr>
              <p:cNvPr id="97" name="直接连接符 96">
                <a:extLst>
                  <a:ext uri="{FF2B5EF4-FFF2-40B4-BE49-F238E27FC236}">
                    <a16:creationId xmlns:a16="http://schemas.microsoft.com/office/drawing/2014/main" id="{2CA9C69F-230B-4057-99AD-88AFCBAD7C3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905252" y="3482770"/>
                <a:ext cx="310453" cy="288306"/>
              </a:xfrm>
              <a:prstGeom prst="line">
                <a:avLst/>
              </a:prstGeom>
              <a:ln w="12700">
                <a:solidFill>
                  <a:srgbClr val="2F528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8" name="直接连接符 97">
                <a:extLst>
                  <a:ext uri="{FF2B5EF4-FFF2-40B4-BE49-F238E27FC236}">
                    <a16:creationId xmlns:a16="http://schemas.microsoft.com/office/drawing/2014/main" id="{18D0A1FC-39F1-417E-8AD9-B8C10023995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905252" y="3841904"/>
                <a:ext cx="310453" cy="288306"/>
              </a:xfrm>
              <a:prstGeom prst="line">
                <a:avLst/>
              </a:prstGeom>
              <a:ln w="12700">
                <a:solidFill>
                  <a:srgbClr val="2F528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2" name="组合 71">
              <a:extLst>
                <a:ext uri="{FF2B5EF4-FFF2-40B4-BE49-F238E27FC236}">
                  <a16:creationId xmlns:a16="http://schemas.microsoft.com/office/drawing/2014/main" id="{2B975913-AE3F-41A0-A7A6-1576981C0AFF}"/>
                </a:ext>
              </a:extLst>
            </p:cNvPr>
            <p:cNvGrpSpPr/>
            <p:nvPr/>
          </p:nvGrpSpPr>
          <p:grpSpPr>
            <a:xfrm>
              <a:off x="3500376" y="4094712"/>
              <a:ext cx="1997537" cy="780880"/>
              <a:chOff x="3175773" y="4107579"/>
              <a:chExt cx="1997537" cy="780880"/>
            </a:xfrm>
          </p:grpSpPr>
          <p:pic>
            <p:nvPicPr>
              <p:cNvPr id="87" name="图片 86">
                <a:extLst>
                  <a:ext uri="{FF2B5EF4-FFF2-40B4-BE49-F238E27FC236}">
                    <a16:creationId xmlns:a16="http://schemas.microsoft.com/office/drawing/2014/main" id="{A225AE76-5D8C-46F9-9F84-CA68D01FB94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4215706" y="4193057"/>
                <a:ext cx="957604" cy="695402"/>
              </a:xfrm>
              <a:prstGeom prst="rect">
                <a:avLst/>
              </a:prstGeom>
            </p:spPr>
          </p:pic>
          <p:pic>
            <p:nvPicPr>
              <p:cNvPr id="88" name="图片 87">
                <a:extLst>
                  <a:ext uri="{FF2B5EF4-FFF2-40B4-BE49-F238E27FC236}">
                    <a16:creationId xmlns:a16="http://schemas.microsoft.com/office/drawing/2014/main" id="{DBA536D7-CF43-43F9-B83B-68C5D878CE3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 flipH="1">
                <a:off x="3175773" y="4193057"/>
                <a:ext cx="957604" cy="695402"/>
              </a:xfrm>
              <a:prstGeom prst="rect">
                <a:avLst/>
              </a:prstGeom>
            </p:spPr>
          </p:pic>
          <p:cxnSp>
            <p:nvCxnSpPr>
              <p:cNvPr id="89" name="直接连接符 88">
                <a:extLst>
                  <a:ext uri="{FF2B5EF4-FFF2-40B4-BE49-F238E27FC236}">
                    <a16:creationId xmlns:a16="http://schemas.microsoft.com/office/drawing/2014/main" id="{C5044FAF-F662-4BF2-913E-C44138468FD4}"/>
                  </a:ext>
                </a:extLst>
              </p:cNvPr>
              <p:cNvCxnSpPr/>
              <p:nvPr/>
            </p:nvCxnSpPr>
            <p:spPr>
              <a:xfrm>
                <a:off x="4886019" y="4107579"/>
                <a:ext cx="252083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直接连接符 89">
                <a:extLst>
                  <a:ext uri="{FF2B5EF4-FFF2-40B4-BE49-F238E27FC236}">
                    <a16:creationId xmlns:a16="http://schemas.microsoft.com/office/drawing/2014/main" id="{633EF69B-84E9-4769-AAD8-04BAC2F9FCBF}"/>
                  </a:ext>
                </a:extLst>
              </p:cNvPr>
              <p:cNvCxnSpPr/>
              <p:nvPr/>
            </p:nvCxnSpPr>
            <p:spPr>
              <a:xfrm>
                <a:off x="4886019" y="4837334"/>
                <a:ext cx="252083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1" name="矩形 90">
                <a:extLst>
                  <a:ext uri="{FF2B5EF4-FFF2-40B4-BE49-F238E27FC236}">
                    <a16:creationId xmlns:a16="http://schemas.microsoft.com/office/drawing/2014/main" id="{3DA17731-44FB-4061-B5AA-4CB5A1688CEF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907575" y="4531095"/>
                <a:ext cx="95618" cy="70828"/>
              </a:xfrm>
              <a:prstGeom prst="rect">
                <a:avLst/>
              </a:prstGeom>
              <a:noFill/>
              <a:ln w="25400" cmpd="sng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cxnSp>
            <p:nvCxnSpPr>
              <p:cNvPr id="92" name="直接连接符 91">
                <a:extLst>
                  <a:ext uri="{FF2B5EF4-FFF2-40B4-BE49-F238E27FC236}">
                    <a16:creationId xmlns:a16="http://schemas.microsoft.com/office/drawing/2014/main" id="{D3286D9A-408E-4810-8F8F-591D3EEBFA1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001268" y="4199757"/>
                <a:ext cx="214437" cy="332584"/>
              </a:xfrm>
              <a:prstGeom prst="line">
                <a:avLst/>
              </a:prstGeom>
              <a:ln w="12700">
                <a:solidFill>
                  <a:srgbClr val="2F528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直接连接符 92">
                <a:extLst>
                  <a:ext uri="{FF2B5EF4-FFF2-40B4-BE49-F238E27FC236}">
                    <a16:creationId xmlns:a16="http://schemas.microsoft.com/office/drawing/2014/main" id="{21D74D75-90C0-44D7-A6B7-0EE1D340496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00612" y="4608524"/>
                <a:ext cx="206197" cy="278534"/>
              </a:xfrm>
              <a:prstGeom prst="line">
                <a:avLst/>
              </a:prstGeom>
              <a:ln w="12700">
                <a:solidFill>
                  <a:srgbClr val="2F528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3" name="组合 72">
              <a:extLst>
                <a:ext uri="{FF2B5EF4-FFF2-40B4-BE49-F238E27FC236}">
                  <a16:creationId xmlns:a16="http://schemas.microsoft.com/office/drawing/2014/main" id="{CAB604BD-D0D4-434C-801F-9942048EB9F7}"/>
                </a:ext>
              </a:extLst>
            </p:cNvPr>
            <p:cNvGrpSpPr/>
            <p:nvPr/>
          </p:nvGrpSpPr>
          <p:grpSpPr>
            <a:xfrm>
              <a:off x="3500376" y="4914736"/>
              <a:ext cx="1997537" cy="697333"/>
              <a:chOff x="3175773" y="4927603"/>
              <a:chExt cx="1997537" cy="697333"/>
            </a:xfrm>
          </p:grpSpPr>
          <p:pic>
            <p:nvPicPr>
              <p:cNvPr id="81" name="图片 80">
                <a:extLst>
                  <a:ext uri="{FF2B5EF4-FFF2-40B4-BE49-F238E27FC236}">
                    <a16:creationId xmlns:a16="http://schemas.microsoft.com/office/drawing/2014/main" id="{B8DDB231-94CA-43B4-9EE3-B8372318BDF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175773" y="4927603"/>
                <a:ext cx="957604" cy="637930"/>
              </a:xfrm>
              <a:prstGeom prst="rect">
                <a:avLst/>
              </a:prstGeom>
            </p:spPr>
          </p:pic>
          <p:pic>
            <p:nvPicPr>
              <p:cNvPr id="82" name="图片 81">
                <a:extLst>
                  <a:ext uri="{FF2B5EF4-FFF2-40B4-BE49-F238E27FC236}">
                    <a16:creationId xmlns:a16="http://schemas.microsoft.com/office/drawing/2014/main" id="{FCED38BF-B6FC-44EB-9E29-F30EE680103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4215705" y="4929534"/>
                <a:ext cx="957605" cy="695402"/>
              </a:xfrm>
              <a:prstGeom prst="rect">
                <a:avLst/>
              </a:prstGeom>
            </p:spPr>
          </p:pic>
          <p:cxnSp>
            <p:nvCxnSpPr>
              <p:cNvPr id="83" name="直接连接符 82">
                <a:extLst>
                  <a:ext uri="{FF2B5EF4-FFF2-40B4-BE49-F238E27FC236}">
                    <a16:creationId xmlns:a16="http://schemas.microsoft.com/office/drawing/2014/main" id="{C80A78EC-720A-4210-B148-A8503031FCB3}"/>
                  </a:ext>
                </a:extLst>
              </p:cNvPr>
              <p:cNvCxnSpPr/>
              <p:nvPr/>
            </p:nvCxnSpPr>
            <p:spPr>
              <a:xfrm>
                <a:off x="4866959" y="5565533"/>
                <a:ext cx="252083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4" name="矩形 83">
                <a:extLst>
                  <a:ext uri="{FF2B5EF4-FFF2-40B4-BE49-F238E27FC236}">
                    <a16:creationId xmlns:a16="http://schemas.microsoft.com/office/drawing/2014/main" id="{801723CC-A871-47AF-AD1F-6AF324D8DC4B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787527" y="5307164"/>
                <a:ext cx="95618" cy="70828"/>
              </a:xfrm>
              <a:prstGeom prst="rect">
                <a:avLst/>
              </a:prstGeom>
              <a:noFill/>
              <a:ln w="25400" cmpd="sng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cxnSp>
            <p:nvCxnSpPr>
              <p:cNvPr id="85" name="直接连接符 84">
                <a:extLst>
                  <a:ext uri="{FF2B5EF4-FFF2-40B4-BE49-F238E27FC236}">
                    <a16:creationId xmlns:a16="http://schemas.microsoft.com/office/drawing/2014/main" id="{94CDF3AD-3088-4140-A5B3-2A6C377F3C7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888069" y="5381439"/>
                <a:ext cx="327635" cy="240784"/>
              </a:xfrm>
              <a:prstGeom prst="line">
                <a:avLst/>
              </a:prstGeom>
              <a:ln w="12700">
                <a:solidFill>
                  <a:srgbClr val="2F528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直接连接符 85">
                <a:extLst>
                  <a:ext uri="{FF2B5EF4-FFF2-40B4-BE49-F238E27FC236}">
                    <a16:creationId xmlns:a16="http://schemas.microsoft.com/office/drawing/2014/main" id="{1167752D-3439-4984-87F9-48E8079901C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879557" y="4927956"/>
                <a:ext cx="365419" cy="389218"/>
              </a:xfrm>
              <a:prstGeom prst="line">
                <a:avLst/>
              </a:prstGeom>
              <a:ln w="12700">
                <a:solidFill>
                  <a:srgbClr val="2F528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4" name="文本框 73">
              <a:extLst>
                <a:ext uri="{FF2B5EF4-FFF2-40B4-BE49-F238E27FC236}">
                  <a16:creationId xmlns:a16="http://schemas.microsoft.com/office/drawing/2014/main" id="{587EC7B5-641E-4DBC-97C6-AD5113CB7B88}"/>
                </a:ext>
              </a:extLst>
            </p:cNvPr>
            <p:cNvSpPr txBox="1"/>
            <p:nvPr/>
          </p:nvSpPr>
          <p:spPr>
            <a:xfrm>
              <a:off x="3062967" y="3711478"/>
              <a:ext cx="424778" cy="1415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OE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文本框 74">
              <a:extLst>
                <a:ext uri="{FF2B5EF4-FFF2-40B4-BE49-F238E27FC236}">
                  <a16:creationId xmlns:a16="http://schemas.microsoft.com/office/drawing/2014/main" id="{688F797F-42F5-47AB-AD77-6987CF76CEFE}"/>
                </a:ext>
              </a:extLst>
            </p:cNvPr>
            <p:cNvSpPr txBox="1"/>
            <p:nvPr/>
          </p:nvSpPr>
          <p:spPr>
            <a:xfrm>
              <a:off x="3075774" y="4465945"/>
              <a:ext cx="5891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文本框 75">
              <a:extLst>
                <a:ext uri="{FF2B5EF4-FFF2-40B4-BE49-F238E27FC236}">
                  <a16:creationId xmlns:a16="http://schemas.microsoft.com/office/drawing/2014/main" id="{DB904ECD-71ED-4D63-965B-8E975C169DA1}"/>
                </a:ext>
              </a:extLst>
            </p:cNvPr>
            <p:cNvSpPr txBox="1"/>
            <p:nvPr/>
          </p:nvSpPr>
          <p:spPr>
            <a:xfrm>
              <a:off x="3039523" y="5183807"/>
              <a:ext cx="5891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Sh#2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文本框 76">
              <a:extLst>
                <a:ext uri="{FF2B5EF4-FFF2-40B4-BE49-F238E27FC236}">
                  <a16:creationId xmlns:a16="http://schemas.microsoft.com/office/drawing/2014/main" id="{3EBD9DFC-63EE-43AD-BEFB-7B50A20A65B9}"/>
                </a:ext>
              </a:extLst>
            </p:cNvPr>
            <p:cNvSpPr txBox="1"/>
            <p:nvPr/>
          </p:nvSpPr>
          <p:spPr>
            <a:xfrm>
              <a:off x="3274169" y="3228019"/>
              <a:ext cx="24583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g101027E human mitochondria staining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8" name="组合 77">
              <a:extLst>
                <a:ext uri="{FF2B5EF4-FFF2-40B4-BE49-F238E27FC236}">
                  <a16:creationId xmlns:a16="http://schemas.microsoft.com/office/drawing/2014/main" id="{56E9417B-B783-45A5-985D-5BF8B321A616}"/>
                </a:ext>
              </a:extLst>
            </p:cNvPr>
            <p:cNvGrpSpPr/>
            <p:nvPr/>
          </p:nvGrpSpPr>
          <p:grpSpPr>
            <a:xfrm>
              <a:off x="2833749" y="3473642"/>
              <a:ext cx="253428" cy="2160000"/>
              <a:chOff x="6209613" y="3723205"/>
              <a:chExt cx="253428" cy="2160000"/>
            </a:xfrm>
          </p:grpSpPr>
          <p:cxnSp>
            <p:nvCxnSpPr>
              <p:cNvPr id="79" name="直接连接符 78">
                <a:extLst>
                  <a:ext uri="{FF2B5EF4-FFF2-40B4-BE49-F238E27FC236}">
                    <a16:creationId xmlns:a16="http://schemas.microsoft.com/office/drawing/2014/main" id="{288D3AAA-8C55-40DC-9321-8081584B01DA}"/>
                  </a:ext>
                </a:extLst>
              </p:cNvPr>
              <p:cNvCxnSpPr/>
              <p:nvPr/>
            </p:nvCxnSpPr>
            <p:spPr>
              <a:xfrm>
                <a:off x="6463041" y="3723205"/>
                <a:ext cx="0" cy="216000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0" name="文本框 79">
                <a:extLst>
                  <a:ext uri="{FF2B5EF4-FFF2-40B4-BE49-F238E27FC236}">
                    <a16:creationId xmlns:a16="http://schemas.microsoft.com/office/drawing/2014/main" id="{B36C602A-45A4-41E5-9D4C-F2171E355870}"/>
                  </a:ext>
                </a:extLst>
              </p:cNvPr>
              <p:cNvSpPr txBox="1"/>
              <p:nvPr/>
            </p:nvSpPr>
            <p:spPr>
              <a:xfrm rot="16200000">
                <a:off x="5963242" y="4609903"/>
                <a:ext cx="73896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LAGL1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44196212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副标题 2">
            <a:extLst>
              <a:ext uri="{FF2B5EF4-FFF2-40B4-BE49-F238E27FC236}">
                <a16:creationId xmlns:a16="http://schemas.microsoft.com/office/drawing/2014/main" id="{D90E6C4C-0811-4F54-AC55-9D6F73A46276}"/>
              </a:ext>
            </a:extLst>
          </p:cNvPr>
          <p:cNvSpPr txBox="1">
            <a:spLocks/>
          </p:cNvSpPr>
          <p:nvPr/>
        </p:nvSpPr>
        <p:spPr>
          <a:xfrm>
            <a:off x="155105" y="152564"/>
            <a:ext cx="3173883" cy="46750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.7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3BB60BA8-1667-49EB-A9F4-E61B289C635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57367" y="1431273"/>
            <a:ext cx="4300537" cy="864394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1BABB1B7-0718-4321-852F-C405E9EABDF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57367" y="2574274"/>
            <a:ext cx="4300537" cy="450056"/>
          </a:xfrm>
          <a:prstGeom prst="rect">
            <a:avLst/>
          </a:prstGeom>
        </p:spPr>
      </p:pic>
      <p:grpSp>
        <p:nvGrpSpPr>
          <p:cNvPr id="42" name="组合 41">
            <a:extLst>
              <a:ext uri="{FF2B5EF4-FFF2-40B4-BE49-F238E27FC236}">
                <a16:creationId xmlns:a16="http://schemas.microsoft.com/office/drawing/2014/main" id="{4296253A-E744-47D4-87CD-439A81DA01C6}"/>
              </a:ext>
            </a:extLst>
          </p:cNvPr>
          <p:cNvGrpSpPr/>
          <p:nvPr/>
        </p:nvGrpSpPr>
        <p:grpSpPr>
          <a:xfrm>
            <a:off x="2871698" y="1003684"/>
            <a:ext cx="1550921" cy="427589"/>
            <a:chOff x="3187954" y="873520"/>
            <a:chExt cx="1550921" cy="427589"/>
          </a:xfrm>
        </p:grpSpPr>
        <p:grpSp>
          <p:nvGrpSpPr>
            <p:cNvPr id="43" name="组合 42">
              <a:extLst>
                <a:ext uri="{FF2B5EF4-FFF2-40B4-BE49-F238E27FC236}">
                  <a16:creationId xmlns:a16="http://schemas.microsoft.com/office/drawing/2014/main" id="{9BA0293B-BF30-4FB3-A818-F9ED95C986F4}"/>
                </a:ext>
              </a:extLst>
            </p:cNvPr>
            <p:cNvGrpSpPr/>
            <p:nvPr/>
          </p:nvGrpSpPr>
          <p:grpSpPr>
            <a:xfrm>
              <a:off x="3211318" y="1042966"/>
              <a:ext cx="1527557" cy="258143"/>
              <a:chOff x="757815" y="1311455"/>
              <a:chExt cx="1527557" cy="258143"/>
            </a:xfrm>
          </p:grpSpPr>
          <p:sp>
            <p:nvSpPr>
              <p:cNvPr id="46" name="文本框 45">
                <a:extLst>
                  <a:ext uri="{FF2B5EF4-FFF2-40B4-BE49-F238E27FC236}">
                    <a16:creationId xmlns:a16="http://schemas.microsoft.com/office/drawing/2014/main" id="{BEBE4D81-7774-4DD3-9C83-C5FE2221CEDA}"/>
                  </a:ext>
                </a:extLst>
              </p:cNvPr>
              <p:cNvSpPr txBox="1"/>
              <p:nvPr/>
            </p:nvSpPr>
            <p:spPr>
              <a:xfrm>
                <a:off x="757815" y="1323377"/>
                <a:ext cx="4572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OE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id="{4C0363FA-F051-4CC3-B1EE-DD1E7F96D5B7}"/>
                  </a:ext>
                </a:extLst>
              </p:cNvPr>
              <p:cNvSpPr txBox="1"/>
              <p:nvPr/>
            </p:nvSpPr>
            <p:spPr>
              <a:xfrm>
                <a:off x="1395678" y="1311455"/>
                <a:ext cx="51219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h#1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文本框 47">
                <a:extLst>
                  <a:ext uri="{FF2B5EF4-FFF2-40B4-BE49-F238E27FC236}">
                    <a16:creationId xmlns:a16="http://schemas.microsoft.com/office/drawing/2014/main" id="{5B993FFD-71D9-4A1B-96AE-3B724A9D3FE8}"/>
                  </a:ext>
                </a:extLst>
              </p:cNvPr>
              <p:cNvSpPr txBox="1"/>
              <p:nvPr/>
            </p:nvSpPr>
            <p:spPr>
              <a:xfrm>
                <a:off x="1764495" y="1319615"/>
                <a:ext cx="52087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h#2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文本框 48">
                <a:extLst>
                  <a:ext uri="{FF2B5EF4-FFF2-40B4-BE49-F238E27FC236}">
                    <a16:creationId xmlns:a16="http://schemas.microsoft.com/office/drawing/2014/main" id="{F4FE6FC8-CB3B-4E1F-BF35-4116D604BE25}"/>
                  </a:ext>
                </a:extLst>
              </p:cNvPr>
              <p:cNvSpPr txBox="1"/>
              <p:nvPr/>
            </p:nvSpPr>
            <p:spPr>
              <a:xfrm>
                <a:off x="1063116" y="1318026"/>
                <a:ext cx="515627" cy="246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trl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C048B831-9B59-40BE-9BE1-C50E86ABA779}"/>
                </a:ext>
              </a:extLst>
            </p:cNvPr>
            <p:cNvSpPr txBox="1"/>
            <p:nvPr/>
          </p:nvSpPr>
          <p:spPr>
            <a:xfrm>
              <a:off x="3187954" y="873520"/>
              <a:ext cx="14418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g101027E PLAGL1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5" name="直接连接符 44">
              <a:extLst>
                <a:ext uri="{FF2B5EF4-FFF2-40B4-BE49-F238E27FC236}">
                  <a16:creationId xmlns:a16="http://schemas.microsoft.com/office/drawing/2014/main" id="{5A018190-1196-4470-A1AC-E93CA90F6F7D}"/>
                </a:ext>
              </a:extLst>
            </p:cNvPr>
            <p:cNvCxnSpPr>
              <a:cxnSpLocks/>
            </p:cNvCxnSpPr>
            <p:nvPr/>
          </p:nvCxnSpPr>
          <p:spPr>
            <a:xfrm>
              <a:off x="3290239" y="1113169"/>
              <a:ext cx="1339548" cy="1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0" name="组合 49">
            <a:extLst>
              <a:ext uri="{FF2B5EF4-FFF2-40B4-BE49-F238E27FC236}">
                <a16:creationId xmlns:a16="http://schemas.microsoft.com/office/drawing/2014/main" id="{02229D1E-3590-478B-A38D-0F5398BB44F0}"/>
              </a:ext>
            </a:extLst>
          </p:cNvPr>
          <p:cNvGrpSpPr/>
          <p:nvPr/>
        </p:nvGrpSpPr>
        <p:grpSpPr>
          <a:xfrm>
            <a:off x="1390405" y="1010993"/>
            <a:ext cx="1550921" cy="427589"/>
            <a:chOff x="3187954" y="873520"/>
            <a:chExt cx="1550921" cy="427589"/>
          </a:xfrm>
        </p:grpSpPr>
        <p:grpSp>
          <p:nvGrpSpPr>
            <p:cNvPr id="51" name="组合 50">
              <a:extLst>
                <a:ext uri="{FF2B5EF4-FFF2-40B4-BE49-F238E27FC236}">
                  <a16:creationId xmlns:a16="http://schemas.microsoft.com/office/drawing/2014/main" id="{1875624B-5422-40B8-AC65-293D55D22E69}"/>
                </a:ext>
              </a:extLst>
            </p:cNvPr>
            <p:cNvGrpSpPr/>
            <p:nvPr/>
          </p:nvGrpSpPr>
          <p:grpSpPr>
            <a:xfrm>
              <a:off x="3211318" y="1042966"/>
              <a:ext cx="1527557" cy="258143"/>
              <a:chOff x="757815" y="1311455"/>
              <a:chExt cx="1527557" cy="258143"/>
            </a:xfrm>
          </p:grpSpPr>
          <p:sp>
            <p:nvSpPr>
              <p:cNvPr id="61" name="文本框 60">
                <a:extLst>
                  <a:ext uri="{FF2B5EF4-FFF2-40B4-BE49-F238E27FC236}">
                    <a16:creationId xmlns:a16="http://schemas.microsoft.com/office/drawing/2014/main" id="{E69C529F-2FFC-4473-B5F7-A5448B65E546}"/>
                  </a:ext>
                </a:extLst>
              </p:cNvPr>
              <p:cNvSpPr txBox="1"/>
              <p:nvPr/>
            </p:nvSpPr>
            <p:spPr>
              <a:xfrm>
                <a:off x="757815" y="1323377"/>
                <a:ext cx="4572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OE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文本框 61">
                <a:extLst>
                  <a:ext uri="{FF2B5EF4-FFF2-40B4-BE49-F238E27FC236}">
                    <a16:creationId xmlns:a16="http://schemas.microsoft.com/office/drawing/2014/main" id="{C4FB5B32-6BEB-4287-A81F-88721BBE3A3F}"/>
                  </a:ext>
                </a:extLst>
              </p:cNvPr>
              <p:cNvSpPr txBox="1"/>
              <p:nvPr/>
            </p:nvSpPr>
            <p:spPr>
              <a:xfrm>
                <a:off x="1395678" y="1311455"/>
                <a:ext cx="51219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h#1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文本框 62">
                <a:extLst>
                  <a:ext uri="{FF2B5EF4-FFF2-40B4-BE49-F238E27FC236}">
                    <a16:creationId xmlns:a16="http://schemas.microsoft.com/office/drawing/2014/main" id="{B0DCA236-DB46-43BC-8D60-AFD9F463A65C}"/>
                  </a:ext>
                </a:extLst>
              </p:cNvPr>
              <p:cNvSpPr txBox="1"/>
              <p:nvPr/>
            </p:nvSpPr>
            <p:spPr>
              <a:xfrm>
                <a:off x="1764495" y="1319615"/>
                <a:ext cx="52087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h#2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文本框 63">
                <a:extLst>
                  <a:ext uri="{FF2B5EF4-FFF2-40B4-BE49-F238E27FC236}">
                    <a16:creationId xmlns:a16="http://schemas.microsoft.com/office/drawing/2014/main" id="{67EED0D2-7D09-4731-9566-A2444F1F9EAC}"/>
                  </a:ext>
                </a:extLst>
              </p:cNvPr>
              <p:cNvSpPr txBox="1"/>
              <p:nvPr/>
            </p:nvSpPr>
            <p:spPr>
              <a:xfrm>
                <a:off x="1063116" y="1318026"/>
                <a:ext cx="515627" cy="246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trl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2" name="文本框 51">
              <a:extLst>
                <a:ext uri="{FF2B5EF4-FFF2-40B4-BE49-F238E27FC236}">
                  <a16:creationId xmlns:a16="http://schemas.microsoft.com/office/drawing/2014/main" id="{ACA50752-C5F6-481E-A513-208C5820AC6C}"/>
                </a:ext>
              </a:extLst>
            </p:cNvPr>
            <p:cNvSpPr txBox="1"/>
            <p:nvPr/>
          </p:nvSpPr>
          <p:spPr>
            <a:xfrm>
              <a:off x="3187954" y="873520"/>
              <a:ext cx="14418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g1051E PLAGL1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0" name="直接连接符 59">
              <a:extLst>
                <a:ext uri="{FF2B5EF4-FFF2-40B4-BE49-F238E27FC236}">
                  <a16:creationId xmlns:a16="http://schemas.microsoft.com/office/drawing/2014/main" id="{BB41042C-31B0-43FB-80F5-7780D40A2F66}"/>
                </a:ext>
              </a:extLst>
            </p:cNvPr>
            <p:cNvCxnSpPr>
              <a:cxnSpLocks/>
            </p:cNvCxnSpPr>
            <p:nvPr/>
          </p:nvCxnSpPr>
          <p:spPr>
            <a:xfrm>
              <a:off x="3290239" y="1113169"/>
              <a:ext cx="1339548" cy="1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2" name="文本框 21">
            <a:extLst>
              <a:ext uri="{FF2B5EF4-FFF2-40B4-BE49-F238E27FC236}">
                <a16:creationId xmlns:a16="http://schemas.microsoft.com/office/drawing/2014/main" id="{B144C07E-821A-46A5-8C66-407A5F3EBAFF}"/>
              </a:ext>
            </a:extLst>
          </p:cNvPr>
          <p:cNvSpPr txBox="1"/>
          <p:nvPr/>
        </p:nvSpPr>
        <p:spPr>
          <a:xfrm>
            <a:off x="93407" y="1697390"/>
            <a:ext cx="6639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LAGL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D2B8964C-BE0E-46AE-AD06-2AF0D9674AA1}"/>
              </a:ext>
            </a:extLst>
          </p:cNvPr>
          <p:cNvSpPr txBox="1"/>
          <p:nvPr/>
        </p:nvSpPr>
        <p:spPr>
          <a:xfrm>
            <a:off x="93407" y="2616353"/>
            <a:ext cx="6639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-Actin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406EDA61-03F6-4D1E-B813-FBA179262E79}"/>
              </a:ext>
            </a:extLst>
          </p:cNvPr>
          <p:cNvSpPr txBox="1"/>
          <p:nvPr/>
        </p:nvSpPr>
        <p:spPr>
          <a:xfrm>
            <a:off x="253439" y="886188"/>
            <a:ext cx="4395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5" name="组合 24">
            <a:extLst>
              <a:ext uri="{FF2B5EF4-FFF2-40B4-BE49-F238E27FC236}">
                <a16:creationId xmlns:a16="http://schemas.microsoft.com/office/drawing/2014/main" id="{23BACE5F-97E3-4903-A7D3-6EA8AB5B8391}"/>
              </a:ext>
            </a:extLst>
          </p:cNvPr>
          <p:cNvGrpSpPr/>
          <p:nvPr/>
        </p:nvGrpSpPr>
        <p:grpSpPr>
          <a:xfrm>
            <a:off x="93407" y="4254208"/>
            <a:ext cx="5102431" cy="3639150"/>
            <a:chOff x="114949" y="1373353"/>
            <a:chExt cx="5102431" cy="3639150"/>
          </a:xfrm>
        </p:grpSpPr>
        <p:pic>
          <p:nvPicPr>
            <p:cNvPr id="26" name="图片 25">
              <a:extLst>
                <a:ext uri="{FF2B5EF4-FFF2-40B4-BE49-F238E27FC236}">
                  <a16:creationId xmlns:a16="http://schemas.microsoft.com/office/drawing/2014/main" id="{129DD560-2BAF-4418-B320-7163387F34D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916843" y="4175270"/>
              <a:ext cx="4300537" cy="837233"/>
            </a:xfrm>
            <a:prstGeom prst="rect">
              <a:avLst/>
            </a:prstGeom>
          </p:spPr>
        </p:pic>
        <p:pic>
          <p:nvPicPr>
            <p:cNvPr id="27" name="图片 26">
              <a:extLst>
                <a:ext uri="{FF2B5EF4-FFF2-40B4-BE49-F238E27FC236}">
                  <a16:creationId xmlns:a16="http://schemas.microsoft.com/office/drawing/2014/main" id="{82544E7F-D61C-4545-B49D-8650CBCF7E9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277348" y="1373353"/>
              <a:ext cx="1094487" cy="321908"/>
            </a:xfrm>
            <a:prstGeom prst="rect">
              <a:avLst/>
            </a:prstGeom>
          </p:spPr>
        </p:pic>
        <p:pic>
          <p:nvPicPr>
            <p:cNvPr id="28" name="图片 27">
              <a:extLst>
                <a:ext uri="{FF2B5EF4-FFF2-40B4-BE49-F238E27FC236}">
                  <a16:creationId xmlns:a16="http://schemas.microsoft.com/office/drawing/2014/main" id="{966BB403-A008-48D4-A4C7-06B5BECCFF0E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517968" y="1391827"/>
              <a:ext cx="1099751" cy="320400"/>
            </a:xfrm>
            <a:prstGeom prst="rect">
              <a:avLst/>
            </a:prstGeom>
          </p:spPr>
        </p:pic>
        <p:pic>
          <p:nvPicPr>
            <p:cNvPr id="29" name="图片 28">
              <a:extLst>
                <a:ext uri="{FF2B5EF4-FFF2-40B4-BE49-F238E27FC236}">
                  <a16:creationId xmlns:a16="http://schemas.microsoft.com/office/drawing/2014/main" id="{CDA061BF-8F80-4AF9-A480-0C2F68428B1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763852" y="1391827"/>
              <a:ext cx="1099751" cy="320400"/>
            </a:xfrm>
            <a:prstGeom prst="rect">
              <a:avLst/>
            </a:prstGeom>
          </p:spPr>
        </p:pic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1927CCA0-8FF2-4421-B92F-C26C0F7046F4}"/>
                </a:ext>
              </a:extLst>
            </p:cNvPr>
            <p:cNvSpPr txBox="1"/>
            <p:nvPr/>
          </p:nvSpPr>
          <p:spPr>
            <a:xfrm>
              <a:off x="114949" y="4470775"/>
              <a:ext cx="6639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B-Actin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A2A8DCF4-FB5E-4CCA-A987-1443D94103BA}"/>
                </a:ext>
              </a:extLst>
            </p:cNvPr>
            <p:cNvSpPr txBox="1"/>
            <p:nvPr/>
          </p:nvSpPr>
          <p:spPr>
            <a:xfrm>
              <a:off x="114949" y="3147615"/>
              <a:ext cx="6639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LAGL1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48C47845-A130-489D-A36B-D2BE6EFFBFB0}"/>
                </a:ext>
              </a:extLst>
            </p:cNvPr>
            <p:cNvSpPr txBox="1"/>
            <p:nvPr/>
          </p:nvSpPr>
          <p:spPr>
            <a:xfrm>
              <a:off x="114949" y="1947436"/>
              <a:ext cx="6639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D109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3" name="文本框 32">
            <a:extLst>
              <a:ext uri="{FF2B5EF4-FFF2-40B4-BE49-F238E27FC236}">
                <a16:creationId xmlns:a16="http://schemas.microsoft.com/office/drawing/2014/main" id="{111E4D98-5AB8-428A-B6EF-DBE63EE484D8}"/>
              </a:ext>
            </a:extLst>
          </p:cNvPr>
          <p:cNvSpPr txBox="1"/>
          <p:nvPr/>
        </p:nvSpPr>
        <p:spPr>
          <a:xfrm>
            <a:off x="264854" y="3747572"/>
            <a:ext cx="4926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B </a:t>
            </a:r>
            <a:endParaRPr lang="zh-CN" altLang="en-US" dirty="0"/>
          </a:p>
        </p:txBody>
      </p:sp>
      <p:pic>
        <p:nvPicPr>
          <p:cNvPr id="34" name="图片 33">
            <a:extLst>
              <a:ext uri="{FF2B5EF4-FFF2-40B4-BE49-F238E27FC236}">
                <a16:creationId xmlns:a16="http://schemas.microsoft.com/office/drawing/2014/main" id="{9C47643D-86E9-4531-BA4C-E279A5046B3F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95301" y="5804206"/>
            <a:ext cx="4302000" cy="1123371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2E87B454-E574-4BE2-A2B0-E05311995AEF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95301" y="4643012"/>
            <a:ext cx="4302000" cy="10536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12133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66</Words>
  <Application>Microsoft Office PowerPoint</Application>
  <PresentationFormat>信纸(8.5x11 英寸)</PresentationFormat>
  <Paragraphs>160</Paragraphs>
  <Slides>7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3" baseType="lpstr">
      <vt:lpstr>等线</vt:lpstr>
      <vt:lpstr>Arial</vt:lpstr>
      <vt:lpstr>Arial Black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朝曦 李</dc:creator>
  <cp:lastModifiedBy>朝曦 李</cp:lastModifiedBy>
  <cp:revision>63</cp:revision>
  <dcterms:created xsi:type="dcterms:W3CDTF">2020-08-25T00:43:53Z</dcterms:created>
  <dcterms:modified xsi:type="dcterms:W3CDTF">2020-09-10T14:02:44Z</dcterms:modified>
</cp:coreProperties>
</file>